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57E02D8-DCD3-46D8-84E3-3368290989EB}" v="1" dt="2021-05-22T01:24:45.88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23" d="100"/>
          <a:sy n="123" d="100"/>
        </p:scale>
        <p:origin x="132" y="1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ad Serfraz" userId="65b66788-f2b1-4d03-a562-813ae45c945f" providerId="ADAL" clId="{957E02D8-DCD3-46D8-84E3-3368290989EB}"/>
    <pc:docChg chg="undo custSel modSld">
      <pc:chgData name="Saad Serfraz" userId="65b66788-f2b1-4d03-a562-813ae45c945f" providerId="ADAL" clId="{957E02D8-DCD3-46D8-84E3-3368290989EB}" dt="2021-05-22T01:30:45.399" v="119" actId="20577"/>
      <pc:docMkLst>
        <pc:docMk/>
      </pc:docMkLst>
      <pc:sldChg chg="delSp modSp mod">
        <pc:chgData name="Saad Serfraz" userId="65b66788-f2b1-4d03-a562-813ae45c945f" providerId="ADAL" clId="{957E02D8-DCD3-46D8-84E3-3368290989EB}" dt="2021-05-22T01:30:45.399" v="119" actId="20577"/>
        <pc:sldMkLst>
          <pc:docMk/>
          <pc:sldMk cId="2920028789" sldId="259"/>
        </pc:sldMkLst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3" creationId="{149F95C3-CB52-4765-AB22-7E02F0692C85}"/>
          </ac:spMkLst>
        </pc:spChg>
        <pc:spChg chg="mod">
          <ac:chgData name="Saad Serfraz" userId="65b66788-f2b1-4d03-a562-813ae45c945f" providerId="ADAL" clId="{957E02D8-DCD3-46D8-84E3-3368290989EB}" dt="2021-05-22T01:26:52.277" v="43" actId="14100"/>
          <ac:spMkLst>
            <pc:docMk/>
            <pc:sldMk cId="2920028789" sldId="259"/>
            <ac:spMk id="5" creationId="{DFC42E97-8540-4887-B353-72D229E58B15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6" creationId="{4A89F843-E7CD-45FD-8141-58309A60F6DE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7" creationId="{0F662987-DC39-4D3C-B195-106BA70E7C49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8" creationId="{AC0BFD59-E243-4BE3-B550-F85E626CFA64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9" creationId="{40E675A1-BF53-4DAC-B690-1324EFE28ABF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0" creationId="{B6AC502E-AE6F-46EF-8C42-E1E6A040F676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1" creationId="{171E255D-5256-483D-BD40-029A9CEDEF1A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2" creationId="{E97F58C5-804B-4B0B-A5EC-54C418B24A91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3" creationId="{0DF8B7FE-8D57-46F4-A176-0E7913942890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4" creationId="{09E95283-1D26-4172-B641-8BD2A3B880C5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5" creationId="{74B28D44-9E52-4642-89E0-8225E4C996CB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6" creationId="{4C4F7790-DA8C-4ED3-BFC4-1B2C8A30CBB7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7" creationId="{7B95CA46-866A-480A-BEEF-A648E52345F5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8" creationId="{57204492-36C3-4AF9-B033-01D4879DC77C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9" creationId="{FC38581B-7A1C-4549-B581-A9705BD42EC8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0" creationId="{FEF5ED58-E9C1-4E6D-B539-7854D5A33C5B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1" creationId="{66D80857-DEDE-414B-B940-5BA5506E83EC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2" creationId="{02BC0ED7-E872-47F5-90B7-4DC3B7111F34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3" creationId="{35C63CCC-B159-4DD0-A79C-3870C9F3416B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4" creationId="{46EA8149-27CF-4533-985A-26E96F3C7F83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5" creationId="{6992D26D-8BE3-459B-9E11-456D742B5C72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6" creationId="{9E90B7C3-9869-4C23-B50E-E540878F89C2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7" creationId="{F77B2B50-C9E1-491B-923C-98CBE8B830E8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8" creationId="{E20BDBCD-172D-4E95-983B-17EA5FC708FB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9" creationId="{817168CD-2900-4991-9A4C-0365302B923F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30" creationId="{ECF9E645-A27E-4455-8E87-A8CD459D4649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31" creationId="{06657A53-E40B-4E7B-8B30-15847C82EC41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32" creationId="{CE443CFA-4C80-4A1A-8B83-62C9B2981AD7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33" creationId="{F4BCBC29-D1F1-4F7B-B33B-40F4446DC8F3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34" creationId="{FE09DA17-92BF-4183-9854-1A0D0144FE0B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35" creationId="{EEF9F68F-3DE3-41A3-98B4-6F4F3169CA11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36" creationId="{278F95BD-6549-4C77-98A1-9B491BCE1B98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37" creationId="{5AB928ED-5DC1-4C74-880A-E1EF2C9AC3C6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38" creationId="{8D33DE0D-9EA5-4704-B00D-8C946919F0F7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39" creationId="{A19F547E-AAC7-4FC1-A2EB-CB3DAB496EB1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40" creationId="{33281EA0-C8C8-48C2-9248-8349CA96A70C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41" creationId="{599D978E-E964-472A-802E-3AFE4E861BB2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42" creationId="{676104C4-74F5-4140-9399-77075BA37448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43" creationId="{E5B57ADC-5E37-432B-8729-78AECF8E4D0F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44" creationId="{B1079839-D11B-4FA3-8A36-0FC5A254C21D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45" creationId="{048CE57E-C310-454F-BF2A-63C6CD5CB870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46" creationId="{62ABBD8C-74C1-4C8C-9BBB-4E3408B5E72D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47" creationId="{9F90B1B5-E3AE-4D40-A8D4-D170CCE70951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48" creationId="{A0369132-EA99-4F1D-9587-7C95226F3299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49" creationId="{10654DEA-A913-4010-AF94-BDA439E95BA6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50" creationId="{28AA1F30-AD1D-4E91-8284-7890CDC05FEA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51" creationId="{DE123206-6FA3-4AF8-B386-4A98EB64E047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52" creationId="{FCCDA867-2DED-4D44-ABC6-6A5CF413A084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53" creationId="{EA32AC79-D5AE-4ECB-9E66-C33F21970A51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54" creationId="{2952C4BE-4BCC-4CE9-BA1A-9971E4C52FB6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55" creationId="{E6D9B850-45EB-47BC-8574-C954638C7BBE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56" creationId="{43326034-1C68-4650-AB1F-7F027064A94C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57" creationId="{A2C98005-36E5-4FE9-93FE-CAD369F8A053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58" creationId="{311C1331-1FC5-4D6E-A694-4EA826F8D0C8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59" creationId="{84CF1A70-C157-41F0-BC7F-399F620D41F6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60" creationId="{961B17BE-9C47-4F95-98D3-C4F272823CE3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61" creationId="{8D09CA8D-B5CD-4D4F-A197-CA761CB2F72C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62" creationId="{24C7E819-EBBC-413B-991F-FBEEF8252A17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63" creationId="{F3D09E0C-CAF3-4416-9E7E-2D5851B53234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64" creationId="{D60EA101-E296-442E-B2BF-E50C2AA6417F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65" creationId="{D158BA0D-CC1E-4D9F-9D89-5A15CA589961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66" creationId="{A3C620BB-1EA6-432B-BD02-4FDCEC00FAAB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67" creationId="{E89F8F00-F3D1-4E65-8FAE-6A714FDBDDC8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68" creationId="{FE5AC4BF-2920-4B82-98D9-726EE213361C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69" creationId="{A285CB4E-9A8D-49FA-9D46-626E1A9F55EE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70" creationId="{75861284-B272-4318-87F6-496602778DE7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71" creationId="{289E5255-64F8-4F33-91B9-DF07C79435CD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72" creationId="{422D7521-239C-40E0-8FA6-1FD530E035FB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73" creationId="{AAFD4F8D-A263-4043-829B-35BFC69457E9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74" creationId="{16148572-1EEC-4AA1-9FB7-FA186B53C0EC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75" creationId="{7366C1FE-9974-47C1-9C4E-64065638C120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76" creationId="{9FE9F086-82D1-4858-A630-BAE48224F028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77" creationId="{C1A51959-180D-4AF4-AEC6-14824B7EB9B7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78" creationId="{C24C4934-F01E-44EB-A4DF-252D83299300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79" creationId="{B66BC244-289E-48DC-8790-FB2734819186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80" creationId="{23A441BC-1289-4BD0-BB10-4B0B5A9618BC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81" creationId="{96502445-767D-4D0F-9E50-0DC0AEE502A5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82" creationId="{9546E37D-0EA7-4E51-ADAE-D97314CDED20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83" creationId="{EB920C2E-76B6-4673-8B99-AC7C3888362E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84" creationId="{A51974F1-C69C-4D51-B9A0-19D9F4AF6A95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85" creationId="{EFF7811E-92D8-469D-A1E6-1E4BF7688B08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86" creationId="{718287A3-7034-4499-AD02-1F15F2DD99AB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87" creationId="{1E65771D-2AC8-4AC7-B356-C9DF145AB1E9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88" creationId="{C7AE3F9B-4620-4EDD-9DD1-BB60B42EBB33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89" creationId="{5385599D-CD4D-4E45-A081-D9A54635AB40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90" creationId="{50CF1CF8-56AD-420C-98FA-F8D2D1301F5F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91" creationId="{23F156B5-741D-4294-90A4-CD5554123450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92" creationId="{AB268EE0-E2D0-4C49-8D9A-424DFED5FBD5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93" creationId="{E76418D3-C4E8-4BEC-AD9C-9A12DFDE5EC8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94" creationId="{B05C771A-DDB4-403A-8F5E-40EF3399C8C4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95" creationId="{2D349D00-A6AA-4205-903A-5A14B17F0E4E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96" creationId="{A94905C8-CE33-4BD3-BCAC-08D0D8E66411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97" creationId="{52D9AE67-8AED-4F04-92AB-53CA57941D57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98" creationId="{EF05D9EC-7315-479A-8733-B8CFAFD08E32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99" creationId="{765BD881-6AD4-4F1B-A955-72DCD3AB0171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00" creationId="{27A579B2-D463-4F1C-82C0-FDFB3203D733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01" creationId="{EFC5490B-595F-4D10-A474-229C3E29D5E5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02" creationId="{6959825B-12D5-4A51-8E48-36AA65375142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03" creationId="{F4458225-8315-4B6A-998F-16968CC74B39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04" creationId="{096E4D3C-C556-43CF-BD3A-ECBBF5859C4C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05" creationId="{46EA407E-E0FD-4309-A29B-6838028AF3E1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06" creationId="{19595329-C1CA-467E-8E96-6524C43C206C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07" creationId="{41951FC0-24C9-442E-90D6-982C63E4CFBB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08" creationId="{CA0043D0-E3BA-4E85-A7CA-59F8C876F76B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09" creationId="{E7D68B96-900D-42BF-BBC4-0223B0D36963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10" creationId="{11A2A9B2-644E-4308-BBF9-D43125FB5482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11" creationId="{0DFEAD44-96E6-4F07-91AC-15FDB1DA18DA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12" creationId="{23B4255B-6B67-4207-A91B-C3E9DF8B25BA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13" creationId="{CCFF1E73-8C08-4D8C-A96E-B89E5F0A9FD8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14" creationId="{29D98FEC-5E0D-4406-8DF3-C59CF18BE732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15" creationId="{B98190AF-0D6F-455F-9C9A-F30B70DA022D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16" creationId="{B78C6A8D-F88D-4C9C-AE45-ABF95FE11905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17" creationId="{F491F0C0-8C3C-4A06-A268-5AB85FAD3141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18" creationId="{3DF4FDDF-1281-4C37-902C-6BF40AE0C80E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19" creationId="{E2B6B6A2-8EED-4226-BE1E-A531C7AA397F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20" creationId="{2AAACD95-F38A-42A1-8ED4-363BB71DC003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21" creationId="{FA7B7402-E94A-4A18-BAD2-38781F182A5B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22" creationId="{6AA0DF9B-B7A4-490D-8FBD-377C3FB52A28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23" creationId="{1A6F7997-268F-4597-AE59-F21AF5C2C940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24" creationId="{FCFF0CEE-F363-41A3-8057-79A696421E4A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25" creationId="{25ABD0FB-63A3-4A43-BD96-EFC26F8A389B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26" creationId="{CD57C809-38F8-4A38-9FEE-A32AD3E33505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27" creationId="{AEB19326-9236-484B-847B-6CD5A6D4DD79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28" creationId="{33D3681E-1BC0-44B7-A67B-E67AF06CB94B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29" creationId="{47B63424-24F7-4241-A954-EA1C0C99A953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30" creationId="{5A4841B5-C4B2-4751-9C9B-A63480045C36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31" creationId="{153824F7-2DE1-47BF-AB41-A3748A303A9A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32" creationId="{AB6A963F-58D3-468F-BB71-434E65B6F317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33" creationId="{31CF15CE-C662-4FE3-AE69-868414543690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34" creationId="{4183CD76-7CCC-4D6D-A9D6-AF9D4F392511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35" creationId="{F29A74D9-40ED-416C-A505-A2E8C18E894E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36" creationId="{DBCF5693-D443-4245-BEA2-F04CAE7BCB86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37" creationId="{7D9136EC-CA5C-49F3-B3C2-FBDFD8DBB69A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38" creationId="{225E7775-9744-46FE-9754-C163E18E67FB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39" creationId="{246CAC85-2846-497B-AC36-4AEFC6107B2A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40" creationId="{26BE4DE5-F077-4390-9F1F-EDA9A6A040F9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41" creationId="{73EDBD24-3024-47C9-AAD6-4BCB94D4BB98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42" creationId="{DB536F98-E470-4EB9-8090-013BEE37BB13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43" creationId="{55BBF487-1744-4BE4-A988-72E0673BF5ED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44" creationId="{E9FD9B5D-2702-457C-AD55-743BD2EB8A7E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45" creationId="{7012B624-B00D-4D97-BCBE-CF3F1B3A5A83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46" creationId="{544B8084-056B-4319-BBD2-3B0810EC654D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47" creationId="{B6590A07-4B14-40FD-A5C7-DF1AC77A780F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48" creationId="{6ABBC8AC-6B6D-4EF9-BE7E-30B591E0042C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49" creationId="{3C2309CD-98AE-477D-8A0F-9FDEA96E9484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50" creationId="{4830EB84-19FE-419E-8EC3-E7F5D60977C5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51" creationId="{865CE1A9-ED88-470A-AA6B-1FFC3AE8E8BE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52" creationId="{313BBF73-9566-466B-8E06-3F778895668B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53" creationId="{11547AF7-3917-4D5B-899F-DAD4E50E092B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54" creationId="{BE8FE4CC-A2B2-46F1-9F72-B166FF8B3086}"/>
          </ac:spMkLst>
        </pc:spChg>
        <pc:spChg chg="mod">
          <ac:chgData name="Saad Serfraz" userId="65b66788-f2b1-4d03-a562-813ae45c945f" providerId="ADAL" clId="{957E02D8-DCD3-46D8-84E3-3368290989EB}" dt="2021-05-22T01:30:45.399" v="119" actId="20577"/>
          <ac:spMkLst>
            <pc:docMk/>
            <pc:sldMk cId="2920028789" sldId="259"/>
            <ac:spMk id="155" creationId="{9D211A4E-D27A-40EE-B29D-CE1FD3A0DBA8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56" creationId="{0CBA8A50-FC3B-4811-A0B9-D0F642D70F5D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57" creationId="{C10B843F-3493-481A-BCCF-E6EF43454F69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58" creationId="{97735D94-FED2-4C1D-A67E-05F40F5C65D0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59" creationId="{28D133A1-7E90-4469-8F64-AA3E2721CEFE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60" creationId="{AD23F52B-CE33-4BAA-A01C-1D975FD0D33E}"/>
          </ac:spMkLst>
        </pc:spChg>
        <pc:spChg chg="mod">
          <ac:chgData name="Saad Serfraz" userId="65b66788-f2b1-4d03-a562-813ae45c945f" providerId="ADAL" clId="{957E02D8-DCD3-46D8-84E3-3368290989EB}" dt="2021-05-22T01:26:37.760" v="41"/>
          <ac:spMkLst>
            <pc:docMk/>
            <pc:sldMk cId="2920028789" sldId="259"/>
            <ac:spMk id="161" creationId="{3296E76C-12A4-4B30-8B0D-26085E2EA186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62" creationId="{F933DE6F-96D5-466B-B3A7-DB47F2FF877B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63" creationId="{066191B9-F59D-4C22-B15D-D65E8DD42948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64" creationId="{6F996C6A-93C8-4B9C-B12E-8660B45EF0B4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65" creationId="{7D7FA530-B1D7-452A-8791-826C4563C80B}"/>
          </ac:spMkLst>
        </pc:spChg>
        <pc:spChg chg="mod">
          <ac:chgData name="Saad Serfraz" userId="65b66788-f2b1-4d03-a562-813ae45c945f" providerId="ADAL" clId="{957E02D8-DCD3-46D8-84E3-3368290989EB}" dt="2021-05-22T01:25:53.839" v="36" actId="20577"/>
          <ac:spMkLst>
            <pc:docMk/>
            <pc:sldMk cId="2920028789" sldId="259"/>
            <ac:spMk id="166" creationId="{418C652A-24D7-4C32-88EB-15C4A37DFE68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67" creationId="{0795F20B-D745-4439-AC3E-8E32703FBC95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68" creationId="{52B0D6F7-7BCB-4E9C-BF58-D4D5E5F24AA0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69" creationId="{4874D9F9-5765-4B22-B914-4B5A1980009F}"/>
          </ac:spMkLst>
        </pc:spChg>
        <pc:spChg chg="mod">
          <ac:chgData name="Saad Serfraz" userId="65b66788-f2b1-4d03-a562-813ae45c945f" providerId="ADAL" clId="{957E02D8-DCD3-46D8-84E3-3368290989EB}" dt="2021-05-22T01:26:09.169" v="38" actId="14100"/>
          <ac:spMkLst>
            <pc:docMk/>
            <pc:sldMk cId="2920028789" sldId="259"/>
            <ac:spMk id="170" creationId="{62842767-930D-4666-B457-711FF0152CAF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71" creationId="{60AEF2AB-2307-40CD-A86A-FA3F64AACE19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72" creationId="{96559C47-450F-4426-ACBB-ED52BBD9696C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73" creationId="{BA0544CD-2810-423C-A127-94A5BF499548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74" creationId="{4A4A839C-6AA0-42D2-A796-4BB42C5DA31B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75" creationId="{E8CC90C4-B8C0-483C-AEF1-F229D0FC5138}"/>
          </ac:spMkLst>
        </pc:spChg>
        <pc:spChg chg="mod">
          <ac:chgData name="Saad Serfraz" userId="65b66788-f2b1-4d03-a562-813ae45c945f" providerId="ADAL" clId="{957E02D8-DCD3-46D8-84E3-3368290989EB}" dt="2021-05-22T01:30:28.656" v="94" actId="20577"/>
          <ac:spMkLst>
            <pc:docMk/>
            <pc:sldMk cId="2920028789" sldId="259"/>
            <ac:spMk id="176" creationId="{5AF04D99-51E3-47D4-AA48-E9F393288E3B}"/>
          </ac:spMkLst>
        </pc:spChg>
        <pc:spChg chg="mod">
          <ac:chgData name="Saad Serfraz" userId="65b66788-f2b1-4d03-a562-813ae45c945f" providerId="ADAL" clId="{957E02D8-DCD3-46D8-84E3-3368290989EB}" dt="2021-05-22T01:26:23.517" v="40" actId="14100"/>
          <ac:spMkLst>
            <pc:docMk/>
            <pc:sldMk cId="2920028789" sldId="259"/>
            <ac:spMk id="177" creationId="{FC6EB364-6785-4C9B-8BDB-597CEE1DF7B7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78" creationId="{4288C9AC-EEA5-47E8-97EE-C80EEB4FB755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79" creationId="{6CEAD47A-CCCA-46E3-A597-03B2CD2870FB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80" creationId="{415C2147-90D6-4A15-9E1A-D2276425B0B6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81" creationId="{72B8691B-273E-4EAE-A845-F26A0AE0E0CF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82" creationId="{0BEC0277-13DA-46B9-8A5C-05194D686C0A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83" creationId="{A3DB1033-02C1-4114-B993-1D9E0363791E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84" creationId="{5ACD3C6E-BF03-4D24-BDA2-B92ED9BE2BAA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85" creationId="{B0D76884-A4DC-4EA2-A67C-A6389ABA88F3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86" creationId="{273AB2FB-CD90-4BB1-8050-318260C1C599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87" creationId="{3E7C9A1D-7C0A-4261-8612-E7275E2FB3C2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88" creationId="{EB2ADFF5-5BE8-4279-AD31-4506F3A5C03E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89" creationId="{84FFD992-5104-4B69-8FC9-78B1C135D684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90" creationId="{179A6BC9-EB8E-4625-A2F4-BFE515629F06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91" creationId="{D000280D-336C-4763-BE5B-8D04EBD51D13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92" creationId="{4991CBAE-645D-401A-A88D-716278BBC395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93" creationId="{28D9829B-96D2-47C3-A285-D60663089CC4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94" creationId="{3F321873-0831-46A1-AF78-4EE8D3312B6F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95" creationId="{D7C066CD-C3B7-4466-8618-D167098E2AE3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96" creationId="{19507F77-1298-4BBD-8A41-2EC61974DF3C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97" creationId="{D087E52C-6F6C-4943-A8AB-AF1CBEA72610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98" creationId="{6569EB14-8D65-4A4F-9993-C7063E698C29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199" creationId="{861FBFD6-193B-4768-B319-F2CE0979461D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00" creationId="{D391CD09-EA50-45EC-B67B-97EA7FB15CE3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01" creationId="{427EB42D-55D9-4B89-A533-035AA6D37F68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02" creationId="{4C1DE0E8-EED1-45F8-BE94-9514364C1BFE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03" creationId="{216BBA70-FAF0-4ED3-ACE3-82948D58D6DB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04" creationId="{02AD5B1A-B697-4B94-B9F0-E55A1CECB583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05" creationId="{61953F41-C040-44F9-B74A-593F2B99440D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06" creationId="{915F62D6-5559-418A-95DC-FBC206B9F49D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07" creationId="{3BCB1DCE-D87E-41ED-81AD-3C855B518D68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08" creationId="{2F892CC2-CE16-4068-B3B2-02C55833A00A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09" creationId="{12389384-6358-449F-804E-8EB9EBFF8B41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10" creationId="{01494766-F992-4A6A-AE8A-A9055207F729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11" creationId="{ABC0FC5D-E2AC-4582-A928-F3D67D8841DA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12" creationId="{42CA80ED-3D13-4719-9492-F44AB1292BBD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13" creationId="{F84B75C1-CC68-4985-A8F1-A1F958503579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14" creationId="{946F3820-7B71-4606-ADC3-55FE8C73062B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15" creationId="{A1D84CA6-FEAD-49FD-A816-AFFF1803F15D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16" creationId="{AD5530C8-4146-4679-B5F9-6716FBD56997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17" creationId="{8190FD94-95F0-4101-90D1-E579EB4A6AA9}"/>
          </ac:spMkLst>
        </pc:spChg>
        <pc:spChg chg="mod">
          <ac:chgData name="Saad Serfraz" userId="65b66788-f2b1-4d03-a562-813ae45c945f" providerId="ADAL" clId="{957E02D8-DCD3-46D8-84E3-3368290989EB}" dt="2021-05-22T01:27:03.785" v="54" actId="1037"/>
          <ac:spMkLst>
            <pc:docMk/>
            <pc:sldMk cId="2920028789" sldId="259"/>
            <ac:spMk id="218" creationId="{7F170BDB-5386-4932-8905-9B4BD7AAC6BF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19" creationId="{2056355C-0022-451B-AF02-B1D2689058C0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20" creationId="{96CAAD71-C182-477E-86C0-6412950171E7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21" creationId="{0AA93A7C-80BA-4B10-8C52-D96CD15CEAD4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22" creationId="{AFABA105-EA76-47AA-BA46-63802DC9C10D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23" creationId="{64DBB913-BDFC-443A-9874-4CFB94A2EF42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24" creationId="{2177F0E9-5EB5-4CA1-9740-DB60099ABAE0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25" creationId="{08D5C81C-616B-49C4-AEEA-6E1DA859A298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26" creationId="{DC07497B-2D88-41A6-A08E-17A0C72AC827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27" creationId="{589AEF15-6496-4560-A2AA-92513149E332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28" creationId="{4A1AA3BA-A735-4C1B-B955-399B3BD76412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29" creationId="{4F002783-D523-4FA4-BD35-2031E2A6C5C2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30" creationId="{EC5A05CC-B391-456F-A174-33910CE455EA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31" creationId="{60497EF5-155F-494D-BE3F-9E28D3E2CCAA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32" creationId="{8120E79C-6D33-4CFA-A1C3-CB5EE51EB92D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33" creationId="{90975C92-195E-44F2-A543-B9B99D29424D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34" creationId="{43E4D1C0-9419-4919-B52F-D2EA2F66CD75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35" creationId="{F4A210B4-1248-444F-95CD-6051DD23280F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36" creationId="{4F61B47A-14BE-4442-9642-6F142C4735A2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37" creationId="{7A3663B6-FDDE-4C0D-B253-5247187E10F2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38" creationId="{C4611638-F134-401B-88EB-7B78472F723D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39" creationId="{D7A789C1-18D6-45FA-8CE0-6447AF3B8EF1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40" creationId="{65DC268B-00F7-4BF0-82F0-E75D56D61B38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41" creationId="{417DA1ED-F0F7-4DBE-886C-BBA37A2FFED3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42" creationId="{6A52522E-61CD-4FAA-B6ED-DD30C56ADA60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43" creationId="{14A51EFE-F4B0-40FE-8210-B01C19D53806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44" creationId="{B88C8378-8ACB-4AA0-A270-A262A895E3FB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45" creationId="{F9077B08-2A85-4C87-A4B9-E74BA8E6EBA8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46" creationId="{795C41C6-CDAE-4F8C-B756-D507156A9375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47" creationId="{B5087B81-F439-49BF-9E87-93AEE900C1DA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48" creationId="{EC638F80-47C8-41E6-8268-D49F8740965D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49" creationId="{F3D547B3-3D99-4B01-81A1-2060F1DBE0AC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50" creationId="{45F2E765-75C7-4ADE-8090-CFECD9F39491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51" creationId="{9181F827-201D-4473-92CD-77297D179D83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52" creationId="{F44D6112-547C-48B1-8370-CB58D85FAA1A}"/>
          </ac:spMkLst>
        </pc:spChg>
        <pc:spChg chg="mod">
          <ac:chgData name="Saad Serfraz" userId="65b66788-f2b1-4d03-a562-813ae45c945f" providerId="ADAL" clId="{957E02D8-DCD3-46D8-84E3-3368290989EB}" dt="2021-05-22T01:24:45.887" v="1" actId="27803"/>
          <ac:spMkLst>
            <pc:docMk/>
            <pc:sldMk cId="2920028789" sldId="259"/>
            <ac:spMk id="253" creationId="{6A676483-A680-4F01-8016-59504829C4F4}"/>
          </ac:spMkLst>
        </pc:spChg>
        <pc:grpChg chg="mod">
          <ac:chgData name="Saad Serfraz" userId="65b66788-f2b1-4d03-a562-813ae45c945f" providerId="ADAL" clId="{957E02D8-DCD3-46D8-84E3-3368290989EB}" dt="2021-05-22T01:24:45.887" v="1" actId="27803"/>
          <ac:grpSpMkLst>
            <pc:docMk/>
            <pc:sldMk cId="2920028789" sldId="259"/>
            <ac:grpSpMk id="2" creationId="{581B2F86-C03D-434B-8887-3B09C7D57FDB}"/>
          </ac:grpSpMkLst>
        </pc:grpChg>
        <pc:picChg chg="del">
          <ac:chgData name="Saad Serfraz" userId="65b66788-f2b1-4d03-a562-813ae45c945f" providerId="ADAL" clId="{957E02D8-DCD3-46D8-84E3-3368290989EB}" dt="2021-05-22T01:24:45.887" v="1" actId="27803"/>
          <ac:picMkLst>
            <pc:docMk/>
            <pc:sldMk cId="2920028789" sldId="259"/>
            <ac:picMk id="4" creationId="{898C741B-CF87-41D5-ACDB-6329DB098586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E70FA9-81E2-4F80-8A70-CFA7319A7E8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4DD4F4D-D2A9-408D-B10D-34D44E61C93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F7F541-00A8-43E2-92DD-25FD8B4911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C37EF1-3DAD-4308-80B3-F9A789784B86}" type="datetimeFigureOut">
              <a:rPr lang="en-US" smtClean="0"/>
              <a:t>6/11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157869-A18D-4D41-A129-3AB6B9990F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52DA03-512A-47FB-AC0F-A84F47E77C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DC750A-501B-422E-A6F2-C89131A2A88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34746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5B3141-AB78-4834-905D-DF85069813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74B1FA8-8BCA-4E30-A437-4C058674CE3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011004-E7D9-4FED-93C5-4D96909611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C37EF1-3DAD-4308-80B3-F9A789784B86}" type="datetimeFigureOut">
              <a:rPr lang="en-US" smtClean="0"/>
              <a:t>6/11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96C62C3-8FD7-486A-B40E-1CDD3AB155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A0E433-4467-4677-B6BB-6049EE2B3C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DC750A-501B-422E-A6F2-C89131A2A88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18043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E1AC944-A450-4FEE-90C8-4010CC1F0A6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0CB57FC-2EC1-4680-A6E0-0D0B321836E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95259E-38CF-42DF-BF16-323D773EDC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C37EF1-3DAD-4308-80B3-F9A789784B86}" type="datetimeFigureOut">
              <a:rPr lang="en-US" smtClean="0"/>
              <a:t>6/11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FE1172-052D-4ACB-AC79-CCAAC273BD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82FD2A-B88D-4378-BC85-B76D03A827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DC750A-501B-422E-A6F2-C89131A2A88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27498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72BC7C-C948-410E-886F-5EAAE36695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31249B1-3A5C-4AC3-A89C-7A4EF16EC9F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4403B6-82AB-40FC-84E8-759B938B3E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C37EF1-3DAD-4308-80B3-F9A789784B86}" type="datetimeFigureOut">
              <a:rPr lang="en-US" smtClean="0"/>
              <a:t>6/11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E1187D-75DE-4B03-AA36-ED41516D71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1131E4-C8D1-4EC3-9564-661F9D022F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DC750A-501B-422E-A6F2-C89131A2A88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82224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0DAF1E-FE31-4CD3-9087-378A918EEF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9E7E136-FC2D-4E31-97B8-26CAFEE447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F8C9DB-85A8-4D2A-B443-84BC54D612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C37EF1-3DAD-4308-80B3-F9A789784B86}" type="datetimeFigureOut">
              <a:rPr lang="en-US" smtClean="0"/>
              <a:t>6/11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B3E70FF-B1F5-4518-932A-D474473BE4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09F4A1-55E5-47A1-85D0-A1FA6ADF49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DC750A-501B-422E-A6F2-C89131A2A88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51995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FFF3BB-2D65-43D3-B2C7-DDD8CB9902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4A7647B-685A-461B-AD1D-02EC98308C2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FA21B42-DA82-42E7-A783-11F40D09997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BA7F8DF-93F1-4293-88B0-699E405D6C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C37EF1-3DAD-4308-80B3-F9A789784B86}" type="datetimeFigureOut">
              <a:rPr lang="en-US" smtClean="0"/>
              <a:t>6/11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C7D85B6-0550-436C-B06D-E8CF4B7FEB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7D49E52-26DB-44DE-A9A7-086D2FF25C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DC750A-501B-422E-A6F2-C89131A2A88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7864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694955-8424-48C5-9ED5-B57B08DAC1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FF8BEF9-85F3-4FAA-870D-222688759E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362878F-8508-4097-AC96-3FCA01992E0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95A381D-0506-4C13-8C13-9F018C1441E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F9B982E-CC42-4F15-9B92-69959C3AB2D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FB9C0A9-C0D5-411E-85FB-7B1D7347BD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C37EF1-3DAD-4308-80B3-F9A789784B86}" type="datetimeFigureOut">
              <a:rPr lang="en-US" smtClean="0"/>
              <a:t>6/11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6CC8FE7-69E2-44A4-9852-4EAE6AB1E8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07C9384-685F-430E-9F0F-2A2D78A46F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DC750A-501B-422E-A6F2-C89131A2A88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67152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B95E84-B6C8-4779-8E18-360BC3F488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7FECF39-A4F7-4304-B94B-4C403F936D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C37EF1-3DAD-4308-80B3-F9A789784B86}" type="datetimeFigureOut">
              <a:rPr lang="en-US" smtClean="0"/>
              <a:t>6/11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E0BF0F1-F43E-41D5-A89C-B32D88E6A5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57E6540-C8EB-4FC1-8C3E-605120AA80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DC750A-501B-422E-A6F2-C89131A2A88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23823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8E43465-B90D-4D52-96E5-EE215A74C2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C37EF1-3DAD-4308-80B3-F9A789784B86}" type="datetimeFigureOut">
              <a:rPr lang="en-US" smtClean="0"/>
              <a:t>6/11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0B08230-DE46-44FA-94EC-C36AB945F1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51F86B3-4471-47BB-A063-9FDCCC43B0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DC750A-501B-422E-A6F2-C89131A2A88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74340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8BC3CE-57D5-4CD6-9895-6B865249B5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7C46854-8696-451E-92F4-0217C82252E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F40D8EF-C109-499C-BBB8-1D278595012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557CCA3-5256-4507-A867-8322483918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C37EF1-3DAD-4308-80B3-F9A789784B86}" type="datetimeFigureOut">
              <a:rPr lang="en-US" smtClean="0"/>
              <a:t>6/11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4578CD5-53C4-4375-9AC1-1AEA67B6B3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2E03509-62FC-4DFE-B5DC-D8D6FCFBBF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DC750A-501B-422E-A6F2-C89131A2A88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69231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BF1FFD-2D7B-40A4-BC1C-527DDCC592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B98C327-0230-46CC-9D70-AB70DBC4A0A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E91E9EC-590F-42AA-9D32-9F20F5EF483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45CAC15-41C1-4CA0-8852-1FEBF0E017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C37EF1-3DAD-4308-80B3-F9A789784B86}" type="datetimeFigureOut">
              <a:rPr lang="en-US" smtClean="0"/>
              <a:t>6/11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7E7C8CB-4F6E-4D55-A65B-20484EFD45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1A45918-C62B-41F8-AEB7-4542DEF488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DC750A-501B-422E-A6F2-C89131A2A88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11628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CFBB158-7F3C-4A86-97E1-04B9B185BE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DC391A2-0164-4256-8273-5D71C9BA1C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82FCB4-FD6C-49A5-B984-BD13DCA4BA6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C37EF1-3DAD-4308-80B3-F9A789784B86}" type="datetimeFigureOut">
              <a:rPr lang="en-US" smtClean="0"/>
              <a:t>6/11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12A618-E42D-46BA-BA38-D2A909DB27C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92EF21-6946-472E-9F96-A83C9285EDC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DC750A-501B-422E-A6F2-C89131A2A88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12707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reeform: Shape 4">
            <a:extLst>
              <a:ext uri="{FF2B5EF4-FFF2-40B4-BE49-F238E27FC236}">
                <a16:creationId xmlns:a16="http://schemas.microsoft.com/office/drawing/2014/main" id="{DFC42E97-8540-4887-B353-72D229E58B15}"/>
              </a:ext>
            </a:extLst>
          </p:cNvPr>
          <p:cNvSpPr/>
          <p:nvPr/>
        </p:nvSpPr>
        <p:spPr>
          <a:xfrm>
            <a:off x="4713318" y="5861399"/>
            <a:ext cx="1759320" cy="439314"/>
          </a:xfrm>
          <a:custGeom>
            <a:avLst/>
            <a:gdLst>
              <a:gd name="connsiteX0" fmla="*/ 0 w 2450293"/>
              <a:gd name="connsiteY0" fmla="*/ 0 h 580075"/>
              <a:gd name="connsiteX1" fmla="*/ 2450294 w 2450293"/>
              <a:gd name="connsiteY1" fmla="*/ 0 h 580075"/>
              <a:gd name="connsiteX2" fmla="*/ 2450294 w 2450293"/>
              <a:gd name="connsiteY2" fmla="*/ 580075 h 580075"/>
              <a:gd name="connsiteX3" fmla="*/ 0 w 2450293"/>
              <a:gd name="connsiteY3" fmla="*/ 580075 h 58007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450293" h="580075">
                <a:moveTo>
                  <a:pt x="0" y="0"/>
                </a:moveTo>
                <a:lnTo>
                  <a:pt x="2450294" y="0"/>
                </a:lnTo>
                <a:lnTo>
                  <a:pt x="2450294" y="580075"/>
                </a:lnTo>
                <a:lnTo>
                  <a:pt x="0" y="580075"/>
                </a:lnTo>
                <a:close/>
              </a:path>
            </a:pathLst>
          </a:custGeom>
          <a:solidFill>
            <a:srgbClr val="F08080">
              <a:alpha val="16000"/>
            </a:srgbClr>
          </a:solidFill>
          <a:ln w="20660" cap="flat">
            <a:noFill/>
            <a:prstDash val="solid"/>
            <a:miter/>
          </a:ln>
        </p:spPr>
        <p:txBody>
          <a:bodyPr rtlCol="0" anchor="ctr"/>
          <a:lstStyle/>
          <a:p>
            <a:endParaRPr lang="en-US" dirty="0"/>
          </a:p>
        </p:txBody>
      </p:sp>
      <p:grpSp>
        <p:nvGrpSpPr>
          <p:cNvPr id="2" name="Content Placeholder 3">
            <a:extLst>
              <a:ext uri="{FF2B5EF4-FFF2-40B4-BE49-F238E27FC236}">
                <a16:creationId xmlns:a16="http://schemas.microsoft.com/office/drawing/2014/main" id="{581B2F86-C03D-434B-8887-3B09C7D57FDB}"/>
              </a:ext>
            </a:extLst>
          </p:cNvPr>
          <p:cNvGrpSpPr/>
          <p:nvPr/>
        </p:nvGrpSpPr>
        <p:grpSpPr>
          <a:xfrm>
            <a:off x="107641" y="202847"/>
            <a:ext cx="6512594" cy="6534285"/>
            <a:chOff x="107641" y="202847"/>
            <a:chExt cx="6512594" cy="6534285"/>
          </a:xfrm>
        </p:grpSpPr>
        <p:sp>
          <p:nvSpPr>
            <p:cNvPr id="3" name="Content Placeholder 3">
              <a:extLst>
                <a:ext uri="{FF2B5EF4-FFF2-40B4-BE49-F238E27FC236}">
                  <a16:creationId xmlns:a16="http://schemas.microsoft.com/office/drawing/2014/main" id="{149F95C3-CB52-4765-AB22-7E02F0692C85}"/>
                </a:ext>
              </a:extLst>
            </p:cNvPr>
            <p:cNvSpPr/>
            <p:nvPr/>
          </p:nvSpPr>
          <p:spPr>
            <a:xfrm>
              <a:off x="2557338" y="6593666"/>
              <a:ext cx="664060" cy="5749"/>
            </a:xfrm>
            <a:custGeom>
              <a:avLst/>
              <a:gdLst>
                <a:gd name="connsiteX0" fmla="*/ 1 w 664060"/>
                <a:gd name="connsiteY0" fmla="*/ -4 h 5749"/>
                <a:gd name="connsiteX1" fmla="*/ 664061 w 664060"/>
                <a:gd name="connsiteY1" fmla="*/ -4 h 574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664060" h="5749">
                  <a:moveTo>
                    <a:pt x="1" y="-4"/>
                  </a:moveTo>
                  <a:lnTo>
                    <a:pt x="664061" y="-4"/>
                  </a:lnTo>
                </a:path>
              </a:pathLst>
            </a:custGeom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" name="Content Placeholder 3">
              <a:extLst>
                <a:ext uri="{FF2B5EF4-FFF2-40B4-BE49-F238E27FC236}">
                  <a16:creationId xmlns:a16="http://schemas.microsoft.com/office/drawing/2014/main" id="{4A89F843-E7CD-45FD-8141-58309A60F6DE}"/>
                </a:ext>
              </a:extLst>
            </p:cNvPr>
            <p:cNvSpPr txBox="1"/>
            <p:nvPr/>
          </p:nvSpPr>
          <p:spPr>
            <a:xfrm>
              <a:off x="2775557" y="6565196"/>
              <a:ext cx="232584" cy="1719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404" spc="0" baseline="0">
                  <a:solidFill>
                    <a:srgbClr val="000000"/>
                  </a:solidFill>
                  <a:latin typeface="Agency FB"/>
                  <a:sym typeface="Agency FB"/>
                  <a:rtl val="0"/>
                </a:rPr>
                <a:t>0.2</a:t>
              </a:r>
            </a:p>
          </p:txBody>
        </p:sp>
        <p:sp>
          <p:nvSpPr>
            <p:cNvPr id="7" name="Content Placeholder 3">
              <a:extLst>
                <a:ext uri="{FF2B5EF4-FFF2-40B4-BE49-F238E27FC236}">
                  <a16:creationId xmlns:a16="http://schemas.microsoft.com/office/drawing/2014/main" id="{0F662987-DC39-4D3C-B195-106BA70E7C49}"/>
                </a:ext>
              </a:extLst>
            </p:cNvPr>
            <p:cNvSpPr/>
            <p:nvPr/>
          </p:nvSpPr>
          <p:spPr>
            <a:xfrm>
              <a:off x="3973771" y="3031390"/>
              <a:ext cx="355956" cy="135279"/>
            </a:xfrm>
            <a:custGeom>
              <a:avLst/>
              <a:gdLst>
                <a:gd name="connsiteX0" fmla="*/ 355957 w 355956"/>
                <a:gd name="connsiteY0" fmla="*/ -4 h 135279"/>
                <a:gd name="connsiteX1" fmla="*/ 1 w 355956"/>
                <a:gd name="connsiteY1" fmla="*/ -4 h 135279"/>
                <a:gd name="connsiteX2" fmla="*/ 1 w 355956"/>
                <a:gd name="connsiteY2" fmla="*/ 135276 h 13527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355956" h="135279">
                  <a:moveTo>
                    <a:pt x="355957" y="-4"/>
                  </a:moveTo>
                  <a:lnTo>
                    <a:pt x="1" y="-4"/>
                  </a:lnTo>
                  <a:lnTo>
                    <a:pt x="1" y="135276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" name="Content Placeholder 3">
              <a:extLst>
                <a:ext uri="{FF2B5EF4-FFF2-40B4-BE49-F238E27FC236}">
                  <a16:creationId xmlns:a16="http://schemas.microsoft.com/office/drawing/2014/main" id="{AC0BFD59-E243-4BE3-B550-F85E626CFA64}"/>
                </a:ext>
              </a:extLst>
            </p:cNvPr>
            <p:cNvSpPr/>
            <p:nvPr/>
          </p:nvSpPr>
          <p:spPr>
            <a:xfrm>
              <a:off x="4573532" y="2170529"/>
              <a:ext cx="739701" cy="49194"/>
            </a:xfrm>
            <a:custGeom>
              <a:avLst/>
              <a:gdLst>
                <a:gd name="connsiteX0" fmla="*/ 739702 w 739701"/>
                <a:gd name="connsiteY0" fmla="*/ -4 h 49194"/>
                <a:gd name="connsiteX1" fmla="*/ 1 w 739701"/>
                <a:gd name="connsiteY1" fmla="*/ -4 h 49194"/>
                <a:gd name="connsiteX2" fmla="*/ 1 w 739701"/>
                <a:gd name="connsiteY2" fmla="*/ 49191 h 491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739701" h="49194">
                  <a:moveTo>
                    <a:pt x="739702" y="-4"/>
                  </a:moveTo>
                  <a:lnTo>
                    <a:pt x="1" y="-4"/>
                  </a:lnTo>
                  <a:lnTo>
                    <a:pt x="1" y="49191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" name="Content Placeholder 3">
              <a:extLst>
                <a:ext uri="{FF2B5EF4-FFF2-40B4-BE49-F238E27FC236}">
                  <a16:creationId xmlns:a16="http://schemas.microsoft.com/office/drawing/2014/main" id="{40E675A1-BF53-4DAC-B690-1324EFE28ABF}"/>
                </a:ext>
              </a:extLst>
            </p:cNvPr>
            <p:cNvSpPr/>
            <p:nvPr/>
          </p:nvSpPr>
          <p:spPr>
            <a:xfrm>
              <a:off x="3520349" y="5515593"/>
              <a:ext cx="1288068" cy="49188"/>
            </a:xfrm>
            <a:custGeom>
              <a:avLst/>
              <a:gdLst>
                <a:gd name="connsiteX0" fmla="*/ 1288069 w 1288068"/>
                <a:gd name="connsiteY0" fmla="*/ -4 h 49188"/>
                <a:gd name="connsiteX1" fmla="*/ 1 w 1288068"/>
                <a:gd name="connsiteY1" fmla="*/ -4 h 49188"/>
                <a:gd name="connsiteX2" fmla="*/ 1 w 1288068"/>
                <a:gd name="connsiteY2" fmla="*/ 49185 h 4918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288068" h="49188">
                  <a:moveTo>
                    <a:pt x="1288069" y="-4"/>
                  </a:moveTo>
                  <a:lnTo>
                    <a:pt x="1" y="-4"/>
                  </a:lnTo>
                  <a:lnTo>
                    <a:pt x="1" y="49185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0" name="Content Placeholder 3">
              <a:extLst>
                <a:ext uri="{FF2B5EF4-FFF2-40B4-BE49-F238E27FC236}">
                  <a16:creationId xmlns:a16="http://schemas.microsoft.com/office/drawing/2014/main" id="{B6AC502E-AE6F-46EF-8C42-E1E6A040F676}"/>
                </a:ext>
              </a:extLst>
            </p:cNvPr>
            <p:cNvSpPr/>
            <p:nvPr/>
          </p:nvSpPr>
          <p:spPr>
            <a:xfrm>
              <a:off x="3210726" y="510297"/>
              <a:ext cx="154210" cy="362789"/>
            </a:xfrm>
            <a:custGeom>
              <a:avLst/>
              <a:gdLst>
                <a:gd name="connsiteX0" fmla="*/ 154211 w 154210"/>
                <a:gd name="connsiteY0" fmla="*/ -4 h 362789"/>
                <a:gd name="connsiteX1" fmla="*/ 1 w 154210"/>
                <a:gd name="connsiteY1" fmla="*/ -4 h 362789"/>
                <a:gd name="connsiteX2" fmla="*/ 1 w 154210"/>
                <a:gd name="connsiteY2" fmla="*/ 362785 h 36278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54210" h="362789">
                  <a:moveTo>
                    <a:pt x="154211" y="-4"/>
                  </a:moveTo>
                  <a:lnTo>
                    <a:pt x="1" y="-4"/>
                  </a:lnTo>
                  <a:lnTo>
                    <a:pt x="1" y="362785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1" name="Content Placeholder 3">
              <a:extLst>
                <a:ext uri="{FF2B5EF4-FFF2-40B4-BE49-F238E27FC236}">
                  <a16:creationId xmlns:a16="http://schemas.microsoft.com/office/drawing/2014/main" id="{171E255D-5256-483D-BD40-029A9CEDEF1A}"/>
                </a:ext>
              </a:extLst>
            </p:cNvPr>
            <p:cNvSpPr/>
            <p:nvPr/>
          </p:nvSpPr>
          <p:spPr>
            <a:xfrm>
              <a:off x="3210726" y="873087"/>
              <a:ext cx="196779" cy="362796"/>
            </a:xfrm>
            <a:custGeom>
              <a:avLst/>
              <a:gdLst>
                <a:gd name="connsiteX0" fmla="*/ 196780 w 196779"/>
                <a:gd name="connsiteY0" fmla="*/ 362792 h 362796"/>
                <a:gd name="connsiteX1" fmla="*/ 1 w 196779"/>
                <a:gd name="connsiteY1" fmla="*/ 362792 h 362796"/>
                <a:gd name="connsiteX2" fmla="*/ 1 w 196779"/>
                <a:gd name="connsiteY2" fmla="*/ -4 h 36279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96779" h="362796">
                  <a:moveTo>
                    <a:pt x="196780" y="362792"/>
                  </a:moveTo>
                  <a:lnTo>
                    <a:pt x="1" y="362792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2" name="Content Placeholder 3">
              <a:extLst>
                <a:ext uri="{FF2B5EF4-FFF2-40B4-BE49-F238E27FC236}">
                  <a16:creationId xmlns:a16="http://schemas.microsoft.com/office/drawing/2014/main" id="{E97F58C5-804B-4B0B-A5EC-54C418B24A91}"/>
                </a:ext>
              </a:extLst>
            </p:cNvPr>
            <p:cNvSpPr/>
            <p:nvPr/>
          </p:nvSpPr>
          <p:spPr>
            <a:xfrm>
              <a:off x="4462587" y="3744678"/>
              <a:ext cx="712468" cy="49188"/>
            </a:xfrm>
            <a:custGeom>
              <a:avLst/>
              <a:gdLst>
                <a:gd name="connsiteX0" fmla="*/ 712469 w 712468"/>
                <a:gd name="connsiteY0" fmla="*/ -4 h 49188"/>
                <a:gd name="connsiteX1" fmla="*/ 1 w 712468"/>
                <a:gd name="connsiteY1" fmla="*/ -4 h 49188"/>
                <a:gd name="connsiteX2" fmla="*/ 1 w 712468"/>
                <a:gd name="connsiteY2" fmla="*/ 49185 h 4918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712468" h="49188">
                  <a:moveTo>
                    <a:pt x="712469" y="-4"/>
                  </a:moveTo>
                  <a:lnTo>
                    <a:pt x="1" y="-4"/>
                  </a:lnTo>
                  <a:lnTo>
                    <a:pt x="1" y="49185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3" name="Content Placeholder 3">
              <a:extLst>
                <a:ext uri="{FF2B5EF4-FFF2-40B4-BE49-F238E27FC236}">
                  <a16:creationId xmlns:a16="http://schemas.microsoft.com/office/drawing/2014/main" id="{0DF8B7FE-8D57-46F4-A176-0E7913942890}"/>
                </a:ext>
              </a:extLst>
            </p:cNvPr>
            <p:cNvSpPr/>
            <p:nvPr/>
          </p:nvSpPr>
          <p:spPr>
            <a:xfrm>
              <a:off x="3576799" y="694768"/>
              <a:ext cx="127415" cy="147574"/>
            </a:xfrm>
            <a:custGeom>
              <a:avLst/>
              <a:gdLst>
                <a:gd name="connsiteX0" fmla="*/ 127416 w 127415"/>
                <a:gd name="connsiteY0" fmla="*/ 147571 h 147574"/>
                <a:gd name="connsiteX1" fmla="*/ 1 w 127415"/>
                <a:gd name="connsiteY1" fmla="*/ 147571 h 147574"/>
                <a:gd name="connsiteX2" fmla="*/ 1 w 127415"/>
                <a:gd name="connsiteY2" fmla="*/ -4 h 14757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27415" h="147574">
                  <a:moveTo>
                    <a:pt x="127416" y="147571"/>
                  </a:moveTo>
                  <a:lnTo>
                    <a:pt x="1" y="147571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4" name="Content Placeholder 3">
              <a:extLst>
                <a:ext uri="{FF2B5EF4-FFF2-40B4-BE49-F238E27FC236}">
                  <a16:creationId xmlns:a16="http://schemas.microsoft.com/office/drawing/2014/main" id="{09E95283-1D26-4172-B641-8BD2A3B880C5}"/>
                </a:ext>
              </a:extLst>
            </p:cNvPr>
            <p:cNvSpPr/>
            <p:nvPr/>
          </p:nvSpPr>
          <p:spPr>
            <a:xfrm>
              <a:off x="1885501" y="4027466"/>
              <a:ext cx="779727" cy="1137600"/>
            </a:xfrm>
            <a:custGeom>
              <a:avLst/>
              <a:gdLst>
                <a:gd name="connsiteX0" fmla="*/ 779728 w 779727"/>
                <a:gd name="connsiteY0" fmla="*/ -4 h 1137600"/>
                <a:gd name="connsiteX1" fmla="*/ 1 w 779727"/>
                <a:gd name="connsiteY1" fmla="*/ -4 h 1137600"/>
                <a:gd name="connsiteX2" fmla="*/ 1 w 779727"/>
                <a:gd name="connsiteY2" fmla="*/ 1137597 h 11376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779727" h="1137600">
                  <a:moveTo>
                    <a:pt x="779728" y="-4"/>
                  </a:moveTo>
                  <a:lnTo>
                    <a:pt x="1" y="-4"/>
                  </a:lnTo>
                  <a:lnTo>
                    <a:pt x="1" y="1137597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5" name="Content Placeholder 3">
              <a:extLst>
                <a:ext uri="{FF2B5EF4-FFF2-40B4-BE49-F238E27FC236}">
                  <a16:creationId xmlns:a16="http://schemas.microsoft.com/office/drawing/2014/main" id="{74B28D44-9E52-4642-89E0-8225E4C996CB}"/>
                </a:ext>
              </a:extLst>
            </p:cNvPr>
            <p:cNvSpPr/>
            <p:nvPr/>
          </p:nvSpPr>
          <p:spPr>
            <a:xfrm>
              <a:off x="2913114" y="5343417"/>
              <a:ext cx="115842" cy="295156"/>
            </a:xfrm>
            <a:custGeom>
              <a:avLst/>
              <a:gdLst>
                <a:gd name="connsiteX0" fmla="*/ 115843 w 115842"/>
                <a:gd name="connsiteY0" fmla="*/ -4 h 295156"/>
                <a:gd name="connsiteX1" fmla="*/ 1 w 115842"/>
                <a:gd name="connsiteY1" fmla="*/ -4 h 295156"/>
                <a:gd name="connsiteX2" fmla="*/ 1 w 115842"/>
                <a:gd name="connsiteY2" fmla="*/ 295152 h 29515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15842" h="295156">
                  <a:moveTo>
                    <a:pt x="115843" y="-4"/>
                  </a:moveTo>
                  <a:lnTo>
                    <a:pt x="1" y="-4"/>
                  </a:lnTo>
                  <a:lnTo>
                    <a:pt x="1" y="295152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6" name="Content Placeholder 3">
              <a:extLst>
                <a:ext uri="{FF2B5EF4-FFF2-40B4-BE49-F238E27FC236}">
                  <a16:creationId xmlns:a16="http://schemas.microsoft.com/office/drawing/2014/main" id="{4C4F7790-DA8C-4ED3-BFC4-1B2C8A30CBB7}"/>
                </a:ext>
              </a:extLst>
            </p:cNvPr>
            <p:cNvSpPr/>
            <p:nvPr/>
          </p:nvSpPr>
          <p:spPr>
            <a:xfrm>
              <a:off x="3718624" y="2336553"/>
              <a:ext cx="182971" cy="276705"/>
            </a:xfrm>
            <a:custGeom>
              <a:avLst/>
              <a:gdLst>
                <a:gd name="connsiteX0" fmla="*/ 182972 w 182971"/>
                <a:gd name="connsiteY0" fmla="*/ 276702 h 276705"/>
                <a:gd name="connsiteX1" fmla="*/ 1 w 182971"/>
                <a:gd name="connsiteY1" fmla="*/ 276702 h 276705"/>
                <a:gd name="connsiteX2" fmla="*/ 1 w 182971"/>
                <a:gd name="connsiteY2" fmla="*/ -4 h 27670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82971" h="276705">
                  <a:moveTo>
                    <a:pt x="182972" y="276702"/>
                  </a:moveTo>
                  <a:lnTo>
                    <a:pt x="1" y="276702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7" name="Content Placeholder 3">
              <a:extLst>
                <a:ext uri="{FF2B5EF4-FFF2-40B4-BE49-F238E27FC236}">
                  <a16:creationId xmlns:a16="http://schemas.microsoft.com/office/drawing/2014/main" id="{7B95CA46-866A-480A-BEEF-A648E52345F5}"/>
                </a:ext>
              </a:extLst>
            </p:cNvPr>
            <p:cNvSpPr/>
            <p:nvPr/>
          </p:nvSpPr>
          <p:spPr>
            <a:xfrm>
              <a:off x="4883154" y="4121819"/>
              <a:ext cx="477795" cy="16398"/>
            </a:xfrm>
            <a:custGeom>
              <a:avLst/>
              <a:gdLst>
                <a:gd name="connsiteX0" fmla="*/ 477796 w 477795"/>
                <a:gd name="connsiteY0" fmla="*/ 16394 h 16398"/>
                <a:gd name="connsiteX1" fmla="*/ 1 w 477795"/>
                <a:gd name="connsiteY1" fmla="*/ 16394 h 16398"/>
                <a:gd name="connsiteX2" fmla="*/ 1 w 477795"/>
                <a:gd name="connsiteY2" fmla="*/ -4 h 1639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477795" h="16398">
                  <a:moveTo>
                    <a:pt x="477796" y="16394"/>
                  </a:moveTo>
                  <a:lnTo>
                    <a:pt x="1" y="16394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8" name="Content Placeholder 3">
              <a:extLst>
                <a:ext uri="{FF2B5EF4-FFF2-40B4-BE49-F238E27FC236}">
                  <a16:creationId xmlns:a16="http://schemas.microsoft.com/office/drawing/2014/main" id="{57204492-36C3-4AF9-B033-01D4879DC77C}"/>
                </a:ext>
              </a:extLst>
            </p:cNvPr>
            <p:cNvSpPr/>
            <p:nvPr/>
          </p:nvSpPr>
          <p:spPr>
            <a:xfrm>
              <a:off x="3116518" y="1202063"/>
              <a:ext cx="741644" cy="328970"/>
            </a:xfrm>
            <a:custGeom>
              <a:avLst/>
              <a:gdLst>
                <a:gd name="connsiteX0" fmla="*/ 741645 w 741644"/>
                <a:gd name="connsiteY0" fmla="*/ 328967 h 328970"/>
                <a:gd name="connsiteX1" fmla="*/ 1 w 741644"/>
                <a:gd name="connsiteY1" fmla="*/ 328967 h 328970"/>
                <a:gd name="connsiteX2" fmla="*/ 1 w 741644"/>
                <a:gd name="connsiteY2" fmla="*/ -4 h 3289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741644" h="328970">
                  <a:moveTo>
                    <a:pt x="741645" y="328967"/>
                  </a:moveTo>
                  <a:lnTo>
                    <a:pt x="1" y="328967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9" name="Content Placeholder 3">
              <a:extLst>
                <a:ext uri="{FF2B5EF4-FFF2-40B4-BE49-F238E27FC236}">
                  <a16:creationId xmlns:a16="http://schemas.microsoft.com/office/drawing/2014/main" id="{FC38581B-7A1C-4549-B581-A9705BD42EC8}"/>
                </a:ext>
              </a:extLst>
            </p:cNvPr>
            <p:cNvSpPr/>
            <p:nvPr/>
          </p:nvSpPr>
          <p:spPr>
            <a:xfrm>
              <a:off x="3582696" y="325827"/>
              <a:ext cx="1176875" cy="73787"/>
            </a:xfrm>
            <a:custGeom>
              <a:avLst/>
              <a:gdLst>
                <a:gd name="connsiteX0" fmla="*/ 1176876 w 1176875"/>
                <a:gd name="connsiteY0" fmla="*/ 73784 h 73787"/>
                <a:gd name="connsiteX1" fmla="*/ 1 w 1176875"/>
                <a:gd name="connsiteY1" fmla="*/ 73784 h 73787"/>
                <a:gd name="connsiteX2" fmla="*/ 1 w 1176875"/>
                <a:gd name="connsiteY2" fmla="*/ -4 h 7378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176875" h="73787">
                  <a:moveTo>
                    <a:pt x="1176876" y="73784"/>
                  </a:moveTo>
                  <a:lnTo>
                    <a:pt x="1" y="73784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0" name="Content Placeholder 3">
              <a:extLst>
                <a:ext uri="{FF2B5EF4-FFF2-40B4-BE49-F238E27FC236}">
                  <a16:creationId xmlns:a16="http://schemas.microsoft.com/office/drawing/2014/main" id="{FEF5ED58-E9C1-4E6D-B539-7854D5A33C5B}"/>
                </a:ext>
              </a:extLst>
            </p:cNvPr>
            <p:cNvSpPr/>
            <p:nvPr/>
          </p:nvSpPr>
          <p:spPr>
            <a:xfrm>
              <a:off x="2665229" y="4027466"/>
              <a:ext cx="120628" cy="1174525"/>
            </a:xfrm>
            <a:custGeom>
              <a:avLst/>
              <a:gdLst>
                <a:gd name="connsiteX0" fmla="*/ 120629 w 120628"/>
                <a:gd name="connsiteY0" fmla="*/ 1174521 h 1174525"/>
                <a:gd name="connsiteX1" fmla="*/ 1 w 120628"/>
                <a:gd name="connsiteY1" fmla="*/ 1174521 h 1174525"/>
                <a:gd name="connsiteX2" fmla="*/ 1 w 120628"/>
                <a:gd name="connsiteY2" fmla="*/ -4 h 11745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20628" h="1174525">
                  <a:moveTo>
                    <a:pt x="120629" y="1174521"/>
                  </a:moveTo>
                  <a:lnTo>
                    <a:pt x="1" y="1174521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1" name="Content Placeholder 3">
              <a:extLst>
                <a:ext uri="{FF2B5EF4-FFF2-40B4-BE49-F238E27FC236}">
                  <a16:creationId xmlns:a16="http://schemas.microsoft.com/office/drawing/2014/main" id="{66D80857-DEDE-414B-B940-5BA5506E83EC}"/>
                </a:ext>
              </a:extLst>
            </p:cNvPr>
            <p:cNvSpPr/>
            <p:nvPr/>
          </p:nvSpPr>
          <p:spPr>
            <a:xfrm>
              <a:off x="3576799" y="547192"/>
              <a:ext cx="799351" cy="147576"/>
            </a:xfrm>
            <a:custGeom>
              <a:avLst/>
              <a:gdLst>
                <a:gd name="connsiteX0" fmla="*/ 799352 w 799351"/>
                <a:gd name="connsiteY0" fmla="*/ -4 h 147576"/>
                <a:gd name="connsiteX1" fmla="*/ 1 w 799351"/>
                <a:gd name="connsiteY1" fmla="*/ -4 h 147576"/>
                <a:gd name="connsiteX2" fmla="*/ 1 w 799351"/>
                <a:gd name="connsiteY2" fmla="*/ 147573 h 14757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799351" h="147576">
                  <a:moveTo>
                    <a:pt x="799352" y="-4"/>
                  </a:moveTo>
                  <a:lnTo>
                    <a:pt x="1" y="-4"/>
                  </a:lnTo>
                  <a:lnTo>
                    <a:pt x="1" y="147573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2" name="Content Placeholder 3">
              <a:extLst>
                <a:ext uri="{FF2B5EF4-FFF2-40B4-BE49-F238E27FC236}">
                  <a16:creationId xmlns:a16="http://schemas.microsoft.com/office/drawing/2014/main" id="{02BC0ED7-E872-47F5-90B7-4DC3B7111F34}"/>
                </a:ext>
              </a:extLst>
            </p:cNvPr>
            <p:cNvSpPr/>
            <p:nvPr/>
          </p:nvSpPr>
          <p:spPr>
            <a:xfrm>
              <a:off x="4329727" y="3031390"/>
              <a:ext cx="163306" cy="73792"/>
            </a:xfrm>
            <a:custGeom>
              <a:avLst/>
              <a:gdLst>
                <a:gd name="connsiteX0" fmla="*/ 163307 w 163306"/>
                <a:gd name="connsiteY0" fmla="*/ 73788 h 73792"/>
                <a:gd name="connsiteX1" fmla="*/ 1 w 163306"/>
                <a:gd name="connsiteY1" fmla="*/ 73788 h 73792"/>
                <a:gd name="connsiteX2" fmla="*/ 1 w 163306"/>
                <a:gd name="connsiteY2" fmla="*/ -4 h 7379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63306" h="73792">
                  <a:moveTo>
                    <a:pt x="163307" y="73788"/>
                  </a:moveTo>
                  <a:lnTo>
                    <a:pt x="1" y="73788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3" name="Content Placeholder 3">
              <a:extLst>
                <a:ext uri="{FF2B5EF4-FFF2-40B4-BE49-F238E27FC236}">
                  <a16:creationId xmlns:a16="http://schemas.microsoft.com/office/drawing/2014/main" id="{35C63CCC-B159-4DD0-A79C-3870C9F3416B}"/>
                </a:ext>
              </a:extLst>
            </p:cNvPr>
            <p:cNvSpPr/>
            <p:nvPr/>
          </p:nvSpPr>
          <p:spPr>
            <a:xfrm>
              <a:off x="3973771" y="3166669"/>
              <a:ext cx="777305" cy="135279"/>
            </a:xfrm>
            <a:custGeom>
              <a:avLst/>
              <a:gdLst>
                <a:gd name="connsiteX0" fmla="*/ 777306 w 777305"/>
                <a:gd name="connsiteY0" fmla="*/ 135276 h 135279"/>
                <a:gd name="connsiteX1" fmla="*/ 1 w 777305"/>
                <a:gd name="connsiteY1" fmla="*/ 135276 h 135279"/>
                <a:gd name="connsiteX2" fmla="*/ 1 w 777305"/>
                <a:gd name="connsiteY2" fmla="*/ -4 h 13527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777305" h="135279">
                  <a:moveTo>
                    <a:pt x="777306" y="135276"/>
                  </a:moveTo>
                  <a:lnTo>
                    <a:pt x="1" y="135276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4" name="Content Placeholder 3">
              <a:extLst>
                <a:ext uri="{FF2B5EF4-FFF2-40B4-BE49-F238E27FC236}">
                  <a16:creationId xmlns:a16="http://schemas.microsoft.com/office/drawing/2014/main" id="{46EA8149-27CF-4533-985A-26E96F3C7F83}"/>
                </a:ext>
              </a:extLst>
            </p:cNvPr>
            <p:cNvSpPr/>
            <p:nvPr/>
          </p:nvSpPr>
          <p:spPr>
            <a:xfrm>
              <a:off x="4493033" y="3055987"/>
              <a:ext cx="527486" cy="49194"/>
            </a:xfrm>
            <a:custGeom>
              <a:avLst/>
              <a:gdLst>
                <a:gd name="connsiteX0" fmla="*/ 527487 w 527486"/>
                <a:gd name="connsiteY0" fmla="*/ -4 h 49194"/>
                <a:gd name="connsiteX1" fmla="*/ 1 w 527486"/>
                <a:gd name="connsiteY1" fmla="*/ -4 h 49194"/>
                <a:gd name="connsiteX2" fmla="*/ 1 w 527486"/>
                <a:gd name="connsiteY2" fmla="*/ 49191 h 491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527486" h="49194">
                  <a:moveTo>
                    <a:pt x="527487" y="-4"/>
                  </a:moveTo>
                  <a:lnTo>
                    <a:pt x="1" y="-4"/>
                  </a:lnTo>
                  <a:lnTo>
                    <a:pt x="1" y="49191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5" name="Content Placeholder 3">
              <a:extLst>
                <a:ext uri="{FF2B5EF4-FFF2-40B4-BE49-F238E27FC236}">
                  <a16:creationId xmlns:a16="http://schemas.microsoft.com/office/drawing/2014/main" id="{6992D26D-8BE3-459B-9E11-456D742B5C72}"/>
                </a:ext>
              </a:extLst>
            </p:cNvPr>
            <p:cNvSpPr/>
            <p:nvPr/>
          </p:nvSpPr>
          <p:spPr>
            <a:xfrm>
              <a:off x="3858163" y="1481839"/>
              <a:ext cx="1068415" cy="49194"/>
            </a:xfrm>
            <a:custGeom>
              <a:avLst/>
              <a:gdLst>
                <a:gd name="connsiteX0" fmla="*/ 1068416 w 1068415"/>
                <a:gd name="connsiteY0" fmla="*/ -4 h 49194"/>
                <a:gd name="connsiteX1" fmla="*/ 1 w 1068415"/>
                <a:gd name="connsiteY1" fmla="*/ -4 h 49194"/>
                <a:gd name="connsiteX2" fmla="*/ 1 w 1068415"/>
                <a:gd name="connsiteY2" fmla="*/ 49191 h 491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068415" h="49194">
                  <a:moveTo>
                    <a:pt x="1068416" y="-4"/>
                  </a:moveTo>
                  <a:lnTo>
                    <a:pt x="1" y="-4"/>
                  </a:lnTo>
                  <a:lnTo>
                    <a:pt x="1" y="49191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6" name="Content Placeholder 3">
              <a:extLst>
                <a:ext uri="{FF2B5EF4-FFF2-40B4-BE49-F238E27FC236}">
                  <a16:creationId xmlns:a16="http://schemas.microsoft.com/office/drawing/2014/main" id="{9E90B7C3-9869-4C23-B50E-E540878F89C2}"/>
                </a:ext>
              </a:extLst>
            </p:cNvPr>
            <p:cNvSpPr/>
            <p:nvPr/>
          </p:nvSpPr>
          <p:spPr>
            <a:xfrm>
              <a:off x="4637388" y="5712360"/>
              <a:ext cx="340430" cy="49194"/>
            </a:xfrm>
            <a:custGeom>
              <a:avLst/>
              <a:gdLst>
                <a:gd name="connsiteX0" fmla="*/ 340431 w 340430"/>
                <a:gd name="connsiteY0" fmla="*/ -4 h 49194"/>
                <a:gd name="connsiteX1" fmla="*/ 1 w 340430"/>
                <a:gd name="connsiteY1" fmla="*/ -4 h 49194"/>
                <a:gd name="connsiteX2" fmla="*/ 1 w 340430"/>
                <a:gd name="connsiteY2" fmla="*/ 49191 h 491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340430" h="49194">
                  <a:moveTo>
                    <a:pt x="340431" y="-4"/>
                  </a:moveTo>
                  <a:lnTo>
                    <a:pt x="1" y="-4"/>
                  </a:lnTo>
                  <a:lnTo>
                    <a:pt x="1" y="49191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7" name="Content Placeholder 3">
              <a:extLst>
                <a:ext uri="{FF2B5EF4-FFF2-40B4-BE49-F238E27FC236}">
                  <a16:creationId xmlns:a16="http://schemas.microsoft.com/office/drawing/2014/main" id="{F77B2B50-C9E1-491B-923C-98CBE8B830E8}"/>
                </a:ext>
              </a:extLst>
            </p:cNvPr>
            <p:cNvSpPr/>
            <p:nvPr/>
          </p:nvSpPr>
          <p:spPr>
            <a:xfrm>
              <a:off x="4006924" y="1334266"/>
              <a:ext cx="539736" cy="49188"/>
            </a:xfrm>
            <a:custGeom>
              <a:avLst/>
              <a:gdLst>
                <a:gd name="connsiteX0" fmla="*/ 539737 w 539736"/>
                <a:gd name="connsiteY0" fmla="*/ 49185 h 49188"/>
                <a:gd name="connsiteX1" fmla="*/ 1 w 539736"/>
                <a:gd name="connsiteY1" fmla="*/ 49185 h 49188"/>
                <a:gd name="connsiteX2" fmla="*/ 1 w 539736"/>
                <a:gd name="connsiteY2" fmla="*/ -4 h 4918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539736" h="49188">
                  <a:moveTo>
                    <a:pt x="539737" y="49185"/>
                  </a:moveTo>
                  <a:lnTo>
                    <a:pt x="1" y="49185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8" name="Content Placeholder 3">
              <a:extLst>
                <a:ext uri="{FF2B5EF4-FFF2-40B4-BE49-F238E27FC236}">
                  <a16:creationId xmlns:a16="http://schemas.microsoft.com/office/drawing/2014/main" id="{E20BDBCD-172D-4E95-983B-17EA5FC708FB}"/>
                </a:ext>
              </a:extLst>
            </p:cNvPr>
            <p:cNvSpPr/>
            <p:nvPr/>
          </p:nvSpPr>
          <p:spPr>
            <a:xfrm>
              <a:off x="4376151" y="547192"/>
              <a:ext cx="258119" cy="49192"/>
            </a:xfrm>
            <a:custGeom>
              <a:avLst/>
              <a:gdLst>
                <a:gd name="connsiteX0" fmla="*/ 258120 w 258119"/>
                <a:gd name="connsiteY0" fmla="*/ 49188 h 49192"/>
                <a:gd name="connsiteX1" fmla="*/ 1 w 258119"/>
                <a:gd name="connsiteY1" fmla="*/ 49188 h 49192"/>
                <a:gd name="connsiteX2" fmla="*/ 1 w 258119"/>
                <a:gd name="connsiteY2" fmla="*/ -4 h 4919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58119" h="49192">
                  <a:moveTo>
                    <a:pt x="258120" y="49188"/>
                  </a:moveTo>
                  <a:lnTo>
                    <a:pt x="1" y="49188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9" name="Content Placeholder 3">
              <a:extLst>
                <a:ext uri="{FF2B5EF4-FFF2-40B4-BE49-F238E27FC236}">
                  <a16:creationId xmlns:a16="http://schemas.microsoft.com/office/drawing/2014/main" id="{817168CD-2900-4991-9A4C-0365302B923F}"/>
                </a:ext>
              </a:extLst>
            </p:cNvPr>
            <p:cNvSpPr/>
            <p:nvPr/>
          </p:nvSpPr>
          <p:spPr>
            <a:xfrm>
              <a:off x="3991326" y="4974480"/>
              <a:ext cx="731735" cy="49194"/>
            </a:xfrm>
            <a:custGeom>
              <a:avLst/>
              <a:gdLst>
                <a:gd name="connsiteX0" fmla="*/ 731736 w 731735"/>
                <a:gd name="connsiteY0" fmla="*/ 49191 h 49194"/>
                <a:gd name="connsiteX1" fmla="*/ 1 w 731735"/>
                <a:gd name="connsiteY1" fmla="*/ 49191 h 49194"/>
                <a:gd name="connsiteX2" fmla="*/ 1 w 731735"/>
                <a:gd name="connsiteY2" fmla="*/ -4 h 491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731735" h="49194">
                  <a:moveTo>
                    <a:pt x="731736" y="49191"/>
                  </a:moveTo>
                  <a:lnTo>
                    <a:pt x="1" y="49191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0" name="Content Placeholder 3">
              <a:extLst>
                <a:ext uri="{FF2B5EF4-FFF2-40B4-BE49-F238E27FC236}">
                  <a16:creationId xmlns:a16="http://schemas.microsoft.com/office/drawing/2014/main" id="{ECF9E645-A27E-4455-8E87-A8CD459D4649}"/>
                </a:ext>
              </a:extLst>
            </p:cNvPr>
            <p:cNvSpPr/>
            <p:nvPr/>
          </p:nvSpPr>
          <p:spPr>
            <a:xfrm>
              <a:off x="2665229" y="2852941"/>
              <a:ext cx="248585" cy="1174525"/>
            </a:xfrm>
            <a:custGeom>
              <a:avLst/>
              <a:gdLst>
                <a:gd name="connsiteX0" fmla="*/ 248586 w 248585"/>
                <a:gd name="connsiteY0" fmla="*/ -4 h 1174525"/>
                <a:gd name="connsiteX1" fmla="*/ 1 w 248585"/>
                <a:gd name="connsiteY1" fmla="*/ -4 h 1174525"/>
                <a:gd name="connsiteX2" fmla="*/ 1 w 248585"/>
                <a:gd name="connsiteY2" fmla="*/ 1174521 h 11745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48585" h="1174525">
                  <a:moveTo>
                    <a:pt x="248586" y="-4"/>
                  </a:moveTo>
                  <a:lnTo>
                    <a:pt x="1" y="-4"/>
                  </a:lnTo>
                  <a:lnTo>
                    <a:pt x="1" y="1174521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1" name="Content Placeholder 3">
              <a:extLst>
                <a:ext uri="{FF2B5EF4-FFF2-40B4-BE49-F238E27FC236}">
                  <a16:creationId xmlns:a16="http://schemas.microsoft.com/office/drawing/2014/main" id="{06657A53-E40B-4E7B-8B30-15847C82EC41}"/>
                </a:ext>
              </a:extLst>
            </p:cNvPr>
            <p:cNvSpPr/>
            <p:nvPr/>
          </p:nvSpPr>
          <p:spPr>
            <a:xfrm>
              <a:off x="3022206" y="3663716"/>
              <a:ext cx="1044823" cy="164999"/>
            </a:xfrm>
            <a:custGeom>
              <a:avLst/>
              <a:gdLst>
                <a:gd name="connsiteX0" fmla="*/ 1044824 w 1044823"/>
                <a:gd name="connsiteY0" fmla="*/ 164996 h 164999"/>
                <a:gd name="connsiteX1" fmla="*/ 1 w 1044823"/>
                <a:gd name="connsiteY1" fmla="*/ 164996 h 164999"/>
                <a:gd name="connsiteX2" fmla="*/ 1 w 1044823"/>
                <a:gd name="connsiteY2" fmla="*/ -4 h 1649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044823" h="164999">
                  <a:moveTo>
                    <a:pt x="1044824" y="164996"/>
                  </a:moveTo>
                  <a:lnTo>
                    <a:pt x="1" y="164996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2" name="Content Placeholder 3">
              <a:extLst>
                <a:ext uri="{FF2B5EF4-FFF2-40B4-BE49-F238E27FC236}">
                  <a16:creationId xmlns:a16="http://schemas.microsoft.com/office/drawing/2014/main" id="{CE443CFA-4C80-4A1A-8B83-62C9B2981AD7}"/>
                </a:ext>
              </a:extLst>
            </p:cNvPr>
            <p:cNvSpPr/>
            <p:nvPr/>
          </p:nvSpPr>
          <p:spPr>
            <a:xfrm>
              <a:off x="4751076" y="3301949"/>
              <a:ext cx="432248" cy="49194"/>
            </a:xfrm>
            <a:custGeom>
              <a:avLst/>
              <a:gdLst>
                <a:gd name="connsiteX0" fmla="*/ 432249 w 432248"/>
                <a:gd name="connsiteY0" fmla="*/ 49191 h 49194"/>
                <a:gd name="connsiteX1" fmla="*/ 1 w 432248"/>
                <a:gd name="connsiteY1" fmla="*/ 49191 h 49194"/>
                <a:gd name="connsiteX2" fmla="*/ 1 w 432248"/>
                <a:gd name="connsiteY2" fmla="*/ -4 h 491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432248" h="49194">
                  <a:moveTo>
                    <a:pt x="432249" y="49191"/>
                  </a:moveTo>
                  <a:lnTo>
                    <a:pt x="1" y="49191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3" name="Content Placeholder 3">
              <a:extLst>
                <a:ext uri="{FF2B5EF4-FFF2-40B4-BE49-F238E27FC236}">
                  <a16:creationId xmlns:a16="http://schemas.microsoft.com/office/drawing/2014/main" id="{F4BCBC29-D1F1-4F7B-B33B-40F4446DC8F3}"/>
                </a:ext>
              </a:extLst>
            </p:cNvPr>
            <p:cNvSpPr/>
            <p:nvPr/>
          </p:nvSpPr>
          <p:spPr>
            <a:xfrm>
              <a:off x="4989567" y="6007539"/>
              <a:ext cx="1852" cy="5749"/>
            </a:xfrm>
            <a:custGeom>
              <a:avLst/>
              <a:gdLst>
                <a:gd name="connsiteX0" fmla="*/ 1853 w 1852"/>
                <a:gd name="connsiteY0" fmla="*/ -4 h 5749"/>
                <a:gd name="connsiteX1" fmla="*/ 1 w 1852"/>
                <a:gd name="connsiteY1" fmla="*/ -4 h 5749"/>
                <a:gd name="connsiteX2" fmla="*/ 1 w 1852"/>
                <a:gd name="connsiteY2" fmla="*/ -4 h 574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852" h="5749">
                  <a:moveTo>
                    <a:pt x="1853" y="-4"/>
                  </a:moveTo>
                  <a:lnTo>
                    <a:pt x="1" y="-4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4" name="Content Placeholder 3">
              <a:extLst>
                <a:ext uri="{FF2B5EF4-FFF2-40B4-BE49-F238E27FC236}">
                  <a16:creationId xmlns:a16="http://schemas.microsoft.com/office/drawing/2014/main" id="{FE09DA17-92BF-4183-9854-1A0D0144FE0B}"/>
                </a:ext>
              </a:extLst>
            </p:cNvPr>
            <p:cNvSpPr/>
            <p:nvPr/>
          </p:nvSpPr>
          <p:spPr>
            <a:xfrm>
              <a:off x="4787903" y="1826184"/>
              <a:ext cx="354618" cy="49194"/>
            </a:xfrm>
            <a:custGeom>
              <a:avLst/>
              <a:gdLst>
                <a:gd name="connsiteX0" fmla="*/ 354619 w 354618"/>
                <a:gd name="connsiteY0" fmla="*/ 49191 h 49194"/>
                <a:gd name="connsiteX1" fmla="*/ 1 w 354618"/>
                <a:gd name="connsiteY1" fmla="*/ 49191 h 49194"/>
                <a:gd name="connsiteX2" fmla="*/ 1 w 354618"/>
                <a:gd name="connsiteY2" fmla="*/ -4 h 491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354618" h="49194">
                  <a:moveTo>
                    <a:pt x="354619" y="49191"/>
                  </a:moveTo>
                  <a:lnTo>
                    <a:pt x="1" y="49191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5" name="Content Placeholder 3">
              <a:extLst>
                <a:ext uri="{FF2B5EF4-FFF2-40B4-BE49-F238E27FC236}">
                  <a16:creationId xmlns:a16="http://schemas.microsoft.com/office/drawing/2014/main" id="{EEF9F68F-3DE3-41A3-98B4-6F4F3169CA11}"/>
                </a:ext>
              </a:extLst>
            </p:cNvPr>
            <p:cNvSpPr/>
            <p:nvPr/>
          </p:nvSpPr>
          <p:spPr>
            <a:xfrm>
              <a:off x="2913814" y="2042173"/>
              <a:ext cx="88243" cy="810768"/>
            </a:xfrm>
            <a:custGeom>
              <a:avLst/>
              <a:gdLst>
                <a:gd name="connsiteX0" fmla="*/ 88244 w 88243"/>
                <a:gd name="connsiteY0" fmla="*/ -4 h 810768"/>
                <a:gd name="connsiteX1" fmla="*/ 1 w 88243"/>
                <a:gd name="connsiteY1" fmla="*/ -4 h 810768"/>
                <a:gd name="connsiteX2" fmla="*/ 1 w 88243"/>
                <a:gd name="connsiteY2" fmla="*/ 810765 h 81076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88243" h="810768">
                  <a:moveTo>
                    <a:pt x="88244" y="-4"/>
                  </a:moveTo>
                  <a:lnTo>
                    <a:pt x="1" y="-4"/>
                  </a:lnTo>
                  <a:lnTo>
                    <a:pt x="1" y="810765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6" name="Content Placeholder 3">
              <a:extLst>
                <a:ext uri="{FF2B5EF4-FFF2-40B4-BE49-F238E27FC236}">
                  <a16:creationId xmlns:a16="http://schemas.microsoft.com/office/drawing/2014/main" id="{278F95BD-6549-4C77-98A1-9B491BCE1B98}"/>
                </a:ext>
              </a:extLst>
            </p:cNvPr>
            <p:cNvSpPr/>
            <p:nvPr/>
          </p:nvSpPr>
          <p:spPr>
            <a:xfrm>
              <a:off x="3364936" y="325827"/>
              <a:ext cx="217759" cy="184470"/>
            </a:xfrm>
            <a:custGeom>
              <a:avLst/>
              <a:gdLst>
                <a:gd name="connsiteX0" fmla="*/ 217760 w 217759"/>
                <a:gd name="connsiteY0" fmla="*/ -4 h 184470"/>
                <a:gd name="connsiteX1" fmla="*/ 1 w 217759"/>
                <a:gd name="connsiteY1" fmla="*/ -4 h 184470"/>
                <a:gd name="connsiteX2" fmla="*/ 1 w 217759"/>
                <a:gd name="connsiteY2" fmla="*/ 184466 h 1844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17759" h="184470">
                  <a:moveTo>
                    <a:pt x="217760" y="-4"/>
                  </a:moveTo>
                  <a:lnTo>
                    <a:pt x="1" y="-4"/>
                  </a:lnTo>
                  <a:lnTo>
                    <a:pt x="1" y="184466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7" name="Content Placeholder 3">
              <a:extLst>
                <a:ext uri="{FF2B5EF4-FFF2-40B4-BE49-F238E27FC236}">
                  <a16:creationId xmlns:a16="http://schemas.microsoft.com/office/drawing/2014/main" id="{5AB928ED-5DC1-4C74-880A-E1EF2C9AC3C6}"/>
                </a:ext>
              </a:extLst>
            </p:cNvPr>
            <p:cNvSpPr/>
            <p:nvPr/>
          </p:nvSpPr>
          <p:spPr>
            <a:xfrm>
              <a:off x="3203072" y="5490996"/>
              <a:ext cx="317277" cy="73786"/>
            </a:xfrm>
            <a:custGeom>
              <a:avLst/>
              <a:gdLst>
                <a:gd name="connsiteX0" fmla="*/ 317278 w 317277"/>
                <a:gd name="connsiteY0" fmla="*/ 73782 h 73786"/>
                <a:gd name="connsiteX1" fmla="*/ 1 w 317277"/>
                <a:gd name="connsiteY1" fmla="*/ 73782 h 73786"/>
                <a:gd name="connsiteX2" fmla="*/ 1 w 317277"/>
                <a:gd name="connsiteY2" fmla="*/ -4 h 7378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317277" h="73786">
                  <a:moveTo>
                    <a:pt x="317278" y="73782"/>
                  </a:moveTo>
                  <a:lnTo>
                    <a:pt x="1" y="73782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8" name="Content Placeholder 3">
              <a:extLst>
                <a:ext uri="{FF2B5EF4-FFF2-40B4-BE49-F238E27FC236}">
                  <a16:creationId xmlns:a16="http://schemas.microsoft.com/office/drawing/2014/main" id="{8D33DE0D-9EA5-4704-B00D-8C946919F0F7}"/>
                </a:ext>
              </a:extLst>
            </p:cNvPr>
            <p:cNvSpPr/>
            <p:nvPr/>
          </p:nvSpPr>
          <p:spPr>
            <a:xfrm>
              <a:off x="4067030" y="3828716"/>
              <a:ext cx="190232" cy="182421"/>
            </a:xfrm>
            <a:custGeom>
              <a:avLst/>
              <a:gdLst>
                <a:gd name="connsiteX0" fmla="*/ 190233 w 190232"/>
                <a:gd name="connsiteY0" fmla="*/ 182418 h 182421"/>
                <a:gd name="connsiteX1" fmla="*/ 1 w 190232"/>
                <a:gd name="connsiteY1" fmla="*/ 182418 h 182421"/>
                <a:gd name="connsiteX2" fmla="*/ 1 w 190232"/>
                <a:gd name="connsiteY2" fmla="*/ -4 h 18242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90232" h="182421">
                  <a:moveTo>
                    <a:pt x="190233" y="182418"/>
                  </a:moveTo>
                  <a:lnTo>
                    <a:pt x="1" y="182418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9" name="Content Placeholder 3">
              <a:extLst>
                <a:ext uri="{FF2B5EF4-FFF2-40B4-BE49-F238E27FC236}">
                  <a16:creationId xmlns:a16="http://schemas.microsoft.com/office/drawing/2014/main" id="{A19F547E-AAC7-4FC1-A2EB-CB3DAB496EB1}"/>
                </a:ext>
              </a:extLst>
            </p:cNvPr>
            <p:cNvSpPr/>
            <p:nvPr/>
          </p:nvSpPr>
          <p:spPr>
            <a:xfrm>
              <a:off x="4731104" y="6105918"/>
              <a:ext cx="271024" cy="98377"/>
            </a:xfrm>
            <a:custGeom>
              <a:avLst/>
              <a:gdLst>
                <a:gd name="connsiteX0" fmla="*/ 271025 w 271024"/>
                <a:gd name="connsiteY0" fmla="*/ 98374 h 98377"/>
                <a:gd name="connsiteX1" fmla="*/ 1 w 271024"/>
                <a:gd name="connsiteY1" fmla="*/ 98374 h 98377"/>
                <a:gd name="connsiteX2" fmla="*/ 1 w 271024"/>
                <a:gd name="connsiteY2" fmla="*/ -4 h 9837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71024" h="98377">
                  <a:moveTo>
                    <a:pt x="271025" y="98374"/>
                  </a:moveTo>
                  <a:lnTo>
                    <a:pt x="1" y="98374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40" name="Content Placeholder 3">
              <a:extLst>
                <a:ext uri="{FF2B5EF4-FFF2-40B4-BE49-F238E27FC236}">
                  <a16:creationId xmlns:a16="http://schemas.microsoft.com/office/drawing/2014/main" id="{33281EA0-C8C8-48C2-9248-8349CA96A70C}"/>
                </a:ext>
              </a:extLst>
            </p:cNvPr>
            <p:cNvSpPr/>
            <p:nvPr/>
          </p:nvSpPr>
          <p:spPr>
            <a:xfrm>
              <a:off x="3929073" y="202847"/>
              <a:ext cx="1274358" cy="49192"/>
            </a:xfrm>
            <a:custGeom>
              <a:avLst/>
              <a:gdLst>
                <a:gd name="connsiteX0" fmla="*/ 1274360 w 1274358"/>
                <a:gd name="connsiteY0" fmla="*/ -4 h 49192"/>
                <a:gd name="connsiteX1" fmla="*/ 1 w 1274358"/>
                <a:gd name="connsiteY1" fmla="*/ -4 h 49192"/>
                <a:gd name="connsiteX2" fmla="*/ 1 w 1274358"/>
                <a:gd name="connsiteY2" fmla="*/ 49188 h 4919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274358" h="49192">
                  <a:moveTo>
                    <a:pt x="1274360" y="-4"/>
                  </a:moveTo>
                  <a:lnTo>
                    <a:pt x="1" y="-4"/>
                  </a:lnTo>
                  <a:lnTo>
                    <a:pt x="1" y="49188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41" name="Content Placeholder 3">
              <a:extLst>
                <a:ext uri="{FF2B5EF4-FFF2-40B4-BE49-F238E27FC236}">
                  <a16:creationId xmlns:a16="http://schemas.microsoft.com/office/drawing/2014/main" id="{599D978E-E964-472A-802E-3AFE4E861BB2}"/>
                </a:ext>
              </a:extLst>
            </p:cNvPr>
            <p:cNvSpPr/>
            <p:nvPr/>
          </p:nvSpPr>
          <p:spPr>
            <a:xfrm>
              <a:off x="4278427" y="1752398"/>
              <a:ext cx="213769" cy="110682"/>
            </a:xfrm>
            <a:custGeom>
              <a:avLst/>
              <a:gdLst>
                <a:gd name="connsiteX0" fmla="*/ 213770 w 213769"/>
                <a:gd name="connsiteY0" fmla="*/ -4 h 110682"/>
                <a:gd name="connsiteX1" fmla="*/ 1 w 213769"/>
                <a:gd name="connsiteY1" fmla="*/ -4 h 110682"/>
                <a:gd name="connsiteX2" fmla="*/ 1 w 213769"/>
                <a:gd name="connsiteY2" fmla="*/ 110678 h 11068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13769" h="110682">
                  <a:moveTo>
                    <a:pt x="213770" y="-4"/>
                  </a:moveTo>
                  <a:lnTo>
                    <a:pt x="1" y="-4"/>
                  </a:lnTo>
                  <a:lnTo>
                    <a:pt x="1" y="110678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42" name="Content Placeholder 3">
              <a:extLst>
                <a:ext uri="{FF2B5EF4-FFF2-40B4-BE49-F238E27FC236}">
                  <a16:creationId xmlns:a16="http://schemas.microsoft.com/office/drawing/2014/main" id="{676104C4-74F5-4140-9399-77075BA37448}"/>
                </a:ext>
              </a:extLst>
            </p:cNvPr>
            <p:cNvSpPr/>
            <p:nvPr/>
          </p:nvSpPr>
          <p:spPr>
            <a:xfrm>
              <a:off x="4414699" y="5933713"/>
              <a:ext cx="316405" cy="172204"/>
            </a:xfrm>
            <a:custGeom>
              <a:avLst/>
              <a:gdLst>
                <a:gd name="connsiteX0" fmla="*/ 316406 w 316405"/>
                <a:gd name="connsiteY0" fmla="*/ 172201 h 172204"/>
                <a:gd name="connsiteX1" fmla="*/ 1 w 316405"/>
                <a:gd name="connsiteY1" fmla="*/ 172201 h 172204"/>
                <a:gd name="connsiteX2" fmla="*/ 1 w 316405"/>
                <a:gd name="connsiteY2" fmla="*/ -4 h 17220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316405" h="172204">
                  <a:moveTo>
                    <a:pt x="316406" y="172201"/>
                  </a:moveTo>
                  <a:lnTo>
                    <a:pt x="1" y="172201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43" name="Content Placeholder 3">
              <a:extLst>
                <a:ext uri="{FF2B5EF4-FFF2-40B4-BE49-F238E27FC236}">
                  <a16:creationId xmlns:a16="http://schemas.microsoft.com/office/drawing/2014/main" id="{E5B57ADC-5E37-432B-8729-78AECF8E4D0F}"/>
                </a:ext>
              </a:extLst>
            </p:cNvPr>
            <p:cNvSpPr/>
            <p:nvPr/>
          </p:nvSpPr>
          <p:spPr>
            <a:xfrm>
              <a:off x="3891817" y="4531752"/>
              <a:ext cx="990298" cy="49194"/>
            </a:xfrm>
            <a:custGeom>
              <a:avLst/>
              <a:gdLst>
                <a:gd name="connsiteX0" fmla="*/ 990299 w 990298"/>
                <a:gd name="connsiteY0" fmla="*/ -4 h 49194"/>
                <a:gd name="connsiteX1" fmla="*/ 1 w 990298"/>
                <a:gd name="connsiteY1" fmla="*/ -4 h 49194"/>
                <a:gd name="connsiteX2" fmla="*/ 1 w 990298"/>
                <a:gd name="connsiteY2" fmla="*/ 49191 h 491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990298" h="49194">
                  <a:moveTo>
                    <a:pt x="990299" y="-4"/>
                  </a:moveTo>
                  <a:lnTo>
                    <a:pt x="1" y="-4"/>
                  </a:lnTo>
                  <a:lnTo>
                    <a:pt x="1" y="49191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44" name="Content Placeholder 3">
              <a:extLst>
                <a:ext uri="{FF2B5EF4-FFF2-40B4-BE49-F238E27FC236}">
                  <a16:creationId xmlns:a16="http://schemas.microsoft.com/office/drawing/2014/main" id="{B1079839-D11B-4FA3-8A36-0FC5A254C21D}"/>
                </a:ext>
              </a:extLst>
            </p:cNvPr>
            <p:cNvSpPr/>
            <p:nvPr/>
          </p:nvSpPr>
          <p:spPr>
            <a:xfrm>
              <a:off x="4989567" y="6007539"/>
              <a:ext cx="1987" cy="98378"/>
            </a:xfrm>
            <a:custGeom>
              <a:avLst/>
              <a:gdLst>
                <a:gd name="connsiteX0" fmla="*/ 1988 w 1987"/>
                <a:gd name="connsiteY0" fmla="*/ 98374 h 98378"/>
                <a:gd name="connsiteX1" fmla="*/ 1 w 1987"/>
                <a:gd name="connsiteY1" fmla="*/ 98374 h 98378"/>
                <a:gd name="connsiteX2" fmla="*/ 1 w 1987"/>
                <a:gd name="connsiteY2" fmla="*/ -4 h 9837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987" h="98378">
                  <a:moveTo>
                    <a:pt x="1988" y="98374"/>
                  </a:moveTo>
                  <a:lnTo>
                    <a:pt x="1" y="98374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45" name="Content Placeholder 3">
              <a:extLst>
                <a:ext uri="{FF2B5EF4-FFF2-40B4-BE49-F238E27FC236}">
                  <a16:creationId xmlns:a16="http://schemas.microsoft.com/office/drawing/2014/main" id="{048CE57E-C310-454F-BF2A-63C6CD5CB870}"/>
                </a:ext>
              </a:extLst>
            </p:cNvPr>
            <p:cNvSpPr/>
            <p:nvPr/>
          </p:nvSpPr>
          <p:spPr>
            <a:xfrm>
              <a:off x="3868949" y="1863080"/>
              <a:ext cx="409478" cy="196767"/>
            </a:xfrm>
            <a:custGeom>
              <a:avLst/>
              <a:gdLst>
                <a:gd name="connsiteX0" fmla="*/ 409479 w 409478"/>
                <a:gd name="connsiteY0" fmla="*/ -4 h 196767"/>
                <a:gd name="connsiteX1" fmla="*/ 1 w 409478"/>
                <a:gd name="connsiteY1" fmla="*/ -4 h 196767"/>
                <a:gd name="connsiteX2" fmla="*/ 1 w 409478"/>
                <a:gd name="connsiteY2" fmla="*/ 196763 h 19676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409478" h="196767">
                  <a:moveTo>
                    <a:pt x="409479" y="-4"/>
                  </a:moveTo>
                  <a:lnTo>
                    <a:pt x="1" y="-4"/>
                  </a:lnTo>
                  <a:lnTo>
                    <a:pt x="1" y="196763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46" name="Content Placeholder 3">
              <a:extLst>
                <a:ext uri="{FF2B5EF4-FFF2-40B4-BE49-F238E27FC236}">
                  <a16:creationId xmlns:a16="http://schemas.microsoft.com/office/drawing/2014/main" id="{62ABBD8C-74C1-4C8C-9BBB-4E3408B5E72D}"/>
                </a:ext>
              </a:extLst>
            </p:cNvPr>
            <p:cNvSpPr/>
            <p:nvPr/>
          </p:nvSpPr>
          <p:spPr>
            <a:xfrm>
              <a:off x="2785857" y="4765415"/>
              <a:ext cx="161327" cy="436576"/>
            </a:xfrm>
            <a:custGeom>
              <a:avLst/>
              <a:gdLst>
                <a:gd name="connsiteX0" fmla="*/ 161328 w 161327"/>
                <a:gd name="connsiteY0" fmla="*/ -4 h 436576"/>
                <a:gd name="connsiteX1" fmla="*/ 1 w 161327"/>
                <a:gd name="connsiteY1" fmla="*/ -4 h 436576"/>
                <a:gd name="connsiteX2" fmla="*/ 1 w 161327"/>
                <a:gd name="connsiteY2" fmla="*/ 436573 h 43657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61327" h="436576">
                  <a:moveTo>
                    <a:pt x="161328" y="-4"/>
                  </a:moveTo>
                  <a:lnTo>
                    <a:pt x="1" y="-4"/>
                  </a:lnTo>
                  <a:lnTo>
                    <a:pt x="1" y="436573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47" name="Content Placeholder 3">
              <a:extLst>
                <a:ext uri="{FF2B5EF4-FFF2-40B4-BE49-F238E27FC236}">
                  <a16:creationId xmlns:a16="http://schemas.microsoft.com/office/drawing/2014/main" id="{9F90B1B5-E3AE-4D40-A8D4-D170CCE70951}"/>
                </a:ext>
              </a:extLst>
            </p:cNvPr>
            <p:cNvSpPr/>
            <p:nvPr/>
          </p:nvSpPr>
          <p:spPr>
            <a:xfrm>
              <a:off x="3116518" y="873087"/>
              <a:ext cx="94208" cy="328976"/>
            </a:xfrm>
            <a:custGeom>
              <a:avLst/>
              <a:gdLst>
                <a:gd name="connsiteX0" fmla="*/ 94209 w 94208"/>
                <a:gd name="connsiteY0" fmla="*/ -4 h 328976"/>
                <a:gd name="connsiteX1" fmla="*/ 1 w 94208"/>
                <a:gd name="connsiteY1" fmla="*/ -4 h 328976"/>
                <a:gd name="connsiteX2" fmla="*/ 1 w 94208"/>
                <a:gd name="connsiteY2" fmla="*/ 328972 h 32897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94208" h="328976">
                  <a:moveTo>
                    <a:pt x="94209" y="-4"/>
                  </a:moveTo>
                  <a:lnTo>
                    <a:pt x="1" y="-4"/>
                  </a:lnTo>
                  <a:lnTo>
                    <a:pt x="1" y="328972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48" name="Content Placeholder 3">
              <a:extLst>
                <a:ext uri="{FF2B5EF4-FFF2-40B4-BE49-F238E27FC236}">
                  <a16:creationId xmlns:a16="http://schemas.microsoft.com/office/drawing/2014/main" id="{A0369132-EA99-4F1D-9587-7C95226F3299}"/>
                </a:ext>
              </a:extLst>
            </p:cNvPr>
            <p:cNvSpPr/>
            <p:nvPr/>
          </p:nvSpPr>
          <p:spPr>
            <a:xfrm>
              <a:off x="4257262" y="3793866"/>
              <a:ext cx="205324" cy="217270"/>
            </a:xfrm>
            <a:custGeom>
              <a:avLst/>
              <a:gdLst>
                <a:gd name="connsiteX0" fmla="*/ 205325 w 205324"/>
                <a:gd name="connsiteY0" fmla="*/ -4 h 217270"/>
                <a:gd name="connsiteX1" fmla="*/ 1 w 205324"/>
                <a:gd name="connsiteY1" fmla="*/ -4 h 217270"/>
                <a:gd name="connsiteX2" fmla="*/ 1 w 205324"/>
                <a:gd name="connsiteY2" fmla="*/ 217267 h 217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05324" h="217270">
                  <a:moveTo>
                    <a:pt x="205325" y="-4"/>
                  </a:moveTo>
                  <a:lnTo>
                    <a:pt x="1" y="-4"/>
                  </a:lnTo>
                  <a:lnTo>
                    <a:pt x="1" y="217267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49" name="Content Placeholder 3">
              <a:extLst>
                <a:ext uri="{FF2B5EF4-FFF2-40B4-BE49-F238E27FC236}">
                  <a16:creationId xmlns:a16="http://schemas.microsoft.com/office/drawing/2014/main" id="{10654DEA-A913-4010-AF94-BDA439E95BA6}"/>
                </a:ext>
              </a:extLst>
            </p:cNvPr>
            <p:cNvSpPr/>
            <p:nvPr/>
          </p:nvSpPr>
          <p:spPr>
            <a:xfrm>
              <a:off x="3991326" y="4925286"/>
              <a:ext cx="798203" cy="49194"/>
            </a:xfrm>
            <a:custGeom>
              <a:avLst/>
              <a:gdLst>
                <a:gd name="connsiteX0" fmla="*/ 798204 w 798203"/>
                <a:gd name="connsiteY0" fmla="*/ -4 h 49194"/>
                <a:gd name="connsiteX1" fmla="*/ 1 w 798203"/>
                <a:gd name="connsiteY1" fmla="*/ -4 h 49194"/>
                <a:gd name="connsiteX2" fmla="*/ 1 w 798203"/>
                <a:gd name="connsiteY2" fmla="*/ 49191 h 491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798203" h="49194">
                  <a:moveTo>
                    <a:pt x="798204" y="-4"/>
                  </a:moveTo>
                  <a:lnTo>
                    <a:pt x="1" y="-4"/>
                  </a:lnTo>
                  <a:lnTo>
                    <a:pt x="1" y="49191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50" name="Content Placeholder 3">
              <a:extLst>
                <a:ext uri="{FF2B5EF4-FFF2-40B4-BE49-F238E27FC236}">
                  <a16:creationId xmlns:a16="http://schemas.microsoft.com/office/drawing/2014/main" id="{28AA1F30-AD1D-4E91-8284-7890CDC05FEA}"/>
                </a:ext>
              </a:extLst>
            </p:cNvPr>
            <p:cNvSpPr/>
            <p:nvPr/>
          </p:nvSpPr>
          <p:spPr>
            <a:xfrm>
              <a:off x="162725" y="5165067"/>
              <a:ext cx="1722776" cy="617991"/>
            </a:xfrm>
            <a:custGeom>
              <a:avLst/>
              <a:gdLst>
                <a:gd name="connsiteX0" fmla="*/ 1722777 w 1722776"/>
                <a:gd name="connsiteY0" fmla="*/ -4 h 617991"/>
                <a:gd name="connsiteX1" fmla="*/ 1 w 1722776"/>
                <a:gd name="connsiteY1" fmla="*/ -4 h 617991"/>
                <a:gd name="connsiteX2" fmla="*/ 1 w 1722776"/>
                <a:gd name="connsiteY2" fmla="*/ 617988 h 61799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722776" h="617991">
                  <a:moveTo>
                    <a:pt x="1722777" y="-4"/>
                  </a:moveTo>
                  <a:lnTo>
                    <a:pt x="1" y="-4"/>
                  </a:lnTo>
                  <a:lnTo>
                    <a:pt x="1" y="617988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51" name="Content Placeholder 3">
              <a:extLst>
                <a:ext uri="{FF2B5EF4-FFF2-40B4-BE49-F238E27FC236}">
                  <a16:creationId xmlns:a16="http://schemas.microsoft.com/office/drawing/2014/main" id="{DE123206-6FA3-4AF8-B386-4A98EB64E047}"/>
                </a:ext>
              </a:extLst>
            </p:cNvPr>
            <p:cNvSpPr/>
            <p:nvPr/>
          </p:nvSpPr>
          <p:spPr>
            <a:xfrm>
              <a:off x="5012115" y="3990639"/>
              <a:ext cx="418059" cy="49188"/>
            </a:xfrm>
            <a:custGeom>
              <a:avLst/>
              <a:gdLst>
                <a:gd name="connsiteX0" fmla="*/ 418060 w 418059"/>
                <a:gd name="connsiteY0" fmla="*/ 49185 h 49188"/>
                <a:gd name="connsiteX1" fmla="*/ 1 w 418059"/>
                <a:gd name="connsiteY1" fmla="*/ 49185 h 49188"/>
                <a:gd name="connsiteX2" fmla="*/ 1 w 418059"/>
                <a:gd name="connsiteY2" fmla="*/ -4 h 4918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418059" h="49188">
                  <a:moveTo>
                    <a:pt x="418060" y="49185"/>
                  </a:moveTo>
                  <a:lnTo>
                    <a:pt x="1" y="49185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52" name="Content Placeholder 3">
              <a:extLst>
                <a:ext uri="{FF2B5EF4-FFF2-40B4-BE49-F238E27FC236}">
                  <a16:creationId xmlns:a16="http://schemas.microsoft.com/office/drawing/2014/main" id="{FCCDA867-2DED-4D44-ABC6-6A5CF413A084}"/>
                </a:ext>
              </a:extLst>
            </p:cNvPr>
            <p:cNvSpPr/>
            <p:nvPr/>
          </p:nvSpPr>
          <p:spPr>
            <a:xfrm>
              <a:off x="3582696" y="252039"/>
              <a:ext cx="346376" cy="73787"/>
            </a:xfrm>
            <a:custGeom>
              <a:avLst/>
              <a:gdLst>
                <a:gd name="connsiteX0" fmla="*/ 346377 w 346376"/>
                <a:gd name="connsiteY0" fmla="*/ -4 h 73787"/>
                <a:gd name="connsiteX1" fmla="*/ 1 w 346376"/>
                <a:gd name="connsiteY1" fmla="*/ -4 h 73787"/>
                <a:gd name="connsiteX2" fmla="*/ 1 w 346376"/>
                <a:gd name="connsiteY2" fmla="*/ 73784 h 7378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346376" h="73787">
                  <a:moveTo>
                    <a:pt x="346377" y="-4"/>
                  </a:moveTo>
                  <a:lnTo>
                    <a:pt x="1" y="-4"/>
                  </a:lnTo>
                  <a:lnTo>
                    <a:pt x="1" y="7378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53" name="Content Placeholder 3">
              <a:extLst>
                <a:ext uri="{FF2B5EF4-FFF2-40B4-BE49-F238E27FC236}">
                  <a16:creationId xmlns:a16="http://schemas.microsoft.com/office/drawing/2014/main" id="{EA32AC79-D5AE-4ECB-9E66-C33F21970A51}"/>
                </a:ext>
              </a:extLst>
            </p:cNvPr>
            <p:cNvSpPr/>
            <p:nvPr/>
          </p:nvSpPr>
          <p:spPr>
            <a:xfrm>
              <a:off x="3002058" y="1202063"/>
              <a:ext cx="114460" cy="840109"/>
            </a:xfrm>
            <a:custGeom>
              <a:avLst/>
              <a:gdLst>
                <a:gd name="connsiteX0" fmla="*/ 114461 w 114460"/>
                <a:gd name="connsiteY0" fmla="*/ -4 h 840109"/>
                <a:gd name="connsiteX1" fmla="*/ 1 w 114460"/>
                <a:gd name="connsiteY1" fmla="*/ -4 h 840109"/>
                <a:gd name="connsiteX2" fmla="*/ 1 w 114460"/>
                <a:gd name="connsiteY2" fmla="*/ 840106 h 84010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14460" h="840109">
                  <a:moveTo>
                    <a:pt x="114461" y="-4"/>
                  </a:moveTo>
                  <a:lnTo>
                    <a:pt x="1" y="-4"/>
                  </a:lnTo>
                  <a:lnTo>
                    <a:pt x="1" y="840106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54" name="Content Placeholder 3">
              <a:extLst>
                <a:ext uri="{FF2B5EF4-FFF2-40B4-BE49-F238E27FC236}">
                  <a16:creationId xmlns:a16="http://schemas.microsoft.com/office/drawing/2014/main" id="{2952C4BE-4BCC-4CE9-BA1A-9971E4C52FB6}"/>
                </a:ext>
              </a:extLst>
            </p:cNvPr>
            <p:cNvSpPr/>
            <p:nvPr/>
          </p:nvSpPr>
          <p:spPr>
            <a:xfrm>
              <a:off x="3718624" y="2059847"/>
              <a:ext cx="150324" cy="276705"/>
            </a:xfrm>
            <a:custGeom>
              <a:avLst/>
              <a:gdLst>
                <a:gd name="connsiteX0" fmla="*/ 150325 w 150324"/>
                <a:gd name="connsiteY0" fmla="*/ -4 h 276705"/>
                <a:gd name="connsiteX1" fmla="*/ 1 w 150324"/>
                <a:gd name="connsiteY1" fmla="*/ -4 h 276705"/>
                <a:gd name="connsiteX2" fmla="*/ 1 w 150324"/>
                <a:gd name="connsiteY2" fmla="*/ 276702 h 27670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50324" h="276705">
                  <a:moveTo>
                    <a:pt x="150325" y="-4"/>
                  </a:moveTo>
                  <a:lnTo>
                    <a:pt x="1" y="-4"/>
                  </a:lnTo>
                  <a:lnTo>
                    <a:pt x="1" y="276702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55" name="Content Placeholder 3">
              <a:extLst>
                <a:ext uri="{FF2B5EF4-FFF2-40B4-BE49-F238E27FC236}">
                  <a16:creationId xmlns:a16="http://schemas.microsoft.com/office/drawing/2014/main" id="{E6D9B850-45EB-47BC-8574-C954638C7BBE}"/>
                </a:ext>
              </a:extLst>
            </p:cNvPr>
            <p:cNvSpPr/>
            <p:nvPr/>
          </p:nvSpPr>
          <p:spPr>
            <a:xfrm>
              <a:off x="3028957" y="5343417"/>
              <a:ext cx="174114" cy="147578"/>
            </a:xfrm>
            <a:custGeom>
              <a:avLst/>
              <a:gdLst>
                <a:gd name="connsiteX0" fmla="*/ 174115 w 174114"/>
                <a:gd name="connsiteY0" fmla="*/ 147574 h 147578"/>
                <a:gd name="connsiteX1" fmla="*/ 1 w 174114"/>
                <a:gd name="connsiteY1" fmla="*/ 147574 h 147578"/>
                <a:gd name="connsiteX2" fmla="*/ 1 w 174114"/>
                <a:gd name="connsiteY2" fmla="*/ -4 h 14757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74114" h="147578">
                  <a:moveTo>
                    <a:pt x="174115" y="147574"/>
                  </a:moveTo>
                  <a:lnTo>
                    <a:pt x="1" y="147574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56" name="Content Placeholder 3">
              <a:extLst>
                <a:ext uri="{FF2B5EF4-FFF2-40B4-BE49-F238E27FC236}">
                  <a16:creationId xmlns:a16="http://schemas.microsoft.com/office/drawing/2014/main" id="{43326034-1C68-4650-AB1F-7F027064A94C}"/>
                </a:ext>
              </a:extLst>
            </p:cNvPr>
            <p:cNvSpPr/>
            <p:nvPr/>
          </p:nvSpPr>
          <p:spPr>
            <a:xfrm>
              <a:off x="3753083" y="1088305"/>
              <a:ext cx="1286053" cy="49194"/>
            </a:xfrm>
            <a:custGeom>
              <a:avLst/>
              <a:gdLst>
                <a:gd name="connsiteX0" fmla="*/ 1286054 w 1286053"/>
                <a:gd name="connsiteY0" fmla="*/ -4 h 49194"/>
                <a:gd name="connsiteX1" fmla="*/ 1 w 1286053"/>
                <a:gd name="connsiteY1" fmla="*/ -4 h 49194"/>
                <a:gd name="connsiteX2" fmla="*/ 1 w 1286053"/>
                <a:gd name="connsiteY2" fmla="*/ 49191 h 491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286053" h="49194">
                  <a:moveTo>
                    <a:pt x="1286054" y="-4"/>
                  </a:moveTo>
                  <a:lnTo>
                    <a:pt x="1" y="-4"/>
                  </a:lnTo>
                  <a:lnTo>
                    <a:pt x="1" y="49191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57" name="Content Placeholder 3">
              <a:extLst>
                <a:ext uri="{FF2B5EF4-FFF2-40B4-BE49-F238E27FC236}">
                  <a16:creationId xmlns:a16="http://schemas.microsoft.com/office/drawing/2014/main" id="{A2C98005-36E5-4FE9-93FE-CAD369F8A053}"/>
                </a:ext>
              </a:extLst>
            </p:cNvPr>
            <p:cNvSpPr/>
            <p:nvPr/>
          </p:nvSpPr>
          <p:spPr>
            <a:xfrm>
              <a:off x="3858163" y="1531033"/>
              <a:ext cx="1161995" cy="49194"/>
            </a:xfrm>
            <a:custGeom>
              <a:avLst/>
              <a:gdLst>
                <a:gd name="connsiteX0" fmla="*/ 1161996 w 1161995"/>
                <a:gd name="connsiteY0" fmla="*/ 49191 h 49194"/>
                <a:gd name="connsiteX1" fmla="*/ 1 w 1161995"/>
                <a:gd name="connsiteY1" fmla="*/ 49191 h 49194"/>
                <a:gd name="connsiteX2" fmla="*/ 1 w 1161995"/>
                <a:gd name="connsiteY2" fmla="*/ -4 h 491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161995" h="49194">
                  <a:moveTo>
                    <a:pt x="1161996" y="49191"/>
                  </a:moveTo>
                  <a:lnTo>
                    <a:pt x="1" y="49191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58" name="Content Placeholder 3">
              <a:extLst>
                <a:ext uri="{FF2B5EF4-FFF2-40B4-BE49-F238E27FC236}">
                  <a16:creationId xmlns:a16="http://schemas.microsoft.com/office/drawing/2014/main" id="{311C1331-1FC5-4D6E-A694-4EA826F8D0C8}"/>
                </a:ext>
              </a:extLst>
            </p:cNvPr>
            <p:cNvSpPr/>
            <p:nvPr/>
          </p:nvSpPr>
          <p:spPr>
            <a:xfrm>
              <a:off x="3969727" y="2145932"/>
              <a:ext cx="208198" cy="110682"/>
            </a:xfrm>
            <a:custGeom>
              <a:avLst/>
              <a:gdLst>
                <a:gd name="connsiteX0" fmla="*/ 208199 w 208198"/>
                <a:gd name="connsiteY0" fmla="*/ -4 h 110682"/>
                <a:gd name="connsiteX1" fmla="*/ 1 w 208198"/>
                <a:gd name="connsiteY1" fmla="*/ -4 h 110682"/>
                <a:gd name="connsiteX2" fmla="*/ 1 w 208198"/>
                <a:gd name="connsiteY2" fmla="*/ 110678 h 11068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08198" h="110682">
                  <a:moveTo>
                    <a:pt x="208199" y="-4"/>
                  </a:moveTo>
                  <a:lnTo>
                    <a:pt x="1" y="-4"/>
                  </a:lnTo>
                  <a:lnTo>
                    <a:pt x="1" y="110678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59" name="Content Placeholder 3">
              <a:extLst>
                <a:ext uri="{FF2B5EF4-FFF2-40B4-BE49-F238E27FC236}">
                  <a16:creationId xmlns:a16="http://schemas.microsoft.com/office/drawing/2014/main" id="{84CF1A70-C157-41F0-BC7F-399F620D41F6}"/>
                </a:ext>
              </a:extLst>
            </p:cNvPr>
            <p:cNvSpPr/>
            <p:nvPr/>
          </p:nvSpPr>
          <p:spPr>
            <a:xfrm>
              <a:off x="4257262" y="4011137"/>
              <a:ext cx="177079" cy="217264"/>
            </a:xfrm>
            <a:custGeom>
              <a:avLst/>
              <a:gdLst>
                <a:gd name="connsiteX0" fmla="*/ 177080 w 177079"/>
                <a:gd name="connsiteY0" fmla="*/ 217261 h 217264"/>
                <a:gd name="connsiteX1" fmla="*/ 1 w 177079"/>
                <a:gd name="connsiteY1" fmla="*/ 217261 h 217264"/>
                <a:gd name="connsiteX2" fmla="*/ 1 w 177079"/>
                <a:gd name="connsiteY2" fmla="*/ -4 h 21726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77079" h="217264">
                  <a:moveTo>
                    <a:pt x="177080" y="217261"/>
                  </a:moveTo>
                  <a:lnTo>
                    <a:pt x="1" y="217261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0" name="Content Placeholder 3">
              <a:extLst>
                <a:ext uri="{FF2B5EF4-FFF2-40B4-BE49-F238E27FC236}">
                  <a16:creationId xmlns:a16="http://schemas.microsoft.com/office/drawing/2014/main" id="{961B17BE-9C47-4F95-98D3-C4F272823CE3}"/>
                </a:ext>
              </a:extLst>
            </p:cNvPr>
            <p:cNvSpPr/>
            <p:nvPr/>
          </p:nvSpPr>
          <p:spPr>
            <a:xfrm>
              <a:off x="3169453" y="2597889"/>
              <a:ext cx="199463" cy="284387"/>
            </a:xfrm>
            <a:custGeom>
              <a:avLst/>
              <a:gdLst>
                <a:gd name="connsiteX0" fmla="*/ 199465 w 199463"/>
                <a:gd name="connsiteY0" fmla="*/ -4 h 284387"/>
                <a:gd name="connsiteX1" fmla="*/ 1 w 199463"/>
                <a:gd name="connsiteY1" fmla="*/ -4 h 284387"/>
                <a:gd name="connsiteX2" fmla="*/ 1 w 199463"/>
                <a:gd name="connsiteY2" fmla="*/ 284383 h 28438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99463" h="284387">
                  <a:moveTo>
                    <a:pt x="199465" y="-4"/>
                  </a:moveTo>
                  <a:lnTo>
                    <a:pt x="1" y="-4"/>
                  </a:lnTo>
                  <a:lnTo>
                    <a:pt x="1" y="284383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1" name="Content Placeholder 3">
              <a:extLst>
                <a:ext uri="{FF2B5EF4-FFF2-40B4-BE49-F238E27FC236}">
                  <a16:creationId xmlns:a16="http://schemas.microsoft.com/office/drawing/2014/main" id="{8D09CA8D-B5CD-4D4F-A197-CA761CB2F72C}"/>
                </a:ext>
              </a:extLst>
            </p:cNvPr>
            <p:cNvSpPr/>
            <p:nvPr/>
          </p:nvSpPr>
          <p:spPr>
            <a:xfrm>
              <a:off x="4159928" y="2613258"/>
              <a:ext cx="625896" cy="49194"/>
            </a:xfrm>
            <a:custGeom>
              <a:avLst/>
              <a:gdLst>
                <a:gd name="connsiteX0" fmla="*/ 625897 w 625896"/>
                <a:gd name="connsiteY0" fmla="*/ 49191 h 49194"/>
                <a:gd name="connsiteX1" fmla="*/ 1 w 625896"/>
                <a:gd name="connsiteY1" fmla="*/ 49191 h 49194"/>
                <a:gd name="connsiteX2" fmla="*/ 1 w 625896"/>
                <a:gd name="connsiteY2" fmla="*/ -4 h 491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625896" h="49194">
                  <a:moveTo>
                    <a:pt x="625897" y="49191"/>
                  </a:moveTo>
                  <a:lnTo>
                    <a:pt x="1" y="49191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2" name="Content Placeholder 3">
              <a:extLst>
                <a:ext uri="{FF2B5EF4-FFF2-40B4-BE49-F238E27FC236}">
                  <a16:creationId xmlns:a16="http://schemas.microsoft.com/office/drawing/2014/main" id="{24C7E819-EBBC-413B-991F-FBEEF8252A17}"/>
                </a:ext>
              </a:extLst>
            </p:cNvPr>
            <p:cNvSpPr/>
            <p:nvPr/>
          </p:nvSpPr>
          <p:spPr>
            <a:xfrm>
              <a:off x="3122654" y="4433368"/>
              <a:ext cx="1477257" cy="122980"/>
            </a:xfrm>
            <a:custGeom>
              <a:avLst/>
              <a:gdLst>
                <a:gd name="connsiteX0" fmla="*/ 1477258 w 1477257"/>
                <a:gd name="connsiteY0" fmla="*/ -4 h 122980"/>
                <a:gd name="connsiteX1" fmla="*/ 1 w 1477257"/>
                <a:gd name="connsiteY1" fmla="*/ -4 h 122980"/>
                <a:gd name="connsiteX2" fmla="*/ 1 w 1477257"/>
                <a:gd name="connsiteY2" fmla="*/ 122977 h 12298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477257" h="122980">
                  <a:moveTo>
                    <a:pt x="1477258" y="-4"/>
                  </a:moveTo>
                  <a:lnTo>
                    <a:pt x="1" y="-4"/>
                  </a:lnTo>
                  <a:lnTo>
                    <a:pt x="1" y="122977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3" name="Content Placeholder 3">
              <a:extLst>
                <a:ext uri="{FF2B5EF4-FFF2-40B4-BE49-F238E27FC236}">
                  <a16:creationId xmlns:a16="http://schemas.microsoft.com/office/drawing/2014/main" id="{F3D09E0C-CAF3-4416-9E7E-2D5851B53234}"/>
                </a:ext>
              </a:extLst>
            </p:cNvPr>
            <p:cNvSpPr/>
            <p:nvPr/>
          </p:nvSpPr>
          <p:spPr>
            <a:xfrm>
              <a:off x="4032047" y="891537"/>
              <a:ext cx="698108" cy="49188"/>
            </a:xfrm>
            <a:custGeom>
              <a:avLst/>
              <a:gdLst>
                <a:gd name="connsiteX0" fmla="*/ 698109 w 698108"/>
                <a:gd name="connsiteY0" fmla="*/ -4 h 49188"/>
                <a:gd name="connsiteX1" fmla="*/ 1 w 698108"/>
                <a:gd name="connsiteY1" fmla="*/ -4 h 49188"/>
                <a:gd name="connsiteX2" fmla="*/ 1 w 698108"/>
                <a:gd name="connsiteY2" fmla="*/ 49185 h 4918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698108" h="49188">
                  <a:moveTo>
                    <a:pt x="698109" y="-4"/>
                  </a:moveTo>
                  <a:lnTo>
                    <a:pt x="1" y="-4"/>
                  </a:lnTo>
                  <a:lnTo>
                    <a:pt x="1" y="49185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4" name="Content Placeholder 3">
              <a:extLst>
                <a:ext uri="{FF2B5EF4-FFF2-40B4-BE49-F238E27FC236}">
                  <a16:creationId xmlns:a16="http://schemas.microsoft.com/office/drawing/2014/main" id="{D60EA101-E296-442E-B2BF-E50C2AA6417F}"/>
                </a:ext>
              </a:extLst>
            </p:cNvPr>
            <p:cNvSpPr/>
            <p:nvPr/>
          </p:nvSpPr>
          <p:spPr>
            <a:xfrm>
              <a:off x="4434341" y="4228402"/>
              <a:ext cx="682198" cy="106582"/>
            </a:xfrm>
            <a:custGeom>
              <a:avLst/>
              <a:gdLst>
                <a:gd name="connsiteX0" fmla="*/ 682199 w 682198"/>
                <a:gd name="connsiteY0" fmla="*/ 106579 h 106582"/>
                <a:gd name="connsiteX1" fmla="*/ 1 w 682198"/>
                <a:gd name="connsiteY1" fmla="*/ 106579 h 106582"/>
                <a:gd name="connsiteX2" fmla="*/ 1 w 682198"/>
                <a:gd name="connsiteY2" fmla="*/ -4 h 10658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682198" h="106582">
                  <a:moveTo>
                    <a:pt x="682199" y="106579"/>
                  </a:moveTo>
                  <a:lnTo>
                    <a:pt x="1" y="106579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5" name="Content Placeholder 3">
              <a:extLst>
                <a:ext uri="{FF2B5EF4-FFF2-40B4-BE49-F238E27FC236}">
                  <a16:creationId xmlns:a16="http://schemas.microsoft.com/office/drawing/2014/main" id="{D158BA0D-CC1E-4D9F-9D89-5A15CA589961}"/>
                </a:ext>
              </a:extLst>
            </p:cNvPr>
            <p:cNvSpPr/>
            <p:nvPr/>
          </p:nvSpPr>
          <p:spPr>
            <a:xfrm>
              <a:off x="3419277" y="4679324"/>
              <a:ext cx="380907" cy="98389"/>
            </a:xfrm>
            <a:custGeom>
              <a:avLst/>
              <a:gdLst>
                <a:gd name="connsiteX0" fmla="*/ 380908 w 380907"/>
                <a:gd name="connsiteY0" fmla="*/ 98385 h 98389"/>
                <a:gd name="connsiteX1" fmla="*/ 1 w 380907"/>
                <a:gd name="connsiteY1" fmla="*/ 98385 h 98389"/>
                <a:gd name="connsiteX2" fmla="*/ 1 w 380907"/>
                <a:gd name="connsiteY2" fmla="*/ -4 h 9838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380907" h="98389">
                  <a:moveTo>
                    <a:pt x="380908" y="98385"/>
                  </a:moveTo>
                  <a:lnTo>
                    <a:pt x="1" y="98385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6" name="Content Placeholder 3">
              <a:extLst>
                <a:ext uri="{FF2B5EF4-FFF2-40B4-BE49-F238E27FC236}">
                  <a16:creationId xmlns:a16="http://schemas.microsoft.com/office/drawing/2014/main" id="{A3C620BB-1EA6-432B-BD02-4FDCEC00FAAB}"/>
                </a:ext>
              </a:extLst>
            </p:cNvPr>
            <p:cNvSpPr/>
            <p:nvPr/>
          </p:nvSpPr>
          <p:spPr>
            <a:xfrm>
              <a:off x="3800185" y="4777713"/>
              <a:ext cx="1067651" cy="49188"/>
            </a:xfrm>
            <a:custGeom>
              <a:avLst/>
              <a:gdLst>
                <a:gd name="connsiteX0" fmla="*/ 1067652 w 1067651"/>
                <a:gd name="connsiteY0" fmla="*/ 49185 h 49188"/>
                <a:gd name="connsiteX1" fmla="*/ 1 w 1067651"/>
                <a:gd name="connsiteY1" fmla="*/ 49185 h 49188"/>
                <a:gd name="connsiteX2" fmla="*/ 1 w 1067651"/>
                <a:gd name="connsiteY2" fmla="*/ -4 h 4918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067651" h="49188">
                  <a:moveTo>
                    <a:pt x="1067652" y="49185"/>
                  </a:moveTo>
                  <a:lnTo>
                    <a:pt x="1" y="49185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7" name="Content Placeholder 3">
              <a:extLst>
                <a:ext uri="{FF2B5EF4-FFF2-40B4-BE49-F238E27FC236}">
                  <a16:creationId xmlns:a16="http://schemas.microsoft.com/office/drawing/2014/main" id="{E89F8F00-F3D1-4E65-8FAE-6A714FDBDDC8}"/>
                </a:ext>
              </a:extLst>
            </p:cNvPr>
            <p:cNvSpPr/>
            <p:nvPr/>
          </p:nvSpPr>
          <p:spPr>
            <a:xfrm>
              <a:off x="3891817" y="4580946"/>
              <a:ext cx="941407" cy="49188"/>
            </a:xfrm>
            <a:custGeom>
              <a:avLst/>
              <a:gdLst>
                <a:gd name="connsiteX0" fmla="*/ 941408 w 941407"/>
                <a:gd name="connsiteY0" fmla="*/ 49185 h 49188"/>
                <a:gd name="connsiteX1" fmla="*/ 1 w 941407"/>
                <a:gd name="connsiteY1" fmla="*/ 49185 h 49188"/>
                <a:gd name="connsiteX2" fmla="*/ 1 w 941407"/>
                <a:gd name="connsiteY2" fmla="*/ -4 h 4918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941407" h="49188">
                  <a:moveTo>
                    <a:pt x="941408" y="49185"/>
                  </a:moveTo>
                  <a:lnTo>
                    <a:pt x="1" y="49185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8" name="Content Placeholder 3">
              <a:extLst>
                <a:ext uri="{FF2B5EF4-FFF2-40B4-BE49-F238E27FC236}">
                  <a16:creationId xmlns:a16="http://schemas.microsoft.com/office/drawing/2014/main" id="{FE5AC4BF-2920-4B82-98D9-726EE213361C}"/>
                </a:ext>
              </a:extLst>
            </p:cNvPr>
            <p:cNvSpPr/>
            <p:nvPr/>
          </p:nvSpPr>
          <p:spPr>
            <a:xfrm>
              <a:off x="4492197" y="1752398"/>
              <a:ext cx="295705" cy="73786"/>
            </a:xfrm>
            <a:custGeom>
              <a:avLst/>
              <a:gdLst>
                <a:gd name="connsiteX0" fmla="*/ 295706 w 295705"/>
                <a:gd name="connsiteY0" fmla="*/ 73782 h 73786"/>
                <a:gd name="connsiteX1" fmla="*/ 1 w 295705"/>
                <a:gd name="connsiteY1" fmla="*/ 73782 h 73786"/>
                <a:gd name="connsiteX2" fmla="*/ 1 w 295705"/>
                <a:gd name="connsiteY2" fmla="*/ -4 h 7378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95705" h="73786">
                  <a:moveTo>
                    <a:pt x="295706" y="73782"/>
                  </a:moveTo>
                  <a:lnTo>
                    <a:pt x="1" y="73782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9" name="Content Placeholder 3">
              <a:extLst>
                <a:ext uri="{FF2B5EF4-FFF2-40B4-BE49-F238E27FC236}">
                  <a16:creationId xmlns:a16="http://schemas.microsoft.com/office/drawing/2014/main" id="{A285CB4E-9A8D-49FA-9D46-626E1A9F55EE}"/>
                </a:ext>
              </a:extLst>
            </p:cNvPr>
            <p:cNvSpPr/>
            <p:nvPr/>
          </p:nvSpPr>
          <p:spPr>
            <a:xfrm>
              <a:off x="3148925" y="5195845"/>
              <a:ext cx="320286" cy="73786"/>
            </a:xfrm>
            <a:custGeom>
              <a:avLst/>
              <a:gdLst>
                <a:gd name="connsiteX0" fmla="*/ 320287 w 320286"/>
                <a:gd name="connsiteY0" fmla="*/ 73782 h 73786"/>
                <a:gd name="connsiteX1" fmla="*/ 1 w 320286"/>
                <a:gd name="connsiteY1" fmla="*/ 73782 h 73786"/>
                <a:gd name="connsiteX2" fmla="*/ 1 w 320286"/>
                <a:gd name="connsiteY2" fmla="*/ -4 h 7378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320286" h="73786">
                  <a:moveTo>
                    <a:pt x="320287" y="73782"/>
                  </a:moveTo>
                  <a:lnTo>
                    <a:pt x="1" y="73782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0" name="Content Placeholder 3">
              <a:extLst>
                <a:ext uri="{FF2B5EF4-FFF2-40B4-BE49-F238E27FC236}">
                  <a16:creationId xmlns:a16="http://schemas.microsoft.com/office/drawing/2014/main" id="{75861284-B272-4318-87F6-496602778DE7}"/>
                </a:ext>
              </a:extLst>
            </p:cNvPr>
            <p:cNvSpPr/>
            <p:nvPr/>
          </p:nvSpPr>
          <p:spPr>
            <a:xfrm>
              <a:off x="3800185" y="4728519"/>
              <a:ext cx="986362" cy="49194"/>
            </a:xfrm>
            <a:custGeom>
              <a:avLst/>
              <a:gdLst>
                <a:gd name="connsiteX0" fmla="*/ 986363 w 986362"/>
                <a:gd name="connsiteY0" fmla="*/ -4 h 49194"/>
                <a:gd name="connsiteX1" fmla="*/ 1 w 986362"/>
                <a:gd name="connsiteY1" fmla="*/ -4 h 49194"/>
                <a:gd name="connsiteX2" fmla="*/ 1 w 986362"/>
                <a:gd name="connsiteY2" fmla="*/ 49191 h 491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986362" h="49194">
                  <a:moveTo>
                    <a:pt x="986363" y="-4"/>
                  </a:moveTo>
                  <a:lnTo>
                    <a:pt x="1" y="-4"/>
                  </a:lnTo>
                  <a:lnTo>
                    <a:pt x="1" y="49191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1" name="Content Placeholder 3">
              <a:extLst>
                <a:ext uri="{FF2B5EF4-FFF2-40B4-BE49-F238E27FC236}">
                  <a16:creationId xmlns:a16="http://schemas.microsoft.com/office/drawing/2014/main" id="{289E5255-64F8-4F33-91B9-DF07C79435CD}"/>
                </a:ext>
              </a:extLst>
            </p:cNvPr>
            <p:cNvSpPr/>
            <p:nvPr/>
          </p:nvSpPr>
          <p:spPr>
            <a:xfrm>
              <a:off x="3520349" y="5564782"/>
              <a:ext cx="955459" cy="49194"/>
            </a:xfrm>
            <a:custGeom>
              <a:avLst/>
              <a:gdLst>
                <a:gd name="connsiteX0" fmla="*/ 955460 w 955459"/>
                <a:gd name="connsiteY0" fmla="*/ 49191 h 49194"/>
                <a:gd name="connsiteX1" fmla="*/ 1 w 955459"/>
                <a:gd name="connsiteY1" fmla="*/ 49191 h 49194"/>
                <a:gd name="connsiteX2" fmla="*/ 1 w 955459"/>
                <a:gd name="connsiteY2" fmla="*/ -4 h 491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955459" h="49194">
                  <a:moveTo>
                    <a:pt x="955460" y="49191"/>
                  </a:moveTo>
                  <a:lnTo>
                    <a:pt x="1" y="49191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2" name="Content Placeholder 3">
              <a:extLst>
                <a:ext uri="{FF2B5EF4-FFF2-40B4-BE49-F238E27FC236}">
                  <a16:creationId xmlns:a16="http://schemas.microsoft.com/office/drawing/2014/main" id="{422D7521-239C-40E0-8FA6-1FD530E035FB}"/>
                </a:ext>
              </a:extLst>
            </p:cNvPr>
            <p:cNvSpPr/>
            <p:nvPr/>
          </p:nvSpPr>
          <p:spPr>
            <a:xfrm>
              <a:off x="162725" y="5783059"/>
              <a:ext cx="1722776" cy="617991"/>
            </a:xfrm>
            <a:custGeom>
              <a:avLst/>
              <a:gdLst>
                <a:gd name="connsiteX0" fmla="*/ 1722777 w 1722776"/>
                <a:gd name="connsiteY0" fmla="*/ 617988 h 617991"/>
                <a:gd name="connsiteX1" fmla="*/ 1 w 1722776"/>
                <a:gd name="connsiteY1" fmla="*/ 617988 h 617991"/>
                <a:gd name="connsiteX2" fmla="*/ 1 w 1722776"/>
                <a:gd name="connsiteY2" fmla="*/ -4 h 61799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722776" h="617991">
                  <a:moveTo>
                    <a:pt x="1722777" y="617988"/>
                  </a:moveTo>
                  <a:lnTo>
                    <a:pt x="1" y="617988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3" name="Content Placeholder 3">
              <a:extLst>
                <a:ext uri="{FF2B5EF4-FFF2-40B4-BE49-F238E27FC236}">
                  <a16:creationId xmlns:a16="http://schemas.microsoft.com/office/drawing/2014/main" id="{AAFD4F8D-A263-4043-829B-35BFC69457E9}"/>
                </a:ext>
              </a:extLst>
            </p:cNvPr>
            <p:cNvSpPr/>
            <p:nvPr/>
          </p:nvSpPr>
          <p:spPr>
            <a:xfrm>
              <a:off x="3966076" y="743959"/>
              <a:ext cx="1166504" cy="49194"/>
            </a:xfrm>
            <a:custGeom>
              <a:avLst/>
              <a:gdLst>
                <a:gd name="connsiteX0" fmla="*/ 1166506 w 1166504"/>
                <a:gd name="connsiteY0" fmla="*/ 49191 h 49194"/>
                <a:gd name="connsiteX1" fmla="*/ 1 w 1166504"/>
                <a:gd name="connsiteY1" fmla="*/ 49191 h 49194"/>
                <a:gd name="connsiteX2" fmla="*/ 1 w 1166504"/>
                <a:gd name="connsiteY2" fmla="*/ -4 h 491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166504" h="49194">
                  <a:moveTo>
                    <a:pt x="1166506" y="49191"/>
                  </a:moveTo>
                  <a:lnTo>
                    <a:pt x="1" y="49191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4" name="Content Placeholder 3">
              <a:extLst>
                <a:ext uri="{FF2B5EF4-FFF2-40B4-BE49-F238E27FC236}">
                  <a16:creationId xmlns:a16="http://schemas.microsoft.com/office/drawing/2014/main" id="{16148572-1EEC-4AA1-9FB7-FA186B53C0EC}"/>
                </a:ext>
              </a:extLst>
            </p:cNvPr>
            <p:cNvSpPr/>
            <p:nvPr/>
          </p:nvSpPr>
          <p:spPr>
            <a:xfrm>
              <a:off x="3201160" y="3449527"/>
              <a:ext cx="1960474" cy="49188"/>
            </a:xfrm>
            <a:custGeom>
              <a:avLst/>
              <a:gdLst>
                <a:gd name="connsiteX0" fmla="*/ 1960475 w 1960474"/>
                <a:gd name="connsiteY0" fmla="*/ -4 h 49188"/>
                <a:gd name="connsiteX1" fmla="*/ 1 w 1960474"/>
                <a:gd name="connsiteY1" fmla="*/ -4 h 49188"/>
                <a:gd name="connsiteX2" fmla="*/ 1 w 1960474"/>
                <a:gd name="connsiteY2" fmla="*/ 49185 h 4918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960474" h="49188">
                  <a:moveTo>
                    <a:pt x="1960475" y="-4"/>
                  </a:moveTo>
                  <a:lnTo>
                    <a:pt x="1" y="-4"/>
                  </a:lnTo>
                  <a:lnTo>
                    <a:pt x="1" y="49185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5" name="Content Placeholder 3">
              <a:extLst>
                <a:ext uri="{FF2B5EF4-FFF2-40B4-BE49-F238E27FC236}">
                  <a16:creationId xmlns:a16="http://schemas.microsoft.com/office/drawing/2014/main" id="{7366C1FE-9974-47C1-9C4E-64065638C120}"/>
                </a:ext>
              </a:extLst>
            </p:cNvPr>
            <p:cNvSpPr/>
            <p:nvPr/>
          </p:nvSpPr>
          <p:spPr>
            <a:xfrm>
              <a:off x="3901595" y="2613258"/>
              <a:ext cx="258332" cy="5749"/>
            </a:xfrm>
            <a:custGeom>
              <a:avLst/>
              <a:gdLst>
                <a:gd name="connsiteX0" fmla="*/ 258333 w 258332"/>
                <a:gd name="connsiteY0" fmla="*/ -4 h 5749"/>
                <a:gd name="connsiteX1" fmla="*/ 1 w 258332"/>
                <a:gd name="connsiteY1" fmla="*/ -4 h 5749"/>
                <a:gd name="connsiteX2" fmla="*/ 1 w 258332"/>
                <a:gd name="connsiteY2" fmla="*/ -4 h 574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58332" h="5749">
                  <a:moveTo>
                    <a:pt x="258333" y="-4"/>
                  </a:moveTo>
                  <a:lnTo>
                    <a:pt x="1" y="-4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6" name="Content Placeholder 3">
              <a:extLst>
                <a:ext uri="{FF2B5EF4-FFF2-40B4-BE49-F238E27FC236}">
                  <a16:creationId xmlns:a16="http://schemas.microsoft.com/office/drawing/2014/main" id="{9FE9F086-82D1-4858-A630-BAE48224F028}"/>
                </a:ext>
              </a:extLst>
            </p:cNvPr>
            <p:cNvSpPr/>
            <p:nvPr/>
          </p:nvSpPr>
          <p:spPr>
            <a:xfrm>
              <a:off x="3148925" y="5122053"/>
              <a:ext cx="956336" cy="73791"/>
            </a:xfrm>
            <a:custGeom>
              <a:avLst/>
              <a:gdLst>
                <a:gd name="connsiteX0" fmla="*/ 956337 w 956336"/>
                <a:gd name="connsiteY0" fmla="*/ -4 h 73791"/>
                <a:gd name="connsiteX1" fmla="*/ 1 w 956336"/>
                <a:gd name="connsiteY1" fmla="*/ -4 h 73791"/>
                <a:gd name="connsiteX2" fmla="*/ 1 w 956336"/>
                <a:gd name="connsiteY2" fmla="*/ 73788 h 7379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956336" h="73791">
                  <a:moveTo>
                    <a:pt x="956337" y="-4"/>
                  </a:moveTo>
                  <a:lnTo>
                    <a:pt x="1" y="-4"/>
                  </a:lnTo>
                  <a:lnTo>
                    <a:pt x="1" y="73788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7" name="Content Placeholder 3">
              <a:extLst>
                <a:ext uri="{FF2B5EF4-FFF2-40B4-BE49-F238E27FC236}">
                  <a16:creationId xmlns:a16="http://schemas.microsoft.com/office/drawing/2014/main" id="{C1A51959-180D-4AF4-AEC6-14824B7EB9B7}"/>
                </a:ext>
              </a:extLst>
            </p:cNvPr>
            <p:cNvSpPr/>
            <p:nvPr/>
          </p:nvSpPr>
          <p:spPr>
            <a:xfrm>
              <a:off x="3368917" y="2336553"/>
              <a:ext cx="349707" cy="261336"/>
            </a:xfrm>
            <a:custGeom>
              <a:avLst/>
              <a:gdLst>
                <a:gd name="connsiteX0" fmla="*/ 349708 w 349707"/>
                <a:gd name="connsiteY0" fmla="*/ -4 h 261336"/>
                <a:gd name="connsiteX1" fmla="*/ 1 w 349707"/>
                <a:gd name="connsiteY1" fmla="*/ -4 h 261336"/>
                <a:gd name="connsiteX2" fmla="*/ 1 w 349707"/>
                <a:gd name="connsiteY2" fmla="*/ 261333 h 26133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349707" h="261336">
                  <a:moveTo>
                    <a:pt x="349708" y="-4"/>
                  </a:moveTo>
                  <a:lnTo>
                    <a:pt x="1" y="-4"/>
                  </a:lnTo>
                  <a:lnTo>
                    <a:pt x="1" y="261333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8" name="Content Placeholder 3">
              <a:extLst>
                <a:ext uri="{FF2B5EF4-FFF2-40B4-BE49-F238E27FC236}">
                  <a16:creationId xmlns:a16="http://schemas.microsoft.com/office/drawing/2014/main" id="{C24C4934-F01E-44EB-A4DF-252D83299300}"/>
                </a:ext>
              </a:extLst>
            </p:cNvPr>
            <p:cNvSpPr/>
            <p:nvPr/>
          </p:nvSpPr>
          <p:spPr>
            <a:xfrm>
              <a:off x="3002058" y="2042173"/>
              <a:ext cx="167395" cy="840103"/>
            </a:xfrm>
            <a:custGeom>
              <a:avLst/>
              <a:gdLst>
                <a:gd name="connsiteX0" fmla="*/ 167396 w 167395"/>
                <a:gd name="connsiteY0" fmla="*/ 840100 h 840103"/>
                <a:gd name="connsiteX1" fmla="*/ 1 w 167395"/>
                <a:gd name="connsiteY1" fmla="*/ 840100 h 840103"/>
                <a:gd name="connsiteX2" fmla="*/ 1 w 167395"/>
                <a:gd name="connsiteY2" fmla="*/ -4 h 84010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67395" h="840103">
                  <a:moveTo>
                    <a:pt x="167396" y="840100"/>
                  </a:moveTo>
                  <a:lnTo>
                    <a:pt x="1" y="840100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9" name="Content Placeholder 3">
              <a:extLst>
                <a:ext uri="{FF2B5EF4-FFF2-40B4-BE49-F238E27FC236}">
                  <a16:creationId xmlns:a16="http://schemas.microsoft.com/office/drawing/2014/main" id="{B66BC244-289E-48DC-8790-FB2734819186}"/>
                </a:ext>
              </a:extLst>
            </p:cNvPr>
            <p:cNvSpPr/>
            <p:nvPr/>
          </p:nvSpPr>
          <p:spPr>
            <a:xfrm>
              <a:off x="3028957" y="5195845"/>
              <a:ext cx="119968" cy="147572"/>
            </a:xfrm>
            <a:custGeom>
              <a:avLst/>
              <a:gdLst>
                <a:gd name="connsiteX0" fmla="*/ 119969 w 119968"/>
                <a:gd name="connsiteY0" fmla="*/ -4 h 147572"/>
                <a:gd name="connsiteX1" fmla="*/ 1 w 119968"/>
                <a:gd name="connsiteY1" fmla="*/ -4 h 147572"/>
                <a:gd name="connsiteX2" fmla="*/ 1 w 119968"/>
                <a:gd name="connsiteY2" fmla="*/ 147569 h 1475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19968" h="147572">
                  <a:moveTo>
                    <a:pt x="119969" y="-4"/>
                  </a:moveTo>
                  <a:lnTo>
                    <a:pt x="1" y="-4"/>
                  </a:lnTo>
                  <a:lnTo>
                    <a:pt x="1" y="147569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0" name="Content Placeholder 3">
              <a:extLst>
                <a:ext uri="{FF2B5EF4-FFF2-40B4-BE49-F238E27FC236}">
                  <a16:creationId xmlns:a16="http://schemas.microsoft.com/office/drawing/2014/main" id="{23A441BC-1289-4BD0-BB10-4B0B5A9618BC}"/>
                </a:ext>
              </a:extLst>
            </p:cNvPr>
            <p:cNvSpPr/>
            <p:nvPr/>
          </p:nvSpPr>
          <p:spPr>
            <a:xfrm>
              <a:off x="2785857" y="5201992"/>
              <a:ext cx="127257" cy="436582"/>
            </a:xfrm>
            <a:custGeom>
              <a:avLst/>
              <a:gdLst>
                <a:gd name="connsiteX0" fmla="*/ 127258 w 127257"/>
                <a:gd name="connsiteY0" fmla="*/ 436578 h 436582"/>
                <a:gd name="connsiteX1" fmla="*/ 1 w 127257"/>
                <a:gd name="connsiteY1" fmla="*/ 436578 h 436582"/>
                <a:gd name="connsiteX2" fmla="*/ 1 w 127257"/>
                <a:gd name="connsiteY2" fmla="*/ -4 h 43658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27257" h="436582">
                  <a:moveTo>
                    <a:pt x="127258" y="436578"/>
                  </a:moveTo>
                  <a:lnTo>
                    <a:pt x="1" y="436578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1" name="Content Placeholder 3">
              <a:extLst>
                <a:ext uri="{FF2B5EF4-FFF2-40B4-BE49-F238E27FC236}">
                  <a16:creationId xmlns:a16="http://schemas.microsoft.com/office/drawing/2014/main" id="{96502445-767D-4D0F-9E50-0DC0AEE502A5}"/>
                </a:ext>
              </a:extLst>
            </p:cNvPr>
            <p:cNvSpPr/>
            <p:nvPr/>
          </p:nvSpPr>
          <p:spPr>
            <a:xfrm>
              <a:off x="3929073" y="252039"/>
              <a:ext cx="755896" cy="49191"/>
            </a:xfrm>
            <a:custGeom>
              <a:avLst/>
              <a:gdLst>
                <a:gd name="connsiteX0" fmla="*/ 755897 w 755896"/>
                <a:gd name="connsiteY0" fmla="*/ 49188 h 49191"/>
                <a:gd name="connsiteX1" fmla="*/ 1 w 755896"/>
                <a:gd name="connsiteY1" fmla="*/ 49188 h 49191"/>
                <a:gd name="connsiteX2" fmla="*/ 1 w 755896"/>
                <a:gd name="connsiteY2" fmla="*/ -4 h 4919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755896" h="49191">
                  <a:moveTo>
                    <a:pt x="755897" y="49188"/>
                  </a:moveTo>
                  <a:lnTo>
                    <a:pt x="1" y="49188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2" name="Content Placeholder 3">
              <a:extLst>
                <a:ext uri="{FF2B5EF4-FFF2-40B4-BE49-F238E27FC236}">
                  <a16:creationId xmlns:a16="http://schemas.microsoft.com/office/drawing/2014/main" id="{9546E37D-0EA7-4E51-ADAE-D97314CDED20}"/>
                </a:ext>
              </a:extLst>
            </p:cNvPr>
            <p:cNvSpPr/>
            <p:nvPr/>
          </p:nvSpPr>
          <p:spPr>
            <a:xfrm>
              <a:off x="3704214" y="743959"/>
              <a:ext cx="261861" cy="98383"/>
            </a:xfrm>
            <a:custGeom>
              <a:avLst/>
              <a:gdLst>
                <a:gd name="connsiteX0" fmla="*/ 261862 w 261861"/>
                <a:gd name="connsiteY0" fmla="*/ -4 h 98383"/>
                <a:gd name="connsiteX1" fmla="*/ 1 w 261861"/>
                <a:gd name="connsiteY1" fmla="*/ -4 h 98383"/>
                <a:gd name="connsiteX2" fmla="*/ 1 w 261861"/>
                <a:gd name="connsiteY2" fmla="*/ 98380 h 9838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61861" h="98383">
                  <a:moveTo>
                    <a:pt x="261862" y="-4"/>
                  </a:moveTo>
                  <a:lnTo>
                    <a:pt x="1" y="-4"/>
                  </a:lnTo>
                  <a:lnTo>
                    <a:pt x="1" y="98380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3" name="Content Placeholder 3">
              <a:extLst>
                <a:ext uri="{FF2B5EF4-FFF2-40B4-BE49-F238E27FC236}">
                  <a16:creationId xmlns:a16="http://schemas.microsoft.com/office/drawing/2014/main" id="{EB920C2E-76B6-4673-8B99-AC7C3888362E}"/>
                </a:ext>
              </a:extLst>
            </p:cNvPr>
            <p:cNvSpPr/>
            <p:nvPr/>
          </p:nvSpPr>
          <p:spPr>
            <a:xfrm>
              <a:off x="2913114" y="5638574"/>
              <a:ext cx="1501585" cy="295139"/>
            </a:xfrm>
            <a:custGeom>
              <a:avLst/>
              <a:gdLst>
                <a:gd name="connsiteX0" fmla="*/ 1501586 w 1501585"/>
                <a:gd name="connsiteY0" fmla="*/ 295135 h 295139"/>
                <a:gd name="connsiteX1" fmla="*/ 1 w 1501585"/>
                <a:gd name="connsiteY1" fmla="*/ 295135 h 295139"/>
                <a:gd name="connsiteX2" fmla="*/ 1 w 1501585"/>
                <a:gd name="connsiteY2" fmla="*/ -4 h 29513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501585" h="295139">
                  <a:moveTo>
                    <a:pt x="1501586" y="295135"/>
                  </a:moveTo>
                  <a:lnTo>
                    <a:pt x="1" y="295135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4" name="Content Placeholder 3">
              <a:extLst>
                <a:ext uri="{FF2B5EF4-FFF2-40B4-BE49-F238E27FC236}">
                  <a16:creationId xmlns:a16="http://schemas.microsoft.com/office/drawing/2014/main" id="{A51974F1-C69C-4D51-B9A0-19D9F4AF6A95}"/>
                </a:ext>
              </a:extLst>
            </p:cNvPr>
            <p:cNvSpPr/>
            <p:nvPr/>
          </p:nvSpPr>
          <p:spPr>
            <a:xfrm>
              <a:off x="4278427" y="1863080"/>
              <a:ext cx="605269" cy="110682"/>
            </a:xfrm>
            <a:custGeom>
              <a:avLst/>
              <a:gdLst>
                <a:gd name="connsiteX0" fmla="*/ 605270 w 605269"/>
                <a:gd name="connsiteY0" fmla="*/ 110678 h 110682"/>
                <a:gd name="connsiteX1" fmla="*/ 1 w 605269"/>
                <a:gd name="connsiteY1" fmla="*/ 110678 h 110682"/>
                <a:gd name="connsiteX2" fmla="*/ 1 w 605269"/>
                <a:gd name="connsiteY2" fmla="*/ -4 h 11068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605269" h="110682">
                  <a:moveTo>
                    <a:pt x="605270" y="110678"/>
                  </a:moveTo>
                  <a:lnTo>
                    <a:pt x="1" y="110678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5" name="Content Placeholder 3">
              <a:extLst>
                <a:ext uri="{FF2B5EF4-FFF2-40B4-BE49-F238E27FC236}">
                  <a16:creationId xmlns:a16="http://schemas.microsoft.com/office/drawing/2014/main" id="{EFF7811E-92D8-469D-A1E6-1E4BF7688B08}"/>
                </a:ext>
              </a:extLst>
            </p:cNvPr>
            <p:cNvSpPr/>
            <p:nvPr/>
          </p:nvSpPr>
          <p:spPr>
            <a:xfrm>
              <a:off x="1885501" y="5165067"/>
              <a:ext cx="1434366" cy="1137606"/>
            </a:xfrm>
            <a:custGeom>
              <a:avLst/>
              <a:gdLst>
                <a:gd name="connsiteX0" fmla="*/ 1434367 w 1434366"/>
                <a:gd name="connsiteY0" fmla="*/ 1137602 h 1137606"/>
                <a:gd name="connsiteX1" fmla="*/ 1 w 1434366"/>
                <a:gd name="connsiteY1" fmla="*/ 1137602 h 1137606"/>
                <a:gd name="connsiteX2" fmla="*/ 1 w 1434366"/>
                <a:gd name="connsiteY2" fmla="*/ -4 h 113760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434366" h="1137606">
                  <a:moveTo>
                    <a:pt x="1434367" y="1137602"/>
                  </a:moveTo>
                  <a:lnTo>
                    <a:pt x="1" y="1137602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6" name="Content Placeholder 3">
              <a:extLst>
                <a:ext uri="{FF2B5EF4-FFF2-40B4-BE49-F238E27FC236}">
                  <a16:creationId xmlns:a16="http://schemas.microsoft.com/office/drawing/2014/main" id="{718287A3-7034-4499-AD02-1F15F2DD99AB}"/>
                </a:ext>
              </a:extLst>
            </p:cNvPr>
            <p:cNvSpPr/>
            <p:nvPr/>
          </p:nvSpPr>
          <p:spPr>
            <a:xfrm>
              <a:off x="4462587" y="3793866"/>
              <a:ext cx="594714" cy="49194"/>
            </a:xfrm>
            <a:custGeom>
              <a:avLst/>
              <a:gdLst>
                <a:gd name="connsiteX0" fmla="*/ 594715 w 594714"/>
                <a:gd name="connsiteY0" fmla="*/ 49191 h 49194"/>
                <a:gd name="connsiteX1" fmla="*/ 1 w 594714"/>
                <a:gd name="connsiteY1" fmla="*/ 49191 h 49194"/>
                <a:gd name="connsiteX2" fmla="*/ 1 w 594714"/>
                <a:gd name="connsiteY2" fmla="*/ -4 h 491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594714" h="49194">
                  <a:moveTo>
                    <a:pt x="594715" y="49191"/>
                  </a:moveTo>
                  <a:lnTo>
                    <a:pt x="1" y="49191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7" name="Content Placeholder 3">
              <a:extLst>
                <a:ext uri="{FF2B5EF4-FFF2-40B4-BE49-F238E27FC236}">
                  <a16:creationId xmlns:a16="http://schemas.microsoft.com/office/drawing/2014/main" id="{1E65771D-2AC8-4AC7-B356-C9DF145AB1E9}"/>
                </a:ext>
              </a:extLst>
            </p:cNvPr>
            <p:cNvSpPr/>
            <p:nvPr/>
          </p:nvSpPr>
          <p:spPr>
            <a:xfrm>
              <a:off x="4177925" y="2145932"/>
              <a:ext cx="395606" cy="73792"/>
            </a:xfrm>
            <a:custGeom>
              <a:avLst/>
              <a:gdLst>
                <a:gd name="connsiteX0" fmla="*/ 395607 w 395606"/>
                <a:gd name="connsiteY0" fmla="*/ 73788 h 73792"/>
                <a:gd name="connsiteX1" fmla="*/ 1 w 395606"/>
                <a:gd name="connsiteY1" fmla="*/ 73788 h 73792"/>
                <a:gd name="connsiteX2" fmla="*/ 1 w 395606"/>
                <a:gd name="connsiteY2" fmla="*/ -4 h 7379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395606" h="73792">
                  <a:moveTo>
                    <a:pt x="395607" y="73788"/>
                  </a:moveTo>
                  <a:lnTo>
                    <a:pt x="1" y="73788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8" name="Content Placeholder 3">
              <a:extLst>
                <a:ext uri="{FF2B5EF4-FFF2-40B4-BE49-F238E27FC236}">
                  <a16:creationId xmlns:a16="http://schemas.microsoft.com/office/drawing/2014/main" id="{C7AE3F9B-4620-4EDD-9DD1-BB60B42EBB33}"/>
                </a:ext>
              </a:extLst>
            </p:cNvPr>
            <p:cNvSpPr/>
            <p:nvPr/>
          </p:nvSpPr>
          <p:spPr>
            <a:xfrm>
              <a:off x="3022206" y="3498716"/>
              <a:ext cx="178953" cy="164999"/>
            </a:xfrm>
            <a:custGeom>
              <a:avLst/>
              <a:gdLst>
                <a:gd name="connsiteX0" fmla="*/ 178954 w 178953"/>
                <a:gd name="connsiteY0" fmla="*/ -4 h 164999"/>
                <a:gd name="connsiteX1" fmla="*/ 1 w 178953"/>
                <a:gd name="connsiteY1" fmla="*/ -4 h 164999"/>
                <a:gd name="connsiteX2" fmla="*/ 1 w 178953"/>
                <a:gd name="connsiteY2" fmla="*/ 164996 h 1649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78953" h="164999">
                  <a:moveTo>
                    <a:pt x="178954" y="-4"/>
                  </a:moveTo>
                  <a:lnTo>
                    <a:pt x="1" y="-4"/>
                  </a:lnTo>
                  <a:lnTo>
                    <a:pt x="1" y="164996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9" name="Content Placeholder 3">
              <a:extLst>
                <a:ext uri="{FF2B5EF4-FFF2-40B4-BE49-F238E27FC236}">
                  <a16:creationId xmlns:a16="http://schemas.microsoft.com/office/drawing/2014/main" id="{5385599D-CD4D-4E45-A081-D9A54635AB40}"/>
                </a:ext>
              </a:extLst>
            </p:cNvPr>
            <p:cNvSpPr/>
            <p:nvPr/>
          </p:nvSpPr>
          <p:spPr>
            <a:xfrm>
              <a:off x="4883154" y="4121819"/>
              <a:ext cx="351455" cy="114781"/>
            </a:xfrm>
            <a:custGeom>
              <a:avLst/>
              <a:gdLst>
                <a:gd name="connsiteX0" fmla="*/ 351456 w 351455"/>
                <a:gd name="connsiteY0" fmla="*/ 114778 h 114781"/>
                <a:gd name="connsiteX1" fmla="*/ 1 w 351455"/>
                <a:gd name="connsiteY1" fmla="*/ 114778 h 114781"/>
                <a:gd name="connsiteX2" fmla="*/ 1 w 351455"/>
                <a:gd name="connsiteY2" fmla="*/ -4 h 11478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351455" h="114781">
                  <a:moveTo>
                    <a:pt x="351456" y="114778"/>
                  </a:moveTo>
                  <a:lnTo>
                    <a:pt x="1" y="114778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0" name="Content Placeholder 3">
              <a:extLst>
                <a:ext uri="{FF2B5EF4-FFF2-40B4-BE49-F238E27FC236}">
                  <a16:creationId xmlns:a16="http://schemas.microsoft.com/office/drawing/2014/main" id="{50CF1CF8-56AD-420C-98FA-F8D2D1301F5F}"/>
                </a:ext>
              </a:extLst>
            </p:cNvPr>
            <p:cNvSpPr/>
            <p:nvPr/>
          </p:nvSpPr>
          <p:spPr>
            <a:xfrm>
              <a:off x="3469212" y="5269631"/>
              <a:ext cx="1350818" cy="49194"/>
            </a:xfrm>
            <a:custGeom>
              <a:avLst/>
              <a:gdLst>
                <a:gd name="connsiteX0" fmla="*/ 1350819 w 1350818"/>
                <a:gd name="connsiteY0" fmla="*/ 49191 h 49194"/>
                <a:gd name="connsiteX1" fmla="*/ 1 w 1350818"/>
                <a:gd name="connsiteY1" fmla="*/ 49191 h 49194"/>
                <a:gd name="connsiteX2" fmla="*/ 1 w 1350818"/>
                <a:gd name="connsiteY2" fmla="*/ -4 h 491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350818" h="49194">
                  <a:moveTo>
                    <a:pt x="1350819" y="49191"/>
                  </a:moveTo>
                  <a:lnTo>
                    <a:pt x="1" y="49191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1" name="Content Placeholder 3">
              <a:extLst>
                <a:ext uri="{FF2B5EF4-FFF2-40B4-BE49-F238E27FC236}">
                  <a16:creationId xmlns:a16="http://schemas.microsoft.com/office/drawing/2014/main" id="{23F156B5-741D-4294-90A4-CD5554123450}"/>
                </a:ext>
              </a:extLst>
            </p:cNvPr>
            <p:cNvSpPr/>
            <p:nvPr/>
          </p:nvSpPr>
          <p:spPr>
            <a:xfrm>
              <a:off x="4376151" y="497999"/>
              <a:ext cx="243746" cy="49192"/>
            </a:xfrm>
            <a:custGeom>
              <a:avLst/>
              <a:gdLst>
                <a:gd name="connsiteX0" fmla="*/ 243747 w 243746"/>
                <a:gd name="connsiteY0" fmla="*/ -4 h 49192"/>
                <a:gd name="connsiteX1" fmla="*/ 1 w 243746"/>
                <a:gd name="connsiteY1" fmla="*/ -4 h 49192"/>
                <a:gd name="connsiteX2" fmla="*/ 1 w 243746"/>
                <a:gd name="connsiteY2" fmla="*/ 49188 h 4919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43746" h="49192">
                  <a:moveTo>
                    <a:pt x="243747" y="-4"/>
                  </a:moveTo>
                  <a:lnTo>
                    <a:pt x="1" y="-4"/>
                  </a:lnTo>
                  <a:lnTo>
                    <a:pt x="1" y="49188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2" name="Content Placeholder 3">
              <a:extLst>
                <a:ext uri="{FF2B5EF4-FFF2-40B4-BE49-F238E27FC236}">
                  <a16:creationId xmlns:a16="http://schemas.microsoft.com/office/drawing/2014/main" id="{AB268EE0-E2D0-4C49-8D9A-424DFED5FBD5}"/>
                </a:ext>
              </a:extLst>
            </p:cNvPr>
            <p:cNvSpPr/>
            <p:nvPr/>
          </p:nvSpPr>
          <p:spPr>
            <a:xfrm>
              <a:off x="3966076" y="694768"/>
              <a:ext cx="1063842" cy="49191"/>
            </a:xfrm>
            <a:custGeom>
              <a:avLst/>
              <a:gdLst>
                <a:gd name="connsiteX0" fmla="*/ 1063843 w 1063842"/>
                <a:gd name="connsiteY0" fmla="*/ -4 h 49191"/>
                <a:gd name="connsiteX1" fmla="*/ 1 w 1063842"/>
                <a:gd name="connsiteY1" fmla="*/ -4 h 49191"/>
                <a:gd name="connsiteX2" fmla="*/ 1 w 1063842"/>
                <a:gd name="connsiteY2" fmla="*/ 49187 h 4919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063842" h="49191">
                  <a:moveTo>
                    <a:pt x="1063843" y="-4"/>
                  </a:moveTo>
                  <a:lnTo>
                    <a:pt x="1" y="-4"/>
                  </a:lnTo>
                  <a:lnTo>
                    <a:pt x="1" y="49187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3" name="Content Placeholder 3">
              <a:extLst>
                <a:ext uri="{FF2B5EF4-FFF2-40B4-BE49-F238E27FC236}">
                  <a16:creationId xmlns:a16="http://schemas.microsoft.com/office/drawing/2014/main" id="{E76418D3-C4E8-4BEC-AD9C-9A12DFDE5EC8}"/>
                </a:ext>
              </a:extLst>
            </p:cNvPr>
            <p:cNvSpPr/>
            <p:nvPr/>
          </p:nvSpPr>
          <p:spPr>
            <a:xfrm>
              <a:off x="3868949" y="2059847"/>
              <a:ext cx="100777" cy="196767"/>
            </a:xfrm>
            <a:custGeom>
              <a:avLst/>
              <a:gdLst>
                <a:gd name="connsiteX0" fmla="*/ 100778 w 100777"/>
                <a:gd name="connsiteY0" fmla="*/ 196763 h 196767"/>
                <a:gd name="connsiteX1" fmla="*/ 1 w 100777"/>
                <a:gd name="connsiteY1" fmla="*/ 196763 h 196767"/>
                <a:gd name="connsiteX2" fmla="*/ 1 w 100777"/>
                <a:gd name="connsiteY2" fmla="*/ -4 h 19676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00777" h="196767">
                  <a:moveTo>
                    <a:pt x="100778" y="196763"/>
                  </a:moveTo>
                  <a:lnTo>
                    <a:pt x="1" y="196763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4" name="Content Placeholder 3">
              <a:extLst>
                <a:ext uri="{FF2B5EF4-FFF2-40B4-BE49-F238E27FC236}">
                  <a16:creationId xmlns:a16="http://schemas.microsoft.com/office/drawing/2014/main" id="{B05C771A-DDB4-403A-8F5E-40EF3399C8C4}"/>
                </a:ext>
              </a:extLst>
            </p:cNvPr>
            <p:cNvSpPr/>
            <p:nvPr/>
          </p:nvSpPr>
          <p:spPr>
            <a:xfrm>
              <a:off x="5012115" y="3941445"/>
              <a:ext cx="389953" cy="49194"/>
            </a:xfrm>
            <a:custGeom>
              <a:avLst/>
              <a:gdLst>
                <a:gd name="connsiteX0" fmla="*/ 389954 w 389953"/>
                <a:gd name="connsiteY0" fmla="*/ -4 h 49194"/>
                <a:gd name="connsiteX1" fmla="*/ 1 w 389953"/>
                <a:gd name="connsiteY1" fmla="*/ -4 h 49194"/>
                <a:gd name="connsiteX2" fmla="*/ 1 w 389953"/>
                <a:gd name="connsiteY2" fmla="*/ 49191 h 491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389953" h="49194">
                  <a:moveTo>
                    <a:pt x="389954" y="-4"/>
                  </a:moveTo>
                  <a:lnTo>
                    <a:pt x="1" y="-4"/>
                  </a:lnTo>
                  <a:lnTo>
                    <a:pt x="1" y="49191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5" name="Content Placeholder 3">
              <a:extLst>
                <a:ext uri="{FF2B5EF4-FFF2-40B4-BE49-F238E27FC236}">
                  <a16:creationId xmlns:a16="http://schemas.microsoft.com/office/drawing/2014/main" id="{2D349D00-A6AA-4205-903A-5A14B17F0E4E}"/>
                </a:ext>
              </a:extLst>
            </p:cNvPr>
            <p:cNvSpPr/>
            <p:nvPr/>
          </p:nvSpPr>
          <p:spPr>
            <a:xfrm>
              <a:off x="3368917" y="2597889"/>
              <a:ext cx="1995240" cy="261330"/>
            </a:xfrm>
            <a:custGeom>
              <a:avLst/>
              <a:gdLst>
                <a:gd name="connsiteX0" fmla="*/ 1995241 w 1995240"/>
                <a:gd name="connsiteY0" fmla="*/ 261327 h 261330"/>
                <a:gd name="connsiteX1" fmla="*/ 1 w 1995240"/>
                <a:gd name="connsiteY1" fmla="*/ 261327 h 261330"/>
                <a:gd name="connsiteX2" fmla="*/ 1 w 1995240"/>
                <a:gd name="connsiteY2" fmla="*/ -4 h 26133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995240" h="261330">
                  <a:moveTo>
                    <a:pt x="1995241" y="261327"/>
                  </a:moveTo>
                  <a:lnTo>
                    <a:pt x="1" y="261327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6" name="Content Placeholder 3">
              <a:extLst>
                <a:ext uri="{FF2B5EF4-FFF2-40B4-BE49-F238E27FC236}">
                  <a16:creationId xmlns:a16="http://schemas.microsoft.com/office/drawing/2014/main" id="{A94905C8-CE33-4BD3-BCAC-08D0D8E66411}"/>
                </a:ext>
              </a:extLst>
            </p:cNvPr>
            <p:cNvSpPr/>
            <p:nvPr/>
          </p:nvSpPr>
          <p:spPr>
            <a:xfrm>
              <a:off x="4787903" y="1776995"/>
              <a:ext cx="598622" cy="49188"/>
            </a:xfrm>
            <a:custGeom>
              <a:avLst/>
              <a:gdLst>
                <a:gd name="connsiteX0" fmla="*/ 598623 w 598622"/>
                <a:gd name="connsiteY0" fmla="*/ -4 h 49188"/>
                <a:gd name="connsiteX1" fmla="*/ 1 w 598622"/>
                <a:gd name="connsiteY1" fmla="*/ -4 h 49188"/>
                <a:gd name="connsiteX2" fmla="*/ 1 w 598622"/>
                <a:gd name="connsiteY2" fmla="*/ 49185 h 4918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598622" h="49188">
                  <a:moveTo>
                    <a:pt x="598623" y="-4"/>
                  </a:moveTo>
                  <a:lnTo>
                    <a:pt x="1" y="-4"/>
                  </a:lnTo>
                  <a:lnTo>
                    <a:pt x="1" y="49185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7" name="Content Placeholder 3">
              <a:extLst>
                <a:ext uri="{FF2B5EF4-FFF2-40B4-BE49-F238E27FC236}">
                  <a16:creationId xmlns:a16="http://schemas.microsoft.com/office/drawing/2014/main" id="{52D9AE67-8AED-4F04-92AB-53CA57941D57}"/>
                </a:ext>
              </a:extLst>
            </p:cNvPr>
            <p:cNvSpPr/>
            <p:nvPr/>
          </p:nvSpPr>
          <p:spPr>
            <a:xfrm>
              <a:off x="2913814" y="2852941"/>
              <a:ext cx="108392" cy="810774"/>
            </a:xfrm>
            <a:custGeom>
              <a:avLst/>
              <a:gdLst>
                <a:gd name="connsiteX0" fmla="*/ 108393 w 108392"/>
                <a:gd name="connsiteY0" fmla="*/ 810771 h 810774"/>
                <a:gd name="connsiteX1" fmla="*/ 1 w 108392"/>
                <a:gd name="connsiteY1" fmla="*/ 810771 h 810774"/>
                <a:gd name="connsiteX2" fmla="*/ 1 w 108392"/>
                <a:gd name="connsiteY2" fmla="*/ -4 h 81077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08392" h="810774">
                  <a:moveTo>
                    <a:pt x="108393" y="810771"/>
                  </a:moveTo>
                  <a:lnTo>
                    <a:pt x="1" y="810771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8" name="Content Placeholder 3">
              <a:extLst>
                <a:ext uri="{FF2B5EF4-FFF2-40B4-BE49-F238E27FC236}">
                  <a16:creationId xmlns:a16="http://schemas.microsoft.com/office/drawing/2014/main" id="{EF05D9EC-7315-479A-8733-B8CFAFD08E32}"/>
                </a:ext>
              </a:extLst>
            </p:cNvPr>
            <p:cNvSpPr/>
            <p:nvPr/>
          </p:nvSpPr>
          <p:spPr>
            <a:xfrm>
              <a:off x="107641" y="5783059"/>
              <a:ext cx="55083" cy="5749"/>
            </a:xfrm>
            <a:custGeom>
              <a:avLst/>
              <a:gdLst>
                <a:gd name="connsiteX0" fmla="*/ 1 w 55083"/>
                <a:gd name="connsiteY0" fmla="*/ -4 h 5749"/>
                <a:gd name="connsiteX1" fmla="*/ 55084 w 55083"/>
                <a:gd name="connsiteY1" fmla="*/ -4 h 574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5083" h="5749">
                  <a:moveTo>
                    <a:pt x="1" y="-4"/>
                  </a:moveTo>
                  <a:lnTo>
                    <a:pt x="55084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9" name="Content Placeholder 3">
              <a:extLst>
                <a:ext uri="{FF2B5EF4-FFF2-40B4-BE49-F238E27FC236}">
                  <a16:creationId xmlns:a16="http://schemas.microsoft.com/office/drawing/2014/main" id="{765BD881-6AD4-4F1B-A955-72DCD3AB0171}"/>
                </a:ext>
              </a:extLst>
            </p:cNvPr>
            <p:cNvSpPr/>
            <p:nvPr/>
          </p:nvSpPr>
          <p:spPr>
            <a:xfrm>
              <a:off x="4731104" y="6007539"/>
              <a:ext cx="258463" cy="98378"/>
            </a:xfrm>
            <a:custGeom>
              <a:avLst/>
              <a:gdLst>
                <a:gd name="connsiteX0" fmla="*/ 258464 w 258463"/>
                <a:gd name="connsiteY0" fmla="*/ -4 h 98378"/>
                <a:gd name="connsiteX1" fmla="*/ 1 w 258463"/>
                <a:gd name="connsiteY1" fmla="*/ -4 h 98378"/>
                <a:gd name="connsiteX2" fmla="*/ 1 w 258463"/>
                <a:gd name="connsiteY2" fmla="*/ 98374 h 9837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58463" h="98378">
                  <a:moveTo>
                    <a:pt x="258464" y="-4"/>
                  </a:moveTo>
                  <a:lnTo>
                    <a:pt x="1" y="-4"/>
                  </a:lnTo>
                  <a:lnTo>
                    <a:pt x="1" y="9837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00" name="Content Placeholder 3">
              <a:extLst>
                <a:ext uri="{FF2B5EF4-FFF2-40B4-BE49-F238E27FC236}">
                  <a16:creationId xmlns:a16="http://schemas.microsoft.com/office/drawing/2014/main" id="{27A579B2-D463-4F1C-82C0-FDFB3203D733}"/>
                </a:ext>
              </a:extLst>
            </p:cNvPr>
            <p:cNvSpPr/>
            <p:nvPr/>
          </p:nvSpPr>
          <p:spPr>
            <a:xfrm>
              <a:off x="4492197" y="1678612"/>
              <a:ext cx="377401" cy="73786"/>
            </a:xfrm>
            <a:custGeom>
              <a:avLst/>
              <a:gdLst>
                <a:gd name="connsiteX0" fmla="*/ 377402 w 377401"/>
                <a:gd name="connsiteY0" fmla="*/ -4 h 73786"/>
                <a:gd name="connsiteX1" fmla="*/ 1 w 377401"/>
                <a:gd name="connsiteY1" fmla="*/ -4 h 73786"/>
                <a:gd name="connsiteX2" fmla="*/ 1 w 377401"/>
                <a:gd name="connsiteY2" fmla="*/ 73782 h 7378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377401" h="73786">
                  <a:moveTo>
                    <a:pt x="377402" y="-4"/>
                  </a:moveTo>
                  <a:lnTo>
                    <a:pt x="1" y="-4"/>
                  </a:lnTo>
                  <a:lnTo>
                    <a:pt x="1" y="73782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01" name="Content Placeholder 3">
              <a:extLst>
                <a:ext uri="{FF2B5EF4-FFF2-40B4-BE49-F238E27FC236}">
                  <a16:creationId xmlns:a16="http://schemas.microsoft.com/office/drawing/2014/main" id="{EFC5490B-595F-4D10-A474-229C3E29D5E5}"/>
                </a:ext>
              </a:extLst>
            </p:cNvPr>
            <p:cNvSpPr/>
            <p:nvPr/>
          </p:nvSpPr>
          <p:spPr>
            <a:xfrm>
              <a:off x="4751076" y="3252760"/>
              <a:ext cx="716919" cy="49188"/>
            </a:xfrm>
            <a:custGeom>
              <a:avLst/>
              <a:gdLst>
                <a:gd name="connsiteX0" fmla="*/ 716920 w 716919"/>
                <a:gd name="connsiteY0" fmla="*/ -4 h 49188"/>
                <a:gd name="connsiteX1" fmla="*/ 1 w 716919"/>
                <a:gd name="connsiteY1" fmla="*/ -4 h 49188"/>
                <a:gd name="connsiteX2" fmla="*/ 1 w 716919"/>
                <a:gd name="connsiteY2" fmla="*/ 49185 h 4918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716919" h="49188">
                  <a:moveTo>
                    <a:pt x="716920" y="-4"/>
                  </a:moveTo>
                  <a:lnTo>
                    <a:pt x="1" y="-4"/>
                  </a:lnTo>
                  <a:lnTo>
                    <a:pt x="1" y="49185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02" name="Content Placeholder 3">
              <a:extLst>
                <a:ext uri="{FF2B5EF4-FFF2-40B4-BE49-F238E27FC236}">
                  <a16:creationId xmlns:a16="http://schemas.microsoft.com/office/drawing/2014/main" id="{6959825B-12D5-4A51-8E48-36AA65375142}"/>
                </a:ext>
              </a:extLst>
            </p:cNvPr>
            <p:cNvSpPr/>
            <p:nvPr/>
          </p:nvSpPr>
          <p:spPr>
            <a:xfrm>
              <a:off x="3407506" y="1235883"/>
              <a:ext cx="599417" cy="98383"/>
            </a:xfrm>
            <a:custGeom>
              <a:avLst/>
              <a:gdLst>
                <a:gd name="connsiteX0" fmla="*/ 599418 w 599417"/>
                <a:gd name="connsiteY0" fmla="*/ 98380 h 98383"/>
                <a:gd name="connsiteX1" fmla="*/ 1 w 599417"/>
                <a:gd name="connsiteY1" fmla="*/ 98380 h 98383"/>
                <a:gd name="connsiteX2" fmla="*/ 1 w 599417"/>
                <a:gd name="connsiteY2" fmla="*/ -4 h 9838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599417" h="98383">
                  <a:moveTo>
                    <a:pt x="599418" y="98380"/>
                  </a:moveTo>
                  <a:lnTo>
                    <a:pt x="1" y="98380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03" name="Content Placeholder 3">
              <a:extLst>
                <a:ext uri="{FF2B5EF4-FFF2-40B4-BE49-F238E27FC236}">
                  <a16:creationId xmlns:a16="http://schemas.microsoft.com/office/drawing/2014/main" id="{F4458225-8315-4B6A-998F-16968CC74B39}"/>
                </a:ext>
              </a:extLst>
            </p:cNvPr>
            <p:cNvSpPr/>
            <p:nvPr/>
          </p:nvSpPr>
          <p:spPr>
            <a:xfrm>
              <a:off x="4493033" y="3105182"/>
              <a:ext cx="673752" cy="49188"/>
            </a:xfrm>
            <a:custGeom>
              <a:avLst/>
              <a:gdLst>
                <a:gd name="connsiteX0" fmla="*/ 673753 w 673752"/>
                <a:gd name="connsiteY0" fmla="*/ 49185 h 49188"/>
                <a:gd name="connsiteX1" fmla="*/ 1 w 673752"/>
                <a:gd name="connsiteY1" fmla="*/ 49185 h 49188"/>
                <a:gd name="connsiteX2" fmla="*/ 1 w 673752"/>
                <a:gd name="connsiteY2" fmla="*/ -4 h 4918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673752" h="49188">
                  <a:moveTo>
                    <a:pt x="673753" y="49185"/>
                  </a:moveTo>
                  <a:lnTo>
                    <a:pt x="1" y="49185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04" name="Content Placeholder 3">
              <a:extLst>
                <a:ext uri="{FF2B5EF4-FFF2-40B4-BE49-F238E27FC236}">
                  <a16:creationId xmlns:a16="http://schemas.microsoft.com/office/drawing/2014/main" id="{096E4D3C-C556-43CF-BD3A-ECBBF5859C4C}"/>
                </a:ext>
              </a:extLst>
            </p:cNvPr>
            <p:cNvSpPr/>
            <p:nvPr/>
          </p:nvSpPr>
          <p:spPr>
            <a:xfrm>
              <a:off x="4032047" y="940726"/>
              <a:ext cx="758928" cy="49194"/>
            </a:xfrm>
            <a:custGeom>
              <a:avLst/>
              <a:gdLst>
                <a:gd name="connsiteX0" fmla="*/ 758929 w 758928"/>
                <a:gd name="connsiteY0" fmla="*/ 49191 h 49194"/>
                <a:gd name="connsiteX1" fmla="*/ 1 w 758928"/>
                <a:gd name="connsiteY1" fmla="*/ 49191 h 49194"/>
                <a:gd name="connsiteX2" fmla="*/ 1 w 758928"/>
                <a:gd name="connsiteY2" fmla="*/ -4 h 491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758928" h="49194">
                  <a:moveTo>
                    <a:pt x="758929" y="49191"/>
                  </a:moveTo>
                  <a:lnTo>
                    <a:pt x="1" y="49191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05" name="Content Placeholder 3">
              <a:extLst>
                <a:ext uri="{FF2B5EF4-FFF2-40B4-BE49-F238E27FC236}">
                  <a16:creationId xmlns:a16="http://schemas.microsoft.com/office/drawing/2014/main" id="{46EA407E-E0FD-4309-A29B-6838028AF3E1}"/>
                </a:ext>
              </a:extLst>
            </p:cNvPr>
            <p:cNvSpPr/>
            <p:nvPr/>
          </p:nvSpPr>
          <p:spPr>
            <a:xfrm>
              <a:off x="4883154" y="3990639"/>
              <a:ext cx="128960" cy="131179"/>
            </a:xfrm>
            <a:custGeom>
              <a:avLst/>
              <a:gdLst>
                <a:gd name="connsiteX0" fmla="*/ 128961 w 128960"/>
                <a:gd name="connsiteY0" fmla="*/ -4 h 131179"/>
                <a:gd name="connsiteX1" fmla="*/ 1 w 128960"/>
                <a:gd name="connsiteY1" fmla="*/ -4 h 131179"/>
                <a:gd name="connsiteX2" fmla="*/ 1 w 128960"/>
                <a:gd name="connsiteY2" fmla="*/ 131176 h 13117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28960" h="131179">
                  <a:moveTo>
                    <a:pt x="128961" y="-4"/>
                  </a:moveTo>
                  <a:lnTo>
                    <a:pt x="1" y="-4"/>
                  </a:lnTo>
                  <a:lnTo>
                    <a:pt x="1" y="131176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06" name="Content Placeholder 3">
              <a:extLst>
                <a:ext uri="{FF2B5EF4-FFF2-40B4-BE49-F238E27FC236}">
                  <a16:creationId xmlns:a16="http://schemas.microsoft.com/office/drawing/2014/main" id="{19595329-C1CA-467E-8E96-6524C43C206C}"/>
                </a:ext>
              </a:extLst>
            </p:cNvPr>
            <p:cNvSpPr/>
            <p:nvPr/>
          </p:nvSpPr>
          <p:spPr>
            <a:xfrm>
              <a:off x="3901595" y="2465686"/>
              <a:ext cx="1145629" cy="147572"/>
            </a:xfrm>
            <a:custGeom>
              <a:avLst/>
              <a:gdLst>
                <a:gd name="connsiteX0" fmla="*/ 1145630 w 1145629"/>
                <a:gd name="connsiteY0" fmla="*/ -4 h 147572"/>
                <a:gd name="connsiteX1" fmla="*/ 1 w 1145629"/>
                <a:gd name="connsiteY1" fmla="*/ -4 h 147572"/>
                <a:gd name="connsiteX2" fmla="*/ 1 w 1145629"/>
                <a:gd name="connsiteY2" fmla="*/ 147568 h 1475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145629" h="147572">
                  <a:moveTo>
                    <a:pt x="1145630" y="-4"/>
                  </a:moveTo>
                  <a:lnTo>
                    <a:pt x="1" y="-4"/>
                  </a:lnTo>
                  <a:lnTo>
                    <a:pt x="1" y="147568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07" name="Content Placeholder 3">
              <a:extLst>
                <a:ext uri="{FF2B5EF4-FFF2-40B4-BE49-F238E27FC236}">
                  <a16:creationId xmlns:a16="http://schemas.microsoft.com/office/drawing/2014/main" id="{41951FC0-24C9-442E-90D6-982C63E4CFBB}"/>
                </a:ext>
              </a:extLst>
            </p:cNvPr>
            <p:cNvSpPr/>
            <p:nvPr/>
          </p:nvSpPr>
          <p:spPr>
            <a:xfrm>
              <a:off x="3169453" y="2882276"/>
              <a:ext cx="804317" cy="284392"/>
            </a:xfrm>
            <a:custGeom>
              <a:avLst/>
              <a:gdLst>
                <a:gd name="connsiteX0" fmla="*/ 804318 w 804317"/>
                <a:gd name="connsiteY0" fmla="*/ 284389 h 284392"/>
                <a:gd name="connsiteX1" fmla="*/ 1 w 804317"/>
                <a:gd name="connsiteY1" fmla="*/ 284389 h 284392"/>
                <a:gd name="connsiteX2" fmla="*/ 1 w 804317"/>
                <a:gd name="connsiteY2" fmla="*/ -4 h 28439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804317" h="284392">
                  <a:moveTo>
                    <a:pt x="804318" y="284389"/>
                  </a:moveTo>
                  <a:lnTo>
                    <a:pt x="1" y="284389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08" name="Content Placeholder 3">
              <a:extLst>
                <a:ext uri="{FF2B5EF4-FFF2-40B4-BE49-F238E27FC236}">
                  <a16:creationId xmlns:a16="http://schemas.microsoft.com/office/drawing/2014/main" id="{CA0043D0-E3BA-4E85-A7CA-59F8C876F76B}"/>
                </a:ext>
              </a:extLst>
            </p:cNvPr>
            <p:cNvSpPr/>
            <p:nvPr/>
          </p:nvSpPr>
          <p:spPr>
            <a:xfrm>
              <a:off x="4414699" y="5761555"/>
              <a:ext cx="222689" cy="172158"/>
            </a:xfrm>
            <a:custGeom>
              <a:avLst/>
              <a:gdLst>
                <a:gd name="connsiteX0" fmla="*/ 222690 w 222689"/>
                <a:gd name="connsiteY0" fmla="*/ -4 h 172158"/>
                <a:gd name="connsiteX1" fmla="*/ 1 w 222689"/>
                <a:gd name="connsiteY1" fmla="*/ -4 h 172158"/>
                <a:gd name="connsiteX2" fmla="*/ 1 w 222689"/>
                <a:gd name="connsiteY2" fmla="*/ 172154 h 17215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22689" h="172158">
                  <a:moveTo>
                    <a:pt x="222690" y="-4"/>
                  </a:moveTo>
                  <a:lnTo>
                    <a:pt x="1" y="-4"/>
                  </a:lnTo>
                  <a:lnTo>
                    <a:pt x="1" y="17215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09" name="Content Placeholder 3">
              <a:extLst>
                <a:ext uri="{FF2B5EF4-FFF2-40B4-BE49-F238E27FC236}">
                  <a16:creationId xmlns:a16="http://schemas.microsoft.com/office/drawing/2014/main" id="{E7D68B96-900D-42BF-BBC4-0223B0D36963}"/>
                </a:ext>
              </a:extLst>
            </p:cNvPr>
            <p:cNvSpPr/>
            <p:nvPr/>
          </p:nvSpPr>
          <p:spPr>
            <a:xfrm>
              <a:off x="4177925" y="2072146"/>
              <a:ext cx="1493180" cy="73786"/>
            </a:xfrm>
            <a:custGeom>
              <a:avLst/>
              <a:gdLst>
                <a:gd name="connsiteX0" fmla="*/ 1493181 w 1493180"/>
                <a:gd name="connsiteY0" fmla="*/ -4 h 73786"/>
                <a:gd name="connsiteX1" fmla="*/ 1 w 1493180"/>
                <a:gd name="connsiteY1" fmla="*/ -4 h 73786"/>
                <a:gd name="connsiteX2" fmla="*/ 1 w 1493180"/>
                <a:gd name="connsiteY2" fmla="*/ 73782 h 7378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493180" h="73786">
                  <a:moveTo>
                    <a:pt x="1493181" y="-4"/>
                  </a:moveTo>
                  <a:lnTo>
                    <a:pt x="1" y="-4"/>
                  </a:lnTo>
                  <a:lnTo>
                    <a:pt x="1" y="73782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10" name="Content Placeholder 3">
              <a:extLst>
                <a:ext uri="{FF2B5EF4-FFF2-40B4-BE49-F238E27FC236}">
                  <a16:creationId xmlns:a16="http://schemas.microsoft.com/office/drawing/2014/main" id="{11A2A9B2-644E-4308-BBF9-D43125FB5482}"/>
                </a:ext>
              </a:extLst>
            </p:cNvPr>
            <p:cNvSpPr/>
            <p:nvPr/>
          </p:nvSpPr>
          <p:spPr>
            <a:xfrm>
              <a:off x="2947184" y="4556349"/>
              <a:ext cx="175470" cy="209065"/>
            </a:xfrm>
            <a:custGeom>
              <a:avLst/>
              <a:gdLst>
                <a:gd name="connsiteX0" fmla="*/ 175471 w 175470"/>
                <a:gd name="connsiteY0" fmla="*/ -4 h 209065"/>
                <a:gd name="connsiteX1" fmla="*/ 1 w 175470"/>
                <a:gd name="connsiteY1" fmla="*/ -4 h 209065"/>
                <a:gd name="connsiteX2" fmla="*/ 1 w 175470"/>
                <a:gd name="connsiteY2" fmla="*/ 209062 h 20906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75470" h="209065">
                  <a:moveTo>
                    <a:pt x="175471" y="-4"/>
                  </a:moveTo>
                  <a:lnTo>
                    <a:pt x="1" y="-4"/>
                  </a:lnTo>
                  <a:lnTo>
                    <a:pt x="1" y="209062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11" name="Content Placeholder 3">
              <a:extLst>
                <a:ext uri="{FF2B5EF4-FFF2-40B4-BE49-F238E27FC236}">
                  <a16:creationId xmlns:a16="http://schemas.microsoft.com/office/drawing/2014/main" id="{0DFEAD44-96E6-4F07-91AC-15FDB1DA18DA}"/>
                </a:ext>
              </a:extLst>
            </p:cNvPr>
            <p:cNvSpPr/>
            <p:nvPr/>
          </p:nvSpPr>
          <p:spPr>
            <a:xfrm>
              <a:off x="4159928" y="2564069"/>
              <a:ext cx="785583" cy="49188"/>
            </a:xfrm>
            <a:custGeom>
              <a:avLst/>
              <a:gdLst>
                <a:gd name="connsiteX0" fmla="*/ 785584 w 785583"/>
                <a:gd name="connsiteY0" fmla="*/ -4 h 49188"/>
                <a:gd name="connsiteX1" fmla="*/ 1 w 785583"/>
                <a:gd name="connsiteY1" fmla="*/ -4 h 49188"/>
                <a:gd name="connsiteX2" fmla="*/ 1 w 785583"/>
                <a:gd name="connsiteY2" fmla="*/ 49185 h 4918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785583" h="49188">
                  <a:moveTo>
                    <a:pt x="785584" y="-4"/>
                  </a:moveTo>
                  <a:lnTo>
                    <a:pt x="1" y="-4"/>
                  </a:lnTo>
                  <a:lnTo>
                    <a:pt x="1" y="49185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12" name="Content Placeholder 3">
              <a:extLst>
                <a:ext uri="{FF2B5EF4-FFF2-40B4-BE49-F238E27FC236}">
                  <a16:creationId xmlns:a16="http://schemas.microsoft.com/office/drawing/2014/main" id="{23B4255B-6B67-4207-A91B-C3E9DF8B25BA}"/>
                </a:ext>
              </a:extLst>
            </p:cNvPr>
            <p:cNvSpPr/>
            <p:nvPr/>
          </p:nvSpPr>
          <p:spPr>
            <a:xfrm>
              <a:off x="3469212" y="5220442"/>
              <a:ext cx="1411864" cy="49188"/>
            </a:xfrm>
            <a:custGeom>
              <a:avLst/>
              <a:gdLst>
                <a:gd name="connsiteX0" fmla="*/ 1411865 w 1411864"/>
                <a:gd name="connsiteY0" fmla="*/ -4 h 49188"/>
                <a:gd name="connsiteX1" fmla="*/ 1 w 1411864"/>
                <a:gd name="connsiteY1" fmla="*/ -4 h 49188"/>
                <a:gd name="connsiteX2" fmla="*/ 1 w 1411864"/>
                <a:gd name="connsiteY2" fmla="*/ 49185 h 4918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411864" h="49188">
                  <a:moveTo>
                    <a:pt x="1411865" y="-4"/>
                  </a:moveTo>
                  <a:lnTo>
                    <a:pt x="1" y="-4"/>
                  </a:lnTo>
                  <a:lnTo>
                    <a:pt x="1" y="49185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13" name="Content Placeholder 3">
              <a:extLst>
                <a:ext uri="{FF2B5EF4-FFF2-40B4-BE49-F238E27FC236}">
                  <a16:creationId xmlns:a16="http://schemas.microsoft.com/office/drawing/2014/main" id="{CCFF1E73-8C08-4D8C-A96E-B89E5F0A9FD8}"/>
                </a:ext>
              </a:extLst>
            </p:cNvPr>
            <p:cNvSpPr/>
            <p:nvPr/>
          </p:nvSpPr>
          <p:spPr>
            <a:xfrm>
              <a:off x="2947184" y="4765415"/>
              <a:ext cx="1044141" cy="209065"/>
            </a:xfrm>
            <a:custGeom>
              <a:avLst/>
              <a:gdLst>
                <a:gd name="connsiteX0" fmla="*/ 1044142 w 1044141"/>
                <a:gd name="connsiteY0" fmla="*/ 209062 h 209065"/>
                <a:gd name="connsiteX1" fmla="*/ 1 w 1044141"/>
                <a:gd name="connsiteY1" fmla="*/ 209062 h 209065"/>
                <a:gd name="connsiteX2" fmla="*/ 1 w 1044141"/>
                <a:gd name="connsiteY2" fmla="*/ -4 h 20906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044141" h="209065">
                  <a:moveTo>
                    <a:pt x="1044142" y="209062"/>
                  </a:moveTo>
                  <a:lnTo>
                    <a:pt x="1" y="209062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14" name="Content Placeholder 3">
              <a:extLst>
                <a:ext uri="{FF2B5EF4-FFF2-40B4-BE49-F238E27FC236}">
                  <a16:creationId xmlns:a16="http://schemas.microsoft.com/office/drawing/2014/main" id="{29D98FEC-5E0D-4406-8DF3-C59CF18BE732}"/>
                </a:ext>
              </a:extLst>
            </p:cNvPr>
            <p:cNvSpPr/>
            <p:nvPr/>
          </p:nvSpPr>
          <p:spPr>
            <a:xfrm>
              <a:off x="4637388" y="5761555"/>
              <a:ext cx="488775" cy="49188"/>
            </a:xfrm>
            <a:custGeom>
              <a:avLst/>
              <a:gdLst>
                <a:gd name="connsiteX0" fmla="*/ 488776 w 488775"/>
                <a:gd name="connsiteY0" fmla="*/ 49185 h 49188"/>
                <a:gd name="connsiteX1" fmla="*/ 1 w 488775"/>
                <a:gd name="connsiteY1" fmla="*/ 49185 h 49188"/>
                <a:gd name="connsiteX2" fmla="*/ 1 w 488775"/>
                <a:gd name="connsiteY2" fmla="*/ -4 h 4918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488775" h="49188">
                  <a:moveTo>
                    <a:pt x="488776" y="49185"/>
                  </a:moveTo>
                  <a:lnTo>
                    <a:pt x="1" y="49185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15" name="Content Placeholder 3">
              <a:extLst>
                <a:ext uri="{FF2B5EF4-FFF2-40B4-BE49-F238E27FC236}">
                  <a16:creationId xmlns:a16="http://schemas.microsoft.com/office/drawing/2014/main" id="{B98190AF-0D6F-455F-9C9A-F30B70DA022D}"/>
                </a:ext>
              </a:extLst>
            </p:cNvPr>
            <p:cNvSpPr/>
            <p:nvPr/>
          </p:nvSpPr>
          <p:spPr>
            <a:xfrm>
              <a:off x="4989567" y="5909104"/>
              <a:ext cx="1852" cy="98435"/>
            </a:xfrm>
            <a:custGeom>
              <a:avLst/>
              <a:gdLst>
                <a:gd name="connsiteX0" fmla="*/ 1853 w 1852"/>
                <a:gd name="connsiteY0" fmla="*/ -4 h 98435"/>
                <a:gd name="connsiteX1" fmla="*/ 1 w 1852"/>
                <a:gd name="connsiteY1" fmla="*/ -4 h 98435"/>
                <a:gd name="connsiteX2" fmla="*/ 1 w 1852"/>
                <a:gd name="connsiteY2" fmla="*/ 98431 h 9843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852" h="98435">
                  <a:moveTo>
                    <a:pt x="1853" y="-4"/>
                  </a:moveTo>
                  <a:lnTo>
                    <a:pt x="1" y="-4"/>
                  </a:lnTo>
                  <a:lnTo>
                    <a:pt x="1" y="98431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16" name="Content Placeholder 3">
              <a:extLst>
                <a:ext uri="{FF2B5EF4-FFF2-40B4-BE49-F238E27FC236}">
                  <a16:creationId xmlns:a16="http://schemas.microsoft.com/office/drawing/2014/main" id="{B78C6A8D-F88D-4C9C-AE45-ABF95FE11905}"/>
                </a:ext>
              </a:extLst>
            </p:cNvPr>
            <p:cNvSpPr/>
            <p:nvPr/>
          </p:nvSpPr>
          <p:spPr>
            <a:xfrm>
              <a:off x="3753083" y="1137499"/>
              <a:ext cx="861545" cy="49188"/>
            </a:xfrm>
            <a:custGeom>
              <a:avLst/>
              <a:gdLst>
                <a:gd name="connsiteX0" fmla="*/ 861546 w 861545"/>
                <a:gd name="connsiteY0" fmla="*/ 49185 h 49188"/>
                <a:gd name="connsiteX1" fmla="*/ 1 w 861545"/>
                <a:gd name="connsiteY1" fmla="*/ 49185 h 49188"/>
                <a:gd name="connsiteX2" fmla="*/ 1 w 861545"/>
                <a:gd name="connsiteY2" fmla="*/ -4 h 4918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861545" h="49188">
                  <a:moveTo>
                    <a:pt x="861546" y="49185"/>
                  </a:moveTo>
                  <a:lnTo>
                    <a:pt x="1" y="49185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17" name="Content Placeholder 3">
              <a:extLst>
                <a:ext uri="{FF2B5EF4-FFF2-40B4-BE49-F238E27FC236}">
                  <a16:creationId xmlns:a16="http://schemas.microsoft.com/office/drawing/2014/main" id="{F491F0C0-8C3C-4A06-A268-5AB85FAD3141}"/>
                </a:ext>
              </a:extLst>
            </p:cNvPr>
            <p:cNvSpPr/>
            <p:nvPr/>
          </p:nvSpPr>
          <p:spPr>
            <a:xfrm>
              <a:off x="4006924" y="1285072"/>
              <a:ext cx="463295" cy="49194"/>
            </a:xfrm>
            <a:custGeom>
              <a:avLst/>
              <a:gdLst>
                <a:gd name="connsiteX0" fmla="*/ 463296 w 463295"/>
                <a:gd name="connsiteY0" fmla="*/ -4 h 49194"/>
                <a:gd name="connsiteX1" fmla="*/ 1 w 463295"/>
                <a:gd name="connsiteY1" fmla="*/ -4 h 49194"/>
                <a:gd name="connsiteX2" fmla="*/ 1 w 463295"/>
                <a:gd name="connsiteY2" fmla="*/ 49191 h 491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463295" h="49194">
                  <a:moveTo>
                    <a:pt x="463296" y="-4"/>
                  </a:moveTo>
                  <a:lnTo>
                    <a:pt x="1" y="-4"/>
                  </a:lnTo>
                  <a:lnTo>
                    <a:pt x="1" y="49191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18" name="Content Placeholder 3">
              <a:extLst>
                <a:ext uri="{FF2B5EF4-FFF2-40B4-BE49-F238E27FC236}">
                  <a16:creationId xmlns:a16="http://schemas.microsoft.com/office/drawing/2014/main" id="{3DF4FDDF-1281-4C37-902C-6BF40AE0C80E}"/>
                </a:ext>
              </a:extLst>
            </p:cNvPr>
            <p:cNvSpPr/>
            <p:nvPr/>
          </p:nvSpPr>
          <p:spPr>
            <a:xfrm>
              <a:off x="3969727" y="2256614"/>
              <a:ext cx="1161679" cy="110682"/>
            </a:xfrm>
            <a:custGeom>
              <a:avLst/>
              <a:gdLst>
                <a:gd name="connsiteX0" fmla="*/ 1161680 w 1161679"/>
                <a:gd name="connsiteY0" fmla="*/ 110678 h 110682"/>
                <a:gd name="connsiteX1" fmla="*/ 1 w 1161679"/>
                <a:gd name="connsiteY1" fmla="*/ 110678 h 110682"/>
                <a:gd name="connsiteX2" fmla="*/ 1 w 1161679"/>
                <a:gd name="connsiteY2" fmla="*/ -4 h 11068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161679" h="110682">
                  <a:moveTo>
                    <a:pt x="1161680" y="110678"/>
                  </a:moveTo>
                  <a:lnTo>
                    <a:pt x="1" y="110678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19" name="Content Placeholder 3">
              <a:extLst>
                <a:ext uri="{FF2B5EF4-FFF2-40B4-BE49-F238E27FC236}">
                  <a16:creationId xmlns:a16="http://schemas.microsoft.com/office/drawing/2014/main" id="{E2B6B6A2-8EED-4226-BE1E-A531C7AA397F}"/>
                </a:ext>
              </a:extLst>
            </p:cNvPr>
            <p:cNvSpPr/>
            <p:nvPr/>
          </p:nvSpPr>
          <p:spPr>
            <a:xfrm>
              <a:off x="4329727" y="2957603"/>
              <a:ext cx="490257" cy="73786"/>
            </a:xfrm>
            <a:custGeom>
              <a:avLst/>
              <a:gdLst>
                <a:gd name="connsiteX0" fmla="*/ 490258 w 490257"/>
                <a:gd name="connsiteY0" fmla="*/ -4 h 73786"/>
                <a:gd name="connsiteX1" fmla="*/ 1 w 490257"/>
                <a:gd name="connsiteY1" fmla="*/ -4 h 73786"/>
                <a:gd name="connsiteX2" fmla="*/ 1 w 490257"/>
                <a:gd name="connsiteY2" fmla="*/ 73782 h 7378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490257" h="73786">
                  <a:moveTo>
                    <a:pt x="490258" y="-4"/>
                  </a:moveTo>
                  <a:lnTo>
                    <a:pt x="1" y="-4"/>
                  </a:lnTo>
                  <a:lnTo>
                    <a:pt x="1" y="73782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20" name="Content Placeholder 3">
              <a:extLst>
                <a:ext uri="{FF2B5EF4-FFF2-40B4-BE49-F238E27FC236}">
                  <a16:creationId xmlns:a16="http://schemas.microsoft.com/office/drawing/2014/main" id="{2AAACD95-F38A-42A1-8ED4-363BB71DC003}"/>
                </a:ext>
              </a:extLst>
            </p:cNvPr>
            <p:cNvSpPr/>
            <p:nvPr/>
          </p:nvSpPr>
          <p:spPr>
            <a:xfrm>
              <a:off x="4067030" y="3646294"/>
              <a:ext cx="666514" cy="182421"/>
            </a:xfrm>
            <a:custGeom>
              <a:avLst/>
              <a:gdLst>
                <a:gd name="connsiteX0" fmla="*/ 666515 w 666514"/>
                <a:gd name="connsiteY0" fmla="*/ -4 h 182421"/>
                <a:gd name="connsiteX1" fmla="*/ 1 w 666514"/>
                <a:gd name="connsiteY1" fmla="*/ -4 h 182421"/>
                <a:gd name="connsiteX2" fmla="*/ 1 w 666514"/>
                <a:gd name="connsiteY2" fmla="*/ 182418 h 18242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666514" h="182421">
                  <a:moveTo>
                    <a:pt x="666515" y="-4"/>
                  </a:moveTo>
                  <a:lnTo>
                    <a:pt x="1" y="-4"/>
                  </a:lnTo>
                  <a:lnTo>
                    <a:pt x="1" y="182418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21" name="Content Placeholder 3">
              <a:extLst>
                <a:ext uri="{FF2B5EF4-FFF2-40B4-BE49-F238E27FC236}">
                  <a16:creationId xmlns:a16="http://schemas.microsoft.com/office/drawing/2014/main" id="{FA7B7402-E94A-4A18-BAD2-38781F182A5B}"/>
                </a:ext>
              </a:extLst>
            </p:cNvPr>
            <p:cNvSpPr/>
            <p:nvPr/>
          </p:nvSpPr>
          <p:spPr>
            <a:xfrm>
              <a:off x="3407506" y="1137499"/>
              <a:ext cx="345577" cy="98383"/>
            </a:xfrm>
            <a:custGeom>
              <a:avLst/>
              <a:gdLst>
                <a:gd name="connsiteX0" fmla="*/ 345578 w 345577"/>
                <a:gd name="connsiteY0" fmla="*/ -4 h 98383"/>
                <a:gd name="connsiteX1" fmla="*/ 1 w 345577"/>
                <a:gd name="connsiteY1" fmla="*/ -4 h 98383"/>
                <a:gd name="connsiteX2" fmla="*/ 1 w 345577"/>
                <a:gd name="connsiteY2" fmla="*/ 98380 h 9838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345577" h="98383">
                  <a:moveTo>
                    <a:pt x="345578" y="-4"/>
                  </a:moveTo>
                  <a:lnTo>
                    <a:pt x="1" y="-4"/>
                  </a:lnTo>
                  <a:lnTo>
                    <a:pt x="1" y="98380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22" name="Content Placeholder 3">
              <a:extLst>
                <a:ext uri="{FF2B5EF4-FFF2-40B4-BE49-F238E27FC236}">
                  <a16:creationId xmlns:a16="http://schemas.microsoft.com/office/drawing/2014/main" id="{6AA0DF9B-B7A4-490D-8FBD-377C3FB52A28}"/>
                </a:ext>
              </a:extLst>
            </p:cNvPr>
            <p:cNvSpPr/>
            <p:nvPr/>
          </p:nvSpPr>
          <p:spPr>
            <a:xfrm>
              <a:off x="3901595" y="2613258"/>
              <a:ext cx="1443358" cy="147578"/>
            </a:xfrm>
            <a:custGeom>
              <a:avLst/>
              <a:gdLst>
                <a:gd name="connsiteX0" fmla="*/ 1443359 w 1443358"/>
                <a:gd name="connsiteY0" fmla="*/ 147574 h 147578"/>
                <a:gd name="connsiteX1" fmla="*/ 1 w 1443358"/>
                <a:gd name="connsiteY1" fmla="*/ 147574 h 147578"/>
                <a:gd name="connsiteX2" fmla="*/ 1 w 1443358"/>
                <a:gd name="connsiteY2" fmla="*/ -4 h 14757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443358" h="147578">
                  <a:moveTo>
                    <a:pt x="1443359" y="147574"/>
                  </a:moveTo>
                  <a:lnTo>
                    <a:pt x="1" y="147574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23" name="Content Placeholder 3">
              <a:extLst>
                <a:ext uri="{FF2B5EF4-FFF2-40B4-BE49-F238E27FC236}">
                  <a16:creationId xmlns:a16="http://schemas.microsoft.com/office/drawing/2014/main" id="{1A6F7997-268F-4597-AE59-F21AF5C2C940}"/>
                </a:ext>
              </a:extLst>
            </p:cNvPr>
            <p:cNvSpPr/>
            <p:nvPr/>
          </p:nvSpPr>
          <p:spPr>
            <a:xfrm>
              <a:off x="3203072" y="5417209"/>
              <a:ext cx="1901448" cy="73786"/>
            </a:xfrm>
            <a:custGeom>
              <a:avLst/>
              <a:gdLst>
                <a:gd name="connsiteX0" fmla="*/ 1901449 w 1901448"/>
                <a:gd name="connsiteY0" fmla="*/ -4 h 73786"/>
                <a:gd name="connsiteX1" fmla="*/ 1 w 1901448"/>
                <a:gd name="connsiteY1" fmla="*/ -4 h 73786"/>
                <a:gd name="connsiteX2" fmla="*/ 1 w 1901448"/>
                <a:gd name="connsiteY2" fmla="*/ 73782 h 7378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901448" h="73786">
                  <a:moveTo>
                    <a:pt x="1901449" y="-4"/>
                  </a:moveTo>
                  <a:lnTo>
                    <a:pt x="1" y="-4"/>
                  </a:lnTo>
                  <a:lnTo>
                    <a:pt x="1" y="73782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24" name="Content Placeholder 3">
              <a:extLst>
                <a:ext uri="{FF2B5EF4-FFF2-40B4-BE49-F238E27FC236}">
                  <a16:creationId xmlns:a16="http://schemas.microsoft.com/office/drawing/2014/main" id="{FCFF0CEE-F363-41A3-8057-79A696421E4A}"/>
                </a:ext>
              </a:extLst>
            </p:cNvPr>
            <p:cNvSpPr/>
            <p:nvPr/>
          </p:nvSpPr>
          <p:spPr>
            <a:xfrm>
              <a:off x="3201160" y="3498716"/>
              <a:ext cx="1961559" cy="49194"/>
            </a:xfrm>
            <a:custGeom>
              <a:avLst/>
              <a:gdLst>
                <a:gd name="connsiteX0" fmla="*/ 1961560 w 1961559"/>
                <a:gd name="connsiteY0" fmla="*/ 49191 h 49194"/>
                <a:gd name="connsiteX1" fmla="*/ 1 w 1961559"/>
                <a:gd name="connsiteY1" fmla="*/ 49191 h 49194"/>
                <a:gd name="connsiteX2" fmla="*/ 1 w 1961559"/>
                <a:gd name="connsiteY2" fmla="*/ -4 h 491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961559" h="49194">
                  <a:moveTo>
                    <a:pt x="1961560" y="49191"/>
                  </a:moveTo>
                  <a:lnTo>
                    <a:pt x="1" y="49191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25" name="Content Placeholder 3">
              <a:extLst>
                <a:ext uri="{FF2B5EF4-FFF2-40B4-BE49-F238E27FC236}">
                  <a16:creationId xmlns:a16="http://schemas.microsoft.com/office/drawing/2014/main" id="{25ABD0FB-63A3-4A43-BD96-EFC26F8A389B}"/>
                </a:ext>
              </a:extLst>
            </p:cNvPr>
            <p:cNvSpPr/>
            <p:nvPr/>
          </p:nvSpPr>
          <p:spPr>
            <a:xfrm>
              <a:off x="4573532" y="2219724"/>
              <a:ext cx="461899" cy="49188"/>
            </a:xfrm>
            <a:custGeom>
              <a:avLst/>
              <a:gdLst>
                <a:gd name="connsiteX0" fmla="*/ 461900 w 461899"/>
                <a:gd name="connsiteY0" fmla="*/ 49185 h 49188"/>
                <a:gd name="connsiteX1" fmla="*/ 1 w 461899"/>
                <a:gd name="connsiteY1" fmla="*/ 49185 h 49188"/>
                <a:gd name="connsiteX2" fmla="*/ 1 w 461899"/>
                <a:gd name="connsiteY2" fmla="*/ -4 h 4918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461899" h="49188">
                  <a:moveTo>
                    <a:pt x="461900" y="49185"/>
                  </a:moveTo>
                  <a:lnTo>
                    <a:pt x="1" y="49185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26" name="Content Placeholder 3">
              <a:extLst>
                <a:ext uri="{FF2B5EF4-FFF2-40B4-BE49-F238E27FC236}">
                  <a16:creationId xmlns:a16="http://schemas.microsoft.com/office/drawing/2014/main" id="{CD57C809-38F8-4A38-9FEE-A32AD3E33505}"/>
                </a:ext>
              </a:extLst>
            </p:cNvPr>
            <p:cNvSpPr/>
            <p:nvPr/>
          </p:nvSpPr>
          <p:spPr>
            <a:xfrm>
              <a:off x="3704214" y="842343"/>
              <a:ext cx="327832" cy="98383"/>
            </a:xfrm>
            <a:custGeom>
              <a:avLst/>
              <a:gdLst>
                <a:gd name="connsiteX0" fmla="*/ 327833 w 327832"/>
                <a:gd name="connsiteY0" fmla="*/ 98380 h 98383"/>
                <a:gd name="connsiteX1" fmla="*/ 1 w 327832"/>
                <a:gd name="connsiteY1" fmla="*/ 98380 h 98383"/>
                <a:gd name="connsiteX2" fmla="*/ 1 w 327832"/>
                <a:gd name="connsiteY2" fmla="*/ -4 h 9838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327832" h="98383">
                  <a:moveTo>
                    <a:pt x="327833" y="98380"/>
                  </a:moveTo>
                  <a:lnTo>
                    <a:pt x="1" y="98380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27" name="Content Placeholder 3">
              <a:extLst>
                <a:ext uri="{FF2B5EF4-FFF2-40B4-BE49-F238E27FC236}">
                  <a16:creationId xmlns:a16="http://schemas.microsoft.com/office/drawing/2014/main" id="{AEB19326-9236-484B-847B-6CD5A6D4DD79}"/>
                </a:ext>
              </a:extLst>
            </p:cNvPr>
            <p:cNvSpPr/>
            <p:nvPr/>
          </p:nvSpPr>
          <p:spPr>
            <a:xfrm>
              <a:off x="4434341" y="4121819"/>
              <a:ext cx="448813" cy="106582"/>
            </a:xfrm>
            <a:custGeom>
              <a:avLst/>
              <a:gdLst>
                <a:gd name="connsiteX0" fmla="*/ 448814 w 448813"/>
                <a:gd name="connsiteY0" fmla="*/ -4 h 106582"/>
                <a:gd name="connsiteX1" fmla="*/ 1 w 448813"/>
                <a:gd name="connsiteY1" fmla="*/ -4 h 106582"/>
                <a:gd name="connsiteX2" fmla="*/ 1 w 448813"/>
                <a:gd name="connsiteY2" fmla="*/ 106579 h 10658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448813" h="106582">
                  <a:moveTo>
                    <a:pt x="448814" y="-4"/>
                  </a:moveTo>
                  <a:lnTo>
                    <a:pt x="1" y="-4"/>
                  </a:lnTo>
                  <a:lnTo>
                    <a:pt x="1" y="106579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28" name="Content Placeholder 3">
              <a:extLst>
                <a:ext uri="{FF2B5EF4-FFF2-40B4-BE49-F238E27FC236}">
                  <a16:creationId xmlns:a16="http://schemas.microsoft.com/office/drawing/2014/main" id="{33D3681E-1BC0-44B7-A67B-E67AF06CB94B}"/>
                </a:ext>
              </a:extLst>
            </p:cNvPr>
            <p:cNvSpPr/>
            <p:nvPr/>
          </p:nvSpPr>
          <p:spPr>
            <a:xfrm>
              <a:off x="3419277" y="4580946"/>
              <a:ext cx="472540" cy="98377"/>
            </a:xfrm>
            <a:custGeom>
              <a:avLst/>
              <a:gdLst>
                <a:gd name="connsiteX0" fmla="*/ 472541 w 472540"/>
                <a:gd name="connsiteY0" fmla="*/ -4 h 98377"/>
                <a:gd name="connsiteX1" fmla="*/ 1 w 472540"/>
                <a:gd name="connsiteY1" fmla="*/ -4 h 98377"/>
                <a:gd name="connsiteX2" fmla="*/ 1 w 472540"/>
                <a:gd name="connsiteY2" fmla="*/ 98374 h 9837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472540" h="98377">
                  <a:moveTo>
                    <a:pt x="472541" y="-4"/>
                  </a:moveTo>
                  <a:lnTo>
                    <a:pt x="1" y="-4"/>
                  </a:lnTo>
                  <a:lnTo>
                    <a:pt x="1" y="9837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29" name="Content Placeholder 3">
              <a:extLst>
                <a:ext uri="{FF2B5EF4-FFF2-40B4-BE49-F238E27FC236}">
                  <a16:creationId xmlns:a16="http://schemas.microsoft.com/office/drawing/2014/main" id="{47B63424-24F7-4241-A954-EA1C0C99A953}"/>
                </a:ext>
              </a:extLst>
            </p:cNvPr>
            <p:cNvSpPr/>
            <p:nvPr/>
          </p:nvSpPr>
          <p:spPr>
            <a:xfrm>
              <a:off x="3364936" y="510297"/>
              <a:ext cx="211862" cy="184470"/>
            </a:xfrm>
            <a:custGeom>
              <a:avLst/>
              <a:gdLst>
                <a:gd name="connsiteX0" fmla="*/ 211863 w 211862"/>
                <a:gd name="connsiteY0" fmla="*/ 184467 h 184470"/>
                <a:gd name="connsiteX1" fmla="*/ 1 w 211862"/>
                <a:gd name="connsiteY1" fmla="*/ 184467 h 184470"/>
                <a:gd name="connsiteX2" fmla="*/ 1 w 211862"/>
                <a:gd name="connsiteY2" fmla="*/ -4 h 1844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11862" h="184470">
                  <a:moveTo>
                    <a:pt x="211863" y="184467"/>
                  </a:moveTo>
                  <a:lnTo>
                    <a:pt x="1" y="184467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30" name="Content Placeholder 3">
              <a:extLst>
                <a:ext uri="{FF2B5EF4-FFF2-40B4-BE49-F238E27FC236}">
                  <a16:creationId xmlns:a16="http://schemas.microsoft.com/office/drawing/2014/main" id="{5A4841B5-C4B2-4751-9C9B-A63480045C36}"/>
                </a:ext>
              </a:extLst>
            </p:cNvPr>
            <p:cNvSpPr/>
            <p:nvPr/>
          </p:nvSpPr>
          <p:spPr>
            <a:xfrm>
              <a:off x="3122654" y="4556349"/>
              <a:ext cx="296622" cy="122975"/>
            </a:xfrm>
            <a:custGeom>
              <a:avLst/>
              <a:gdLst>
                <a:gd name="connsiteX0" fmla="*/ 296623 w 296622"/>
                <a:gd name="connsiteY0" fmla="*/ 122971 h 122975"/>
                <a:gd name="connsiteX1" fmla="*/ 1 w 296622"/>
                <a:gd name="connsiteY1" fmla="*/ 122971 h 122975"/>
                <a:gd name="connsiteX2" fmla="*/ 1 w 296622"/>
                <a:gd name="connsiteY2" fmla="*/ -4 h 12297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96622" h="122975">
                  <a:moveTo>
                    <a:pt x="296623" y="122971"/>
                  </a:moveTo>
                  <a:lnTo>
                    <a:pt x="1" y="122971"/>
                  </a:lnTo>
                  <a:lnTo>
                    <a:pt x="1" y="-4"/>
                  </a:lnTo>
                </a:path>
              </a:pathLst>
            </a:custGeom>
            <a:noFill/>
            <a:ln w="4518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31" name="Content Placeholder 3">
              <a:extLst>
                <a:ext uri="{FF2B5EF4-FFF2-40B4-BE49-F238E27FC236}">
                  <a16:creationId xmlns:a16="http://schemas.microsoft.com/office/drawing/2014/main" id="{153824F7-2DE1-47BF-AB41-A3748A303A9A}"/>
                </a:ext>
              </a:extLst>
            </p:cNvPr>
            <p:cNvSpPr txBox="1"/>
            <p:nvPr/>
          </p:nvSpPr>
          <p:spPr>
            <a:xfrm>
              <a:off x="5266979" y="2070187"/>
              <a:ext cx="1353256" cy="1919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647" dirty="0">
                  <a:solidFill>
                    <a:srgbClr val="000000"/>
                  </a:solidFill>
                  <a:latin typeface="Times New Roman"/>
                  <a:cs typeface="Times New Roman"/>
                  <a:sym typeface="Times New Roman"/>
                  <a:rtl val="0"/>
                </a:rPr>
                <a:t>b</a:t>
              </a:r>
              <a:r>
                <a:rPr lang="en-US" sz="647" spc="0" baseline="0" dirty="0" smtClean="0">
                  <a:solidFill>
                    <a:srgbClr val="000000"/>
                  </a:solidFill>
                  <a:latin typeface="Times New Roman"/>
                  <a:cs typeface="Times New Roman"/>
                  <a:sym typeface="Times New Roman"/>
                  <a:rtl val="0"/>
                </a:rPr>
                <a:t>anana streak IM virus NC 015507</a:t>
              </a:r>
              <a:endParaRPr lang="en-US" sz="647" spc="0" baseline="0" dirty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endParaRPr>
            </a:p>
          </p:txBody>
        </p:sp>
      </p:grpSp>
      <p:sp>
        <p:nvSpPr>
          <p:cNvPr id="132" name="Content Placeholder 3">
            <a:extLst>
              <a:ext uri="{FF2B5EF4-FFF2-40B4-BE49-F238E27FC236}">
                <a16:creationId xmlns:a16="http://schemas.microsoft.com/office/drawing/2014/main" id="{AB6A963F-58D3-468F-BB71-434E65B6F317}"/>
              </a:ext>
            </a:extLst>
          </p:cNvPr>
          <p:cNvSpPr txBox="1"/>
          <p:nvPr/>
        </p:nvSpPr>
        <p:spPr>
          <a:xfrm>
            <a:off x="4740293" y="4628174"/>
            <a:ext cx="1616148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dirty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g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ooseberry vein banding virus NC 018105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33" name="Content Placeholder 3">
            <a:extLst>
              <a:ext uri="{FF2B5EF4-FFF2-40B4-BE49-F238E27FC236}">
                <a16:creationId xmlns:a16="http://schemas.microsoft.com/office/drawing/2014/main" id="{31CF15CE-C662-4FE3-AE69-868414543690}"/>
              </a:ext>
            </a:extLst>
          </p:cNvPr>
          <p:cNvSpPr txBox="1"/>
          <p:nvPr/>
        </p:nvSpPr>
        <p:spPr>
          <a:xfrm>
            <a:off x="4429554" y="5513632"/>
            <a:ext cx="1653017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Pelargonium vein banding virus NC 013262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34" name="Content Placeholder 3">
            <a:extLst>
              <a:ext uri="{FF2B5EF4-FFF2-40B4-BE49-F238E27FC236}">
                <a16:creationId xmlns:a16="http://schemas.microsoft.com/office/drawing/2014/main" id="{4183CD76-7CCC-4D6D-A9D6-AF9D4F392511}"/>
              </a:ext>
            </a:extLst>
          </p:cNvPr>
          <p:cNvSpPr txBox="1"/>
          <p:nvPr/>
        </p:nvSpPr>
        <p:spPr>
          <a:xfrm>
            <a:off x="1839247" y="6300712"/>
            <a:ext cx="1465466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spc="0" baseline="0" dirty="0" err="1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Dioscorea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err="1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nummulariaassociated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virus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35" name="Content Placeholder 3">
            <a:extLst>
              <a:ext uri="{FF2B5EF4-FFF2-40B4-BE49-F238E27FC236}">
                <a16:creationId xmlns:a16="http://schemas.microsoft.com/office/drawing/2014/main" id="{F29A74D9-40ED-416C-A505-A2E8C18E894E}"/>
              </a:ext>
            </a:extLst>
          </p:cNvPr>
          <p:cNvSpPr txBox="1"/>
          <p:nvPr/>
        </p:nvSpPr>
        <p:spPr>
          <a:xfrm>
            <a:off x="5086326" y="692810"/>
            <a:ext cx="1648208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spc="0" baseline="0" dirty="0" err="1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Dioscorea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bacilliform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RT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virus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NC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038987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36" name="Content Placeholder 3">
            <a:extLst>
              <a:ext uri="{FF2B5EF4-FFF2-40B4-BE49-F238E27FC236}">
                <a16:creationId xmlns:a16="http://schemas.microsoft.com/office/drawing/2014/main" id="{DBCF5693-D443-4245-BEA2-F04CAE7BCB86}"/>
              </a:ext>
            </a:extLst>
          </p:cNvPr>
          <p:cNvSpPr txBox="1"/>
          <p:nvPr/>
        </p:nvSpPr>
        <p:spPr>
          <a:xfrm>
            <a:off x="5115381" y="3349182"/>
            <a:ext cx="1455848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dirty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c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acao mild mosaic virus NC 033738 1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37" name="Content Placeholder 3">
            <a:extLst>
              <a:ext uri="{FF2B5EF4-FFF2-40B4-BE49-F238E27FC236}">
                <a16:creationId xmlns:a16="http://schemas.microsoft.com/office/drawing/2014/main" id="{7D9136EC-CA5C-49F3-B3C2-FBDFD8DBB69A}"/>
              </a:ext>
            </a:extLst>
          </p:cNvPr>
          <p:cNvSpPr txBox="1"/>
          <p:nvPr/>
        </p:nvSpPr>
        <p:spPr>
          <a:xfrm>
            <a:off x="4762163" y="5415248"/>
            <a:ext cx="1321196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Dracaena mottle virus NC 008034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38" name="Content Placeholder 3">
            <a:extLst>
              <a:ext uri="{FF2B5EF4-FFF2-40B4-BE49-F238E27FC236}">
                <a16:creationId xmlns:a16="http://schemas.microsoft.com/office/drawing/2014/main" id="{225E7775-9744-46FE-9754-C163E18E67FB}"/>
              </a:ext>
            </a:extLst>
          </p:cNvPr>
          <p:cNvSpPr txBox="1"/>
          <p:nvPr/>
        </p:nvSpPr>
        <p:spPr>
          <a:xfrm>
            <a:off x="4059007" y="5021714"/>
            <a:ext cx="1217000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dirty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b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lackberry Virus F NC 029303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39" name="Content Placeholder 3">
            <a:extLst>
              <a:ext uri="{FF2B5EF4-FFF2-40B4-BE49-F238E27FC236}">
                <a16:creationId xmlns:a16="http://schemas.microsoft.com/office/drawing/2014/main" id="{246CAC85-2846-497B-AC36-4AEFC6107B2A}"/>
              </a:ext>
            </a:extLst>
          </p:cNvPr>
          <p:cNvSpPr txBox="1"/>
          <p:nvPr/>
        </p:nvSpPr>
        <p:spPr>
          <a:xfrm>
            <a:off x="5128801" y="3644333"/>
            <a:ext cx="1580882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dirty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c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acao swollen shoot CD virus NC 038378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40" name="Content Placeholder 3">
            <a:extLst>
              <a:ext uri="{FF2B5EF4-FFF2-40B4-BE49-F238E27FC236}">
                <a16:creationId xmlns:a16="http://schemas.microsoft.com/office/drawing/2014/main" id="{26BE4DE5-F077-4390-9F1F-EDA9A6A040F9}"/>
              </a:ext>
            </a:extLst>
          </p:cNvPr>
          <p:cNvSpPr txBox="1"/>
          <p:nvPr/>
        </p:nvSpPr>
        <p:spPr>
          <a:xfrm>
            <a:off x="4638715" y="200889"/>
            <a:ext cx="1428596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dirty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t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aro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bacilliform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CH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virus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NC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026819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41" name="Content Placeholder 3">
            <a:extLst>
              <a:ext uri="{FF2B5EF4-FFF2-40B4-BE49-F238E27FC236}">
                <a16:creationId xmlns:a16="http://schemas.microsoft.com/office/drawing/2014/main" id="{73EDBD24-3024-47C9-AAD6-4BCB94D4BB98}"/>
              </a:ext>
            </a:extLst>
          </p:cNvPr>
          <p:cNvSpPr txBox="1"/>
          <p:nvPr/>
        </p:nvSpPr>
        <p:spPr>
          <a:xfrm>
            <a:off x="4837442" y="1873418"/>
            <a:ext cx="1370888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dirty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b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anana streak UA virus NC 015502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42" name="Content Placeholder 3">
            <a:extLst>
              <a:ext uri="{FF2B5EF4-FFF2-40B4-BE49-F238E27FC236}">
                <a16:creationId xmlns:a16="http://schemas.microsoft.com/office/drawing/2014/main" id="{DB536F98-E470-4EB9-8090-013BEE37BB13}"/>
              </a:ext>
            </a:extLst>
          </p:cNvPr>
          <p:cNvSpPr txBox="1"/>
          <p:nvPr/>
        </p:nvSpPr>
        <p:spPr>
          <a:xfrm>
            <a:off x="3273614" y="6202334"/>
            <a:ext cx="1354858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dirty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t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aro bacilliform virus NC 004450 1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43" name="Content Placeholder 3">
            <a:extLst>
              <a:ext uri="{FF2B5EF4-FFF2-40B4-BE49-F238E27FC236}">
                <a16:creationId xmlns:a16="http://schemas.microsoft.com/office/drawing/2014/main" id="{55BBF487-1744-4BE4-A988-72E0673BF5ED}"/>
              </a:ext>
            </a:extLst>
          </p:cNvPr>
          <p:cNvSpPr txBox="1"/>
          <p:nvPr/>
        </p:nvSpPr>
        <p:spPr>
          <a:xfrm>
            <a:off x="5011047" y="3742717"/>
            <a:ext cx="1677062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dirty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c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acao swollen shoot Togo A virus AJ781003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44" name="Content Placeholder 3">
            <a:extLst>
              <a:ext uri="{FF2B5EF4-FFF2-40B4-BE49-F238E27FC236}">
                <a16:creationId xmlns:a16="http://schemas.microsoft.com/office/drawing/2014/main" id="{E9FD9B5D-2702-457C-AD55-743BD2EB8A7E}"/>
              </a:ext>
            </a:extLst>
          </p:cNvPr>
          <p:cNvSpPr txBox="1"/>
          <p:nvPr/>
        </p:nvSpPr>
        <p:spPr>
          <a:xfrm>
            <a:off x="5188356" y="4136257"/>
            <a:ext cx="1762021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cacao swollen shoot Ghana K virus NC 040808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45" name="Content Placeholder 3">
            <a:extLst>
              <a:ext uri="{FF2B5EF4-FFF2-40B4-BE49-F238E27FC236}">
                <a16:creationId xmlns:a16="http://schemas.microsoft.com/office/drawing/2014/main" id="{7012B624-B00D-4D97-BCBE-CF3F1B3A5A83}"/>
              </a:ext>
            </a:extLst>
          </p:cNvPr>
          <p:cNvSpPr txBox="1"/>
          <p:nvPr/>
        </p:nvSpPr>
        <p:spPr>
          <a:xfrm>
            <a:off x="4773776" y="5218481"/>
            <a:ext cx="1609736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dirty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j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ujube mosaic associated virus NC 035472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46" name="Content Placeholder 3">
            <a:extLst>
              <a:ext uri="{FF2B5EF4-FFF2-40B4-BE49-F238E27FC236}">
                <a16:creationId xmlns:a16="http://schemas.microsoft.com/office/drawing/2014/main" id="{544B8084-056B-4319-BBD2-3B0810EC654D}"/>
              </a:ext>
            </a:extLst>
          </p:cNvPr>
          <p:cNvSpPr txBox="1"/>
          <p:nvPr/>
        </p:nvSpPr>
        <p:spPr>
          <a:xfrm>
            <a:off x="4573647" y="397657"/>
            <a:ext cx="1627369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spc="0" baseline="0" dirty="0" err="1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Dioscorea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bacilliform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AL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virus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MG948562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47" name="Content Placeholder 3">
            <a:extLst>
              <a:ext uri="{FF2B5EF4-FFF2-40B4-BE49-F238E27FC236}">
                <a16:creationId xmlns:a16="http://schemas.microsoft.com/office/drawing/2014/main" id="{B6590A07-4B14-40FD-A5C7-DF1AC77A780F}"/>
              </a:ext>
            </a:extLst>
          </p:cNvPr>
          <p:cNvSpPr txBox="1"/>
          <p:nvPr/>
        </p:nvSpPr>
        <p:spPr>
          <a:xfrm>
            <a:off x="4983664" y="594426"/>
            <a:ext cx="1624163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spc="0" baseline="0" dirty="0" err="1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Dioscorea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bacilliform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RT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virus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MG711312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48" name="Content Placeholder 3">
            <a:extLst>
              <a:ext uri="{FF2B5EF4-FFF2-40B4-BE49-F238E27FC236}">
                <a16:creationId xmlns:a16="http://schemas.microsoft.com/office/drawing/2014/main" id="{6ABBC8AC-6B6D-4EF9-BE7E-30B591E0042C}"/>
              </a:ext>
            </a:extLst>
          </p:cNvPr>
          <p:cNvSpPr txBox="1"/>
          <p:nvPr/>
        </p:nvSpPr>
        <p:spPr>
          <a:xfrm>
            <a:off x="5355815" y="3841106"/>
            <a:ext cx="1572866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dirty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c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acao swollen shoot CE virus NC 040692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49" name="Content Placeholder 3">
            <a:extLst>
              <a:ext uri="{FF2B5EF4-FFF2-40B4-BE49-F238E27FC236}">
                <a16:creationId xmlns:a16="http://schemas.microsoft.com/office/drawing/2014/main" id="{3C2309CD-98AE-477D-8A0F-9FDEA96E9484}"/>
              </a:ext>
            </a:extLst>
          </p:cNvPr>
          <p:cNvSpPr txBox="1"/>
          <p:nvPr/>
        </p:nvSpPr>
        <p:spPr>
          <a:xfrm>
            <a:off x="5314696" y="4037873"/>
            <a:ext cx="1734770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dirty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c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acao swollen shoot Ghana J virus NC 040807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50" name="Content Placeholder 3">
            <a:extLst>
              <a:ext uri="{FF2B5EF4-FFF2-40B4-BE49-F238E27FC236}">
                <a16:creationId xmlns:a16="http://schemas.microsoft.com/office/drawing/2014/main" id="{4830EB84-19FE-419E-8EC3-E7F5D60977C5}"/>
              </a:ext>
            </a:extLst>
          </p:cNvPr>
          <p:cNvSpPr txBox="1"/>
          <p:nvPr/>
        </p:nvSpPr>
        <p:spPr>
          <a:xfrm>
            <a:off x="5317904" y="2758875"/>
            <a:ext cx="1640193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spc="0" baseline="0" dirty="0" err="1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Commelina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yellow mottle virus NC 001343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51" name="Content Placeholder 3">
            <a:extLst>
              <a:ext uri="{FF2B5EF4-FFF2-40B4-BE49-F238E27FC236}">
                <a16:creationId xmlns:a16="http://schemas.microsoft.com/office/drawing/2014/main" id="{865CE1A9-ED88-470A-AA6B-1FFC3AE8E8BE}"/>
              </a:ext>
            </a:extLst>
          </p:cNvPr>
          <p:cNvSpPr txBox="1"/>
          <p:nvPr/>
        </p:nvSpPr>
        <p:spPr>
          <a:xfrm>
            <a:off x="4713317" y="299273"/>
            <a:ext cx="1428596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Piper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yellow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mottle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virus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NC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022365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52" name="Content Placeholder 3">
            <a:extLst>
              <a:ext uri="{FF2B5EF4-FFF2-40B4-BE49-F238E27FC236}">
                <a16:creationId xmlns:a16="http://schemas.microsoft.com/office/drawing/2014/main" id="{313BBF73-9566-466B-8E06-3F778895668B}"/>
              </a:ext>
            </a:extLst>
          </p:cNvPr>
          <p:cNvSpPr txBox="1"/>
          <p:nvPr/>
        </p:nvSpPr>
        <p:spPr>
          <a:xfrm>
            <a:off x="5340271" y="1676651"/>
            <a:ext cx="1362874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dirty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b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anana streak OL virus NC 003381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53" name="Content Placeholder 3">
            <a:extLst>
              <a:ext uri="{FF2B5EF4-FFF2-40B4-BE49-F238E27FC236}">
                <a16:creationId xmlns:a16="http://schemas.microsoft.com/office/drawing/2014/main" id="{11547AF7-3917-4D5B-899F-DAD4E50E092B}"/>
              </a:ext>
            </a:extLst>
          </p:cNvPr>
          <p:cNvSpPr txBox="1"/>
          <p:nvPr/>
        </p:nvSpPr>
        <p:spPr>
          <a:xfrm>
            <a:off x="4974265" y="2955648"/>
            <a:ext cx="1362874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dirty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b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anana streak UL virus NC 015504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54" name="Content Placeholder 3">
            <a:extLst>
              <a:ext uri="{FF2B5EF4-FFF2-40B4-BE49-F238E27FC236}">
                <a16:creationId xmlns:a16="http://schemas.microsoft.com/office/drawing/2014/main" id="{BE8FE4CC-A2B2-46F1-9F72-B166FF8B3086}"/>
              </a:ext>
            </a:extLst>
          </p:cNvPr>
          <p:cNvSpPr txBox="1"/>
          <p:nvPr/>
        </p:nvSpPr>
        <p:spPr>
          <a:xfrm>
            <a:off x="4880324" y="1381500"/>
            <a:ext cx="1758815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cacao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swollen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shoot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Ghana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R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virus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NC 040693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55" name="Content Placeholder 3">
            <a:extLst>
              <a:ext uri="{FF2B5EF4-FFF2-40B4-BE49-F238E27FC236}">
                <a16:creationId xmlns:a16="http://schemas.microsoft.com/office/drawing/2014/main" id="{9D211A4E-D27A-40EE-B29D-CE1FD3A0DBA8}"/>
              </a:ext>
            </a:extLst>
          </p:cNvPr>
          <p:cNvSpPr txBox="1"/>
          <p:nvPr/>
        </p:nvSpPr>
        <p:spPr>
          <a:xfrm>
            <a:off x="4931565" y="5612021"/>
            <a:ext cx="973343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dirty="0" err="1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g</a:t>
            </a:r>
            <a:r>
              <a:rPr lang="en-US" sz="647" spc="0" baseline="0" dirty="0" err="1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ilo</a:t>
            </a:r>
            <a:r>
              <a:rPr lang="en-US" sz="647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dirty="0" err="1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badnavirus</a:t>
            </a:r>
            <a:r>
              <a:rPr lang="en-US" sz="647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A GBV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56" name="Content Placeholder 3">
            <a:extLst>
              <a:ext uri="{FF2B5EF4-FFF2-40B4-BE49-F238E27FC236}">
                <a16:creationId xmlns:a16="http://schemas.microsoft.com/office/drawing/2014/main" id="{0CBA8A50-FC3B-4811-A0B9-D0F642D70F5D}"/>
              </a:ext>
            </a:extLst>
          </p:cNvPr>
          <p:cNvSpPr txBox="1"/>
          <p:nvPr/>
        </p:nvSpPr>
        <p:spPr>
          <a:xfrm>
            <a:off x="4500406" y="1283116"/>
            <a:ext cx="2331087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dirty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g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rapevine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err="1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roditis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leaf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discoloration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associated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virus NC 027131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57" name="Content Placeholder 3">
            <a:extLst>
              <a:ext uri="{FF2B5EF4-FFF2-40B4-BE49-F238E27FC236}">
                <a16:creationId xmlns:a16="http://schemas.microsoft.com/office/drawing/2014/main" id="{C10B843F-3493-481A-BCCF-E6EF43454F69}"/>
              </a:ext>
            </a:extLst>
          </p:cNvPr>
          <p:cNvSpPr txBox="1"/>
          <p:nvPr/>
        </p:nvSpPr>
        <p:spPr>
          <a:xfrm>
            <a:off x="4576361" y="497999"/>
            <a:ext cx="1651414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spc="0" baseline="0" dirty="0" err="1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Dioscorea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bacilliform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AL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virus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NC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038381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58" name="Content Placeholder 3">
            <a:extLst>
              <a:ext uri="{FF2B5EF4-FFF2-40B4-BE49-F238E27FC236}">
                <a16:creationId xmlns:a16="http://schemas.microsoft.com/office/drawing/2014/main" id="{97735D94-FED2-4C1D-A67E-05F40F5C65D0}"/>
              </a:ext>
            </a:extLst>
          </p:cNvPr>
          <p:cNvSpPr txBox="1"/>
          <p:nvPr/>
        </p:nvSpPr>
        <p:spPr>
          <a:xfrm>
            <a:off x="4676807" y="4923331"/>
            <a:ext cx="1317990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Wisteria </a:t>
            </a:r>
            <a:r>
              <a:rPr lang="en-US" sz="647" spc="0" baseline="0" dirty="0" err="1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badnavirus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1 NC 034252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59" name="Content Placeholder 3">
            <a:extLst>
              <a:ext uri="{FF2B5EF4-FFF2-40B4-BE49-F238E27FC236}">
                <a16:creationId xmlns:a16="http://schemas.microsoft.com/office/drawing/2014/main" id="{28D133A1-7E90-4469-8F64-AA3E2721CEFE}"/>
              </a:ext>
            </a:extLst>
          </p:cNvPr>
          <p:cNvSpPr txBox="1"/>
          <p:nvPr/>
        </p:nvSpPr>
        <p:spPr>
          <a:xfrm>
            <a:off x="4823344" y="1578267"/>
            <a:ext cx="1367682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dirty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b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anana streak CA virus NC 015506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60" name="Content Placeholder 3">
            <a:extLst>
              <a:ext uri="{FF2B5EF4-FFF2-40B4-BE49-F238E27FC236}">
                <a16:creationId xmlns:a16="http://schemas.microsoft.com/office/drawing/2014/main" id="{AD23F52B-CE33-4BAA-A01C-1D975FD0D33E}"/>
              </a:ext>
            </a:extLst>
          </p:cNvPr>
          <p:cNvSpPr txBox="1"/>
          <p:nvPr/>
        </p:nvSpPr>
        <p:spPr>
          <a:xfrm>
            <a:off x="5137070" y="3250799"/>
            <a:ext cx="1673856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dirty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s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ugarcane bacilliform </a:t>
            </a:r>
            <a:r>
              <a:rPr lang="en-US" sz="647" spc="0" baseline="0" dirty="0" err="1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Mor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virus NC 008017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61" name="Content Placeholder 3">
            <a:extLst>
              <a:ext uri="{FF2B5EF4-FFF2-40B4-BE49-F238E27FC236}">
                <a16:creationId xmlns:a16="http://schemas.microsoft.com/office/drawing/2014/main" id="{3296E76C-12A4-4B30-8B0D-26085E2EA186}"/>
              </a:ext>
            </a:extLst>
          </p:cNvPr>
          <p:cNvSpPr txBox="1"/>
          <p:nvPr/>
        </p:nvSpPr>
        <p:spPr>
          <a:xfrm>
            <a:off x="4945166" y="5907143"/>
            <a:ext cx="1390124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dirty="0" err="1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b</a:t>
            </a:r>
            <a:r>
              <a:rPr lang="en-US" sz="647" spc="0" baseline="0" dirty="0" err="1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rinjal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err="1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badnavirus</a:t>
            </a:r>
            <a:r>
              <a:rPr lang="en-US" sz="647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A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err="1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Insanum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VR 1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62" name="Content Placeholder 3">
            <a:extLst>
              <a:ext uri="{FF2B5EF4-FFF2-40B4-BE49-F238E27FC236}">
                <a16:creationId xmlns:a16="http://schemas.microsoft.com/office/drawing/2014/main" id="{F933DE6F-96D5-466B-B3A7-DB47F2FF877B}"/>
              </a:ext>
            </a:extLst>
          </p:cNvPr>
          <p:cNvSpPr txBox="1"/>
          <p:nvPr/>
        </p:nvSpPr>
        <p:spPr>
          <a:xfrm>
            <a:off x="5421741" y="3152415"/>
            <a:ext cx="1632178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dirty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s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ugarcane bacilliform IM virus NC 003031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63" name="Content Placeholder 3">
            <a:extLst>
              <a:ext uri="{FF2B5EF4-FFF2-40B4-BE49-F238E27FC236}">
                <a16:creationId xmlns:a16="http://schemas.microsoft.com/office/drawing/2014/main" id="{066191B9-F59D-4C22-B15D-D65E8DD42948}"/>
              </a:ext>
            </a:extLst>
          </p:cNvPr>
          <p:cNvSpPr txBox="1"/>
          <p:nvPr/>
        </p:nvSpPr>
        <p:spPr>
          <a:xfrm>
            <a:off x="5096267" y="1775034"/>
            <a:ext cx="2032929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dirty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s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ugarcane bacilliform Guadeloupe A virus NC 038382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64" name="Content Placeholder 3">
            <a:extLst>
              <a:ext uri="{FF2B5EF4-FFF2-40B4-BE49-F238E27FC236}">
                <a16:creationId xmlns:a16="http://schemas.microsoft.com/office/drawing/2014/main" id="{6F996C6A-93C8-4B9C-B12E-8660B45EF0B4}"/>
              </a:ext>
            </a:extLst>
          </p:cNvPr>
          <p:cNvSpPr txBox="1"/>
          <p:nvPr/>
        </p:nvSpPr>
        <p:spPr>
          <a:xfrm>
            <a:off x="5126802" y="3067828"/>
            <a:ext cx="1385316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dirty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b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anana streak UM virus NC 015505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65" name="Content Placeholder 3">
            <a:extLst>
              <a:ext uri="{FF2B5EF4-FFF2-40B4-BE49-F238E27FC236}">
                <a16:creationId xmlns:a16="http://schemas.microsoft.com/office/drawing/2014/main" id="{7D7FA530-B1D7-452A-8791-826C4563C80B}"/>
              </a:ext>
            </a:extLst>
          </p:cNvPr>
          <p:cNvSpPr txBox="1"/>
          <p:nvPr/>
        </p:nvSpPr>
        <p:spPr>
          <a:xfrm>
            <a:off x="4855995" y="889576"/>
            <a:ext cx="1648208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spc="0" baseline="0" dirty="0" err="1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Dioscorea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bacilliform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TR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virus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NC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038995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66" name="Content Placeholder 3">
            <a:extLst>
              <a:ext uri="{FF2B5EF4-FFF2-40B4-BE49-F238E27FC236}">
                <a16:creationId xmlns:a16="http://schemas.microsoft.com/office/drawing/2014/main" id="{418C652A-24D7-4C32-88EB-15C4A37DFE68}"/>
              </a:ext>
            </a:extLst>
          </p:cNvPr>
          <p:cNvSpPr txBox="1"/>
          <p:nvPr/>
        </p:nvSpPr>
        <p:spPr>
          <a:xfrm>
            <a:off x="4955875" y="6103956"/>
            <a:ext cx="1418978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dirty="0" err="1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b</a:t>
            </a:r>
            <a:r>
              <a:rPr lang="en-US" sz="647" spc="0" baseline="0" dirty="0" err="1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rinjal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err="1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badnavirus</a:t>
            </a:r>
            <a:r>
              <a:rPr lang="en-US" sz="647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A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err="1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Melongena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Ch0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67" name="Content Placeholder 3">
            <a:extLst>
              <a:ext uri="{FF2B5EF4-FFF2-40B4-BE49-F238E27FC236}">
                <a16:creationId xmlns:a16="http://schemas.microsoft.com/office/drawing/2014/main" id="{0795F20B-D745-4439-AC3E-8E32703FBC95}"/>
              </a:ext>
            </a:extLst>
          </p:cNvPr>
          <p:cNvSpPr txBox="1"/>
          <p:nvPr/>
        </p:nvSpPr>
        <p:spPr>
          <a:xfrm>
            <a:off x="5000970" y="2365341"/>
            <a:ext cx="1505540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b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anana streak Mysore virus NC 006955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68" name="Content Placeholder 3">
            <a:extLst>
              <a:ext uri="{FF2B5EF4-FFF2-40B4-BE49-F238E27FC236}">
                <a16:creationId xmlns:a16="http://schemas.microsoft.com/office/drawing/2014/main" id="{52B0D6F7-7BCB-4E9C-BF58-D4D5E5F24AA0}"/>
              </a:ext>
            </a:extLst>
          </p:cNvPr>
          <p:cNvSpPr txBox="1"/>
          <p:nvPr/>
        </p:nvSpPr>
        <p:spPr>
          <a:xfrm>
            <a:off x="5157178" y="102504"/>
            <a:ext cx="1542410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spc="0" baseline="0" dirty="0" err="1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Aglaonema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b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acilliform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virus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MH384837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69" name="Content Placeholder 3">
            <a:extLst>
              <a:ext uri="{FF2B5EF4-FFF2-40B4-BE49-F238E27FC236}">
                <a16:creationId xmlns:a16="http://schemas.microsoft.com/office/drawing/2014/main" id="{4874D9F9-5765-4B22-B914-4B5A1980009F}"/>
              </a:ext>
            </a:extLst>
          </p:cNvPr>
          <p:cNvSpPr txBox="1"/>
          <p:nvPr/>
        </p:nvSpPr>
        <p:spPr>
          <a:xfrm>
            <a:off x="4835861" y="4431407"/>
            <a:ext cx="1680268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spc="0" baseline="0" dirty="0" err="1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Codonopsis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vein clearing virus MK044821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71" name="Content Placeholder 3">
            <a:extLst>
              <a:ext uri="{FF2B5EF4-FFF2-40B4-BE49-F238E27FC236}">
                <a16:creationId xmlns:a16="http://schemas.microsoft.com/office/drawing/2014/main" id="{60AEF2AB-2307-40CD-A86A-FA3F64AACE19}"/>
              </a:ext>
            </a:extLst>
          </p:cNvPr>
          <p:cNvSpPr txBox="1"/>
          <p:nvPr/>
        </p:nvSpPr>
        <p:spPr>
          <a:xfrm>
            <a:off x="4743275" y="4824947"/>
            <a:ext cx="1904689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Pagoda yellow mosaic associated virus NC 024301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72" name="Content Placeholder 3">
            <a:extLst>
              <a:ext uri="{FF2B5EF4-FFF2-40B4-BE49-F238E27FC236}">
                <a16:creationId xmlns:a16="http://schemas.microsoft.com/office/drawing/2014/main" id="{96559C47-450F-4426-ACBB-ED52BBD9696C}"/>
              </a:ext>
            </a:extLst>
          </p:cNvPr>
          <p:cNvSpPr txBox="1"/>
          <p:nvPr/>
        </p:nvSpPr>
        <p:spPr>
          <a:xfrm>
            <a:off x="5624851" y="1971801"/>
            <a:ext cx="1358064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banana streak GF virus NC 007002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73" name="Content Placeholder 3">
            <a:extLst>
              <a:ext uri="{FF2B5EF4-FFF2-40B4-BE49-F238E27FC236}">
                <a16:creationId xmlns:a16="http://schemas.microsoft.com/office/drawing/2014/main" id="{BA0544CD-2810-423C-A127-94A5BF499548}"/>
              </a:ext>
            </a:extLst>
          </p:cNvPr>
          <p:cNvSpPr txBox="1"/>
          <p:nvPr/>
        </p:nvSpPr>
        <p:spPr>
          <a:xfrm>
            <a:off x="4899257" y="2463725"/>
            <a:ext cx="1467068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C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anna yellow mottle virus NC 038380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74" name="Content Placeholder 3">
            <a:extLst>
              <a:ext uri="{FF2B5EF4-FFF2-40B4-BE49-F238E27FC236}">
                <a16:creationId xmlns:a16="http://schemas.microsoft.com/office/drawing/2014/main" id="{4A4A839C-6AA0-42D2-A796-4BB42C5DA31B}"/>
              </a:ext>
            </a:extLst>
          </p:cNvPr>
          <p:cNvSpPr txBox="1"/>
          <p:nvPr/>
        </p:nvSpPr>
        <p:spPr>
          <a:xfrm>
            <a:off x="5383920" y="3939489"/>
            <a:ext cx="1754006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dirty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c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acao swollen shoot Ghana L virus NC 040552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75" name="Content Placeholder 3">
            <a:extLst>
              <a:ext uri="{FF2B5EF4-FFF2-40B4-BE49-F238E27FC236}">
                <a16:creationId xmlns:a16="http://schemas.microsoft.com/office/drawing/2014/main" id="{E8CC90C4-B8C0-483C-AEF1-F229D0FC5138}"/>
              </a:ext>
            </a:extLst>
          </p:cNvPr>
          <p:cNvSpPr txBox="1"/>
          <p:nvPr/>
        </p:nvSpPr>
        <p:spPr>
          <a:xfrm>
            <a:off x="4834822" y="5120098"/>
            <a:ext cx="2398413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Bougainvillea </a:t>
            </a:r>
            <a:r>
              <a:rPr lang="en-US" sz="647" spc="0" baseline="0" dirty="0" err="1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spectabilis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chlorotic vein banding virus NC 011592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76" name="Content Placeholder 3">
            <a:extLst>
              <a:ext uri="{FF2B5EF4-FFF2-40B4-BE49-F238E27FC236}">
                <a16:creationId xmlns:a16="http://schemas.microsoft.com/office/drawing/2014/main" id="{5AF04D99-51E3-47D4-AA48-E9F393288E3B}"/>
              </a:ext>
            </a:extLst>
          </p:cNvPr>
          <p:cNvSpPr txBox="1"/>
          <p:nvPr/>
        </p:nvSpPr>
        <p:spPr>
          <a:xfrm>
            <a:off x="5079865" y="5710405"/>
            <a:ext cx="1298753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dirty="0" err="1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b</a:t>
            </a:r>
            <a:r>
              <a:rPr lang="en-US" sz="647" spc="0" baseline="0" dirty="0" err="1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rinjal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err="1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badnavirus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B virus BBVA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77" name="Content Placeholder 3">
            <a:extLst>
              <a:ext uri="{FF2B5EF4-FFF2-40B4-BE49-F238E27FC236}">
                <a16:creationId xmlns:a16="http://schemas.microsoft.com/office/drawing/2014/main" id="{FC6EB364-6785-4C9B-8BDB-597CEE1DF7B7}"/>
              </a:ext>
            </a:extLst>
          </p:cNvPr>
          <p:cNvSpPr txBox="1"/>
          <p:nvPr/>
        </p:nvSpPr>
        <p:spPr>
          <a:xfrm>
            <a:off x="4945166" y="5808788"/>
            <a:ext cx="1503752" cy="1919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sz="647" spc="0" baseline="0" dirty="0" err="1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brinjal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err="1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badnavirus</a:t>
            </a:r>
            <a:r>
              <a:rPr lang="en-US" sz="647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A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err="1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Incanum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VR 1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78" name="Content Placeholder 3">
            <a:extLst>
              <a:ext uri="{FF2B5EF4-FFF2-40B4-BE49-F238E27FC236}">
                <a16:creationId xmlns:a16="http://schemas.microsoft.com/office/drawing/2014/main" id="{4288C9AC-EEA5-47E8-97EE-C80EEB4FB755}"/>
              </a:ext>
            </a:extLst>
          </p:cNvPr>
          <p:cNvSpPr txBox="1"/>
          <p:nvPr/>
        </p:nvSpPr>
        <p:spPr>
          <a:xfrm>
            <a:off x="4568361" y="1086344"/>
            <a:ext cx="1435008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dirty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h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ibiscus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bacilliform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virus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NC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023485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79" name="Content Placeholder 3">
            <a:extLst>
              <a:ext uri="{FF2B5EF4-FFF2-40B4-BE49-F238E27FC236}">
                <a16:creationId xmlns:a16="http://schemas.microsoft.com/office/drawing/2014/main" id="{6CEAD47A-CCCA-46E3-A597-03B2CD2870FB}"/>
              </a:ext>
            </a:extLst>
          </p:cNvPr>
          <p:cNvSpPr txBox="1"/>
          <p:nvPr/>
        </p:nvSpPr>
        <p:spPr>
          <a:xfrm>
            <a:off x="4423965" y="1184733"/>
            <a:ext cx="1130438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dirty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f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ig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err="1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badnavirus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1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NC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017830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80" name="Content Placeholder 3">
            <a:extLst>
              <a:ext uri="{FF2B5EF4-FFF2-40B4-BE49-F238E27FC236}">
                <a16:creationId xmlns:a16="http://schemas.microsoft.com/office/drawing/2014/main" id="{415C2147-90D6-4A15-9E1A-D2276425B0B6}"/>
              </a:ext>
            </a:extLst>
          </p:cNvPr>
          <p:cNvSpPr txBox="1"/>
          <p:nvPr/>
        </p:nvSpPr>
        <p:spPr>
          <a:xfrm>
            <a:off x="5085151" y="2266958"/>
            <a:ext cx="1527982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dirty="0" err="1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k</a:t>
            </a:r>
            <a:r>
              <a:rPr lang="en-US" sz="647" spc="0" baseline="0" dirty="0" err="1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alanchoe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top spotting virus NC 004540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81" name="Content Placeholder 3">
            <a:extLst>
              <a:ext uri="{FF2B5EF4-FFF2-40B4-BE49-F238E27FC236}">
                <a16:creationId xmlns:a16="http://schemas.microsoft.com/office/drawing/2014/main" id="{72B8691B-273E-4EAE-A845-F26A0AE0E0CF}"/>
              </a:ext>
            </a:extLst>
          </p:cNvPr>
          <p:cNvSpPr txBox="1"/>
          <p:nvPr/>
        </p:nvSpPr>
        <p:spPr>
          <a:xfrm>
            <a:off x="4773730" y="2857259"/>
            <a:ext cx="1338828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dirty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b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anana streak UI virus NC 015503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82" name="Content Placeholder 3">
            <a:extLst>
              <a:ext uri="{FF2B5EF4-FFF2-40B4-BE49-F238E27FC236}">
                <a16:creationId xmlns:a16="http://schemas.microsoft.com/office/drawing/2014/main" id="{0BEC0277-13DA-46B9-8A5C-05194D686C0A}"/>
              </a:ext>
            </a:extLst>
          </p:cNvPr>
          <p:cNvSpPr txBox="1"/>
          <p:nvPr/>
        </p:nvSpPr>
        <p:spPr>
          <a:xfrm>
            <a:off x="4992882" y="987960"/>
            <a:ext cx="1479892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dirty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c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itrus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yellow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mosaic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virus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NC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003382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84" name="Content Placeholder 3">
            <a:extLst>
              <a:ext uri="{FF2B5EF4-FFF2-40B4-BE49-F238E27FC236}">
                <a16:creationId xmlns:a16="http://schemas.microsoft.com/office/drawing/2014/main" id="{5ACD3C6E-BF03-4D24-BDA2-B92ED9BE2BAA}"/>
              </a:ext>
            </a:extLst>
          </p:cNvPr>
          <p:cNvSpPr txBox="1"/>
          <p:nvPr/>
        </p:nvSpPr>
        <p:spPr>
          <a:xfrm>
            <a:off x="5298700" y="2660492"/>
            <a:ext cx="1802096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dirty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p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ineapple bacilliform </a:t>
            </a:r>
            <a:r>
              <a:rPr lang="en-US" sz="647" spc="0" baseline="0" dirty="0" err="1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comosus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virus NC 014648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85" name="Content Placeholder 3">
            <a:extLst>
              <a:ext uri="{FF2B5EF4-FFF2-40B4-BE49-F238E27FC236}">
                <a16:creationId xmlns:a16="http://schemas.microsoft.com/office/drawing/2014/main" id="{B0D76884-A4DC-4EA2-A67C-A6389ABA88F3}"/>
              </a:ext>
            </a:extLst>
          </p:cNvPr>
          <p:cNvSpPr txBox="1"/>
          <p:nvPr/>
        </p:nvSpPr>
        <p:spPr>
          <a:xfrm>
            <a:off x="4973904" y="1479884"/>
            <a:ext cx="1404552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dirty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m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ulberry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err="1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badnavirus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1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NC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026020 2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86" name="Content Placeholder 3">
            <a:extLst>
              <a:ext uri="{FF2B5EF4-FFF2-40B4-BE49-F238E27FC236}">
                <a16:creationId xmlns:a16="http://schemas.microsoft.com/office/drawing/2014/main" id="{273AB2FB-CD90-4BB1-8050-318260C1C599}"/>
              </a:ext>
            </a:extLst>
          </p:cNvPr>
          <p:cNvSpPr txBox="1"/>
          <p:nvPr/>
        </p:nvSpPr>
        <p:spPr>
          <a:xfrm>
            <a:off x="5058311" y="5316865"/>
            <a:ext cx="1729961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dirty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c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acao Bacilliform </a:t>
            </a:r>
            <a:r>
              <a:rPr lang="en-US" sz="647" spc="0" baseline="0" dirty="0" err="1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SriLanka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Virus NC 040809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88" name="Content Placeholder 3">
            <a:extLst>
              <a:ext uri="{FF2B5EF4-FFF2-40B4-BE49-F238E27FC236}">
                <a16:creationId xmlns:a16="http://schemas.microsoft.com/office/drawing/2014/main" id="{EB2ADFF5-5BE8-4279-AD31-4506F3A5C03E}"/>
              </a:ext>
            </a:extLst>
          </p:cNvPr>
          <p:cNvSpPr txBox="1"/>
          <p:nvPr/>
        </p:nvSpPr>
        <p:spPr>
          <a:xfrm>
            <a:off x="4989177" y="2168574"/>
            <a:ext cx="1231427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dirty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b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anana streak virus NC 007003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89" name="Content Placeholder 3">
            <a:extLst>
              <a:ext uri="{FF2B5EF4-FFF2-40B4-BE49-F238E27FC236}">
                <a16:creationId xmlns:a16="http://schemas.microsoft.com/office/drawing/2014/main" id="{84FFD992-5104-4B69-8FC9-78B1C135D684}"/>
              </a:ext>
            </a:extLst>
          </p:cNvPr>
          <p:cNvSpPr txBox="1"/>
          <p:nvPr/>
        </p:nvSpPr>
        <p:spPr>
          <a:xfrm>
            <a:off x="4739570" y="2562108"/>
            <a:ext cx="2032929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dirty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s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ugarcane bacilliform Guadeloupe D virus NC 013455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90" name="Content Placeholder 3">
            <a:extLst>
              <a:ext uri="{FF2B5EF4-FFF2-40B4-BE49-F238E27FC236}">
                <a16:creationId xmlns:a16="http://schemas.microsoft.com/office/drawing/2014/main" id="{179A6BC9-EB8E-4625-A2F4-BFE515629F06}"/>
              </a:ext>
            </a:extLst>
          </p:cNvPr>
          <p:cNvSpPr txBox="1"/>
          <p:nvPr/>
        </p:nvSpPr>
        <p:spPr>
          <a:xfrm>
            <a:off x="4553675" y="4333024"/>
            <a:ext cx="1587294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dirty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b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irch leaf roll associated virus NC 040635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91" name="Content Placeholder 3">
            <a:extLst>
              <a:ext uri="{FF2B5EF4-FFF2-40B4-BE49-F238E27FC236}">
                <a16:creationId xmlns:a16="http://schemas.microsoft.com/office/drawing/2014/main" id="{D000280D-336C-4763-BE5B-8D04EBD51D13}"/>
              </a:ext>
            </a:extLst>
          </p:cNvPr>
          <p:cNvSpPr txBox="1"/>
          <p:nvPr/>
        </p:nvSpPr>
        <p:spPr>
          <a:xfrm>
            <a:off x="4683901" y="791193"/>
            <a:ext cx="1648208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spc="0" baseline="0" dirty="0" err="1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Dioscorea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bacilliform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RT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virus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NC</a:t>
            </a:r>
            <a:r>
              <a:rPr lang="en-US" sz="647" spc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038986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92" name="Content Placeholder 3">
            <a:extLst>
              <a:ext uri="{FF2B5EF4-FFF2-40B4-BE49-F238E27FC236}">
                <a16:creationId xmlns:a16="http://schemas.microsoft.com/office/drawing/2014/main" id="{4991CBAE-645D-401A-A88D-716278BBC395}"/>
              </a:ext>
            </a:extLst>
          </p:cNvPr>
          <p:cNvSpPr txBox="1"/>
          <p:nvPr/>
        </p:nvSpPr>
        <p:spPr>
          <a:xfrm>
            <a:off x="5070285" y="4234640"/>
            <a:ext cx="1444626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cacao swollen shoot virus NC 001574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94" name="Content Placeholder 3">
            <a:extLst>
              <a:ext uri="{FF2B5EF4-FFF2-40B4-BE49-F238E27FC236}">
                <a16:creationId xmlns:a16="http://schemas.microsoft.com/office/drawing/2014/main" id="{3F321873-0831-46A1-AF78-4EE8D3312B6F}"/>
              </a:ext>
            </a:extLst>
          </p:cNvPr>
          <p:cNvSpPr txBox="1"/>
          <p:nvPr/>
        </p:nvSpPr>
        <p:spPr>
          <a:xfrm>
            <a:off x="4786970" y="4529791"/>
            <a:ext cx="1572866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dirty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g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rapevine vein clearing virus NC 015784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195" name="Content Placeholder 3">
            <a:extLst>
              <a:ext uri="{FF2B5EF4-FFF2-40B4-BE49-F238E27FC236}">
                <a16:creationId xmlns:a16="http://schemas.microsoft.com/office/drawing/2014/main" id="{D7C066CD-C3B7-4466-8618-D167098E2AE3}"/>
              </a:ext>
            </a:extLst>
          </p:cNvPr>
          <p:cNvSpPr txBox="1"/>
          <p:nvPr/>
        </p:nvSpPr>
        <p:spPr>
          <a:xfrm>
            <a:off x="4283473" y="2939676"/>
            <a:ext cx="209991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1</a:t>
            </a:r>
          </a:p>
        </p:txBody>
      </p:sp>
      <p:sp>
        <p:nvSpPr>
          <p:cNvPr id="196" name="Content Placeholder 3">
            <a:extLst>
              <a:ext uri="{FF2B5EF4-FFF2-40B4-BE49-F238E27FC236}">
                <a16:creationId xmlns:a16="http://schemas.microsoft.com/office/drawing/2014/main" id="{19507F77-1298-4BBD-8A41-2EC61974DF3C}"/>
              </a:ext>
            </a:extLst>
          </p:cNvPr>
          <p:cNvSpPr txBox="1"/>
          <p:nvPr/>
        </p:nvSpPr>
        <p:spPr>
          <a:xfrm>
            <a:off x="3318682" y="418580"/>
            <a:ext cx="209991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1</a:t>
            </a:r>
          </a:p>
        </p:txBody>
      </p:sp>
      <p:sp>
        <p:nvSpPr>
          <p:cNvPr id="197" name="Content Placeholder 3">
            <a:extLst>
              <a:ext uri="{FF2B5EF4-FFF2-40B4-BE49-F238E27FC236}">
                <a16:creationId xmlns:a16="http://schemas.microsoft.com/office/drawing/2014/main" id="{D087E52C-6F6C-4943-A8AB-AF1CBEA72610}"/>
              </a:ext>
            </a:extLst>
          </p:cNvPr>
          <p:cNvSpPr txBox="1"/>
          <p:nvPr/>
        </p:nvSpPr>
        <p:spPr>
          <a:xfrm>
            <a:off x="3361252" y="1144163"/>
            <a:ext cx="209991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1</a:t>
            </a:r>
          </a:p>
        </p:txBody>
      </p:sp>
      <p:sp>
        <p:nvSpPr>
          <p:cNvPr id="198" name="Content Placeholder 3">
            <a:extLst>
              <a:ext uri="{FF2B5EF4-FFF2-40B4-BE49-F238E27FC236}">
                <a16:creationId xmlns:a16="http://schemas.microsoft.com/office/drawing/2014/main" id="{6569EB14-8D65-4A4F-9993-C7063E698C29}"/>
              </a:ext>
            </a:extLst>
          </p:cNvPr>
          <p:cNvSpPr txBox="1"/>
          <p:nvPr/>
        </p:nvSpPr>
        <p:spPr>
          <a:xfrm>
            <a:off x="4113673" y="2521544"/>
            <a:ext cx="277770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0.52</a:t>
            </a:r>
          </a:p>
        </p:txBody>
      </p:sp>
      <p:sp>
        <p:nvSpPr>
          <p:cNvPr id="199" name="Content Placeholder 3">
            <a:extLst>
              <a:ext uri="{FF2B5EF4-FFF2-40B4-BE49-F238E27FC236}">
                <a16:creationId xmlns:a16="http://schemas.microsoft.com/office/drawing/2014/main" id="{861FBFD6-193B-4768-B319-F2CE0979461D}"/>
              </a:ext>
            </a:extLst>
          </p:cNvPr>
          <p:cNvSpPr txBox="1"/>
          <p:nvPr/>
        </p:nvSpPr>
        <p:spPr>
          <a:xfrm>
            <a:off x="3672370" y="2244838"/>
            <a:ext cx="209991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1</a:t>
            </a:r>
          </a:p>
        </p:txBody>
      </p:sp>
      <p:sp>
        <p:nvSpPr>
          <p:cNvPr id="200" name="Content Placeholder 3">
            <a:extLst>
              <a:ext uri="{FF2B5EF4-FFF2-40B4-BE49-F238E27FC236}">
                <a16:creationId xmlns:a16="http://schemas.microsoft.com/office/drawing/2014/main" id="{D391CD09-EA50-45EC-B67B-97EA7FB15CE3}"/>
              </a:ext>
            </a:extLst>
          </p:cNvPr>
          <p:cNvSpPr txBox="1"/>
          <p:nvPr/>
        </p:nvSpPr>
        <p:spPr>
          <a:xfrm>
            <a:off x="3123199" y="2790562"/>
            <a:ext cx="209991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1</a:t>
            </a:r>
          </a:p>
        </p:txBody>
      </p:sp>
      <p:sp>
        <p:nvSpPr>
          <p:cNvPr id="201" name="Content Placeholder 3">
            <a:extLst>
              <a:ext uri="{FF2B5EF4-FFF2-40B4-BE49-F238E27FC236}">
                <a16:creationId xmlns:a16="http://schemas.microsoft.com/office/drawing/2014/main" id="{427EB42D-55D9-4B89-A533-035AA6D37F68}"/>
              </a:ext>
            </a:extLst>
          </p:cNvPr>
          <p:cNvSpPr txBox="1"/>
          <p:nvPr/>
        </p:nvSpPr>
        <p:spPr>
          <a:xfrm>
            <a:off x="3102671" y="5104125"/>
            <a:ext cx="250658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0.9</a:t>
            </a:r>
          </a:p>
        </p:txBody>
      </p:sp>
      <p:sp>
        <p:nvSpPr>
          <p:cNvPr id="202" name="Content Placeholder 3">
            <a:extLst>
              <a:ext uri="{FF2B5EF4-FFF2-40B4-BE49-F238E27FC236}">
                <a16:creationId xmlns:a16="http://schemas.microsoft.com/office/drawing/2014/main" id="{4C1DE0E8-EED1-45F8-BE94-9514364C1BFE}"/>
              </a:ext>
            </a:extLst>
          </p:cNvPr>
          <p:cNvSpPr txBox="1"/>
          <p:nvPr/>
        </p:nvSpPr>
        <p:spPr>
          <a:xfrm>
            <a:off x="2866860" y="5546854"/>
            <a:ext cx="277770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0.51</a:t>
            </a:r>
          </a:p>
        </p:txBody>
      </p:sp>
      <p:sp>
        <p:nvSpPr>
          <p:cNvPr id="203" name="Content Placeholder 3">
            <a:extLst>
              <a:ext uri="{FF2B5EF4-FFF2-40B4-BE49-F238E27FC236}">
                <a16:creationId xmlns:a16="http://schemas.microsoft.com/office/drawing/2014/main" id="{216BBA70-FAF0-4ED3-ACE3-82948D58D6DB}"/>
              </a:ext>
            </a:extLst>
          </p:cNvPr>
          <p:cNvSpPr txBox="1"/>
          <p:nvPr/>
        </p:nvSpPr>
        <p:spPr>
          <a:xfrm>
            <a:off x="3657960" y="750629"/>
            <a:ext cx="277770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0.87</a:t>
            </a:r>
          </a:p>
        </p:txBody>
      </p:sp>
      <p:sp>
        <p:nvSpPr>
          <p:cNvPr id="204" name="Content Placeholder 3">
            <a:extLst>
              <a:ext uri="{FF2B5EF4-FFF2-40B4-BE49-F238E27FC236}">
                <a16:creationId xmlns:a16="http://schemas.microsoft.com/office/drawing/2014/main" id="{02AD5B1A-B697-4B94-B9F0-E55A1CECB583}"/>
              </a:ext>
            </a:extLst>
          </p:cNvPr>
          <p:cNvSpPr txBox="1"/>
          <p:nvPr/>
        </p:nvSpPr>
        <p:spPr>
          <a:xfrm>
            <a:off x="2618975" y="3935752"/>
            <a:ext cx="209991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1</a:t>
            </a:r>
          </a:p>
        </p:txBody>
      </p:sp>
      <p:sp>
        <p:nvSpPr>
          <p:cNvPr id="205" name="Content Placeholder 3">
            <a:extLst>
              <a:ext uri="{FF2B5EF4-FFF2-40B4-BE49-F238E27FC236}">
                <a16:creationId xmlns:a16="http://schemas.microsoft.com/office/drawing/2014/main" id="{61953F41-C040-44F9-B74A-593F2B99440D}"/>
              </a:ext>
            </a:extLst>
          </p:cNvPr>
          <p:cNvSpPr txBox="1"/>
          <p:nvPr/>
        </p:nvSpPr>
        <p:spPr>
          <a:xfrm>
            <a:off x="3919817" y="652242"/>
            <a:ext cx="277770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0.99</a:t>
            </a:r>
          </a:p>
        </p:txBody>
      </p:sp>
      <p:sp>
        <p:nvSpPr>
          <p:cNvPr id="206" name="Content Placeholder 3">
            <a:extLst>
              <a:ext uri="{FF2B5EF4-FFF2-40B4-BE49-F238E27FC236}">
                <a16:creationId xmlns:a16="http://schemas.microsoft.com/office/drawing/2014/main" id="{915F62D6-5559-418A-95DC-FBC206B9F49D}"/>
              </a:ext>
            </a:extLst>
          </p:cNvPr>
          <p:cNvSpPr txBox="1"/>
          <p:nvPr/>
        </p:nvSpPr>
        <p:spPr>
          <a:xfrm>
            <a:off x="4368445" y="5842010"/>
            <a:ext cx="209991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1</a:t>
            </a:r>
          </a:p>
        </p:txBody>
      </p:sp>
      <p:sp>
        <p:nvSpPr>
          <p:cNvPr id="207" name="Content Placeholder 3">
            <a:extLst>
              <a:ext uri="{FF2B5EF4-FFF2-40B4-BE49-F238E27FC236}">
                <a16:creationId xmlns:a16="http://schemas.microsoft.com/office/drawing/2014/main" id="{3BCB1DCE-D87E-41ED-81AD-3C855B518D68}"/>
              </a:ext>
            </a:extLst>
          </p:cNvPr>
          <p:cNvSpPr txBox="1"/>
          <p:nvPr/>
        </p:nvSpPr>
        <p:spPr>
          <a:xfrm>
            <a:off x="4527278" y="2128004"/>
            <a:ext cx="209991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1</a:t>
            </a:r>
          </a:p>
        </p:txBody>
      </p:sp>
      <p:sp>
        <p:nvSpPr>
          <p:cNvPr id="208" name="Content Placeholder 3">
            <a:extLst>
              <a:ext uri="{FF2B5EF4-FFF2-40B4-BE49-F238E27FC236}">
                <a16:creationId xmlns:a16="http://schemas.microsoft.com/office/drawing/2014/main" id="{2F892CC2-CE16-4068-B3B2-02C55833A00A}"/>
              </a:ext>
            </a:extLst>
          </p:cNvPr>
          <p:cNvSpPr txBox="1"/>
          <p:nvPr/>
        </p:nvSpPr>
        <p:spPr>
          <a:xfrm>
            <a:off x="3154906" y="3407002"/>
            <a:ext cx="277770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0.85</a:t>
            </a:r>
          </a:p>
        </p:txBody>
      </p:sp>
      <p:sp>
        <p:nvSpPr>
          <p:cNvPr id="209" name="Content Placeholder 3">
            <a:extLst>
              <a:ext uri="{FF2B5EF4-FFF2-40B4-BE49-F238E27FC236}">
                <a16:creationId xmlns:a16="http://schemas.microsoft.com/office/drawing/2014/main" id="{12389384-6358-449F-804E-8EB9EBFF8B41}"/>
              </a:ext>
            </a:extLst>
          </p:cNvPr>
          <p:cNvSpPr txBox="1"/>
          <p:nvPr/>
        </p:nvSpPr>
        <p:spPr>
          <a:xfrm>
            <a:off x="2982703" y="5251703"/>
            <a:ext cx="277770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0.78</a:t>
            </a:r>
          </a:p>
        </p:txBody>
      </p:sp>
      <p:sp>
        <p:nvSpPr>
          <p:cNvPr id="210" name="Content Placeholder 3">
            <a:extLst>
              <a:ext uri="{FF2B5EF4-FFF2-40B4-BE49-F238E27FC236}">
                <a16:creationId xmlns:a16="http://schemas.microsoft.com/office/drawing/2014/main" id="{01494766-F992-4A6A-AE8A-A9055207F729}"/>
              </a:ext>
            </a:extLst>
          </p:cNvPr>
          <p:cNvSpPr txBox="1"/>
          <p:nvPr/>
        </p:nvSpPr>
        <p:spPr>
          <a:xfrm>
            <a:off x="3923472" y="2164900"/>
            <a:ext cx="277770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0.52</a:t>
            </a:r>
          </a:p>
        </p:txBody>
      </p:sp>
      <p:sp>
        <p:nvSpPr>
          <p:cNvPr id="211" name="Content Placeholder 3">
            <a:extLst>
              <a:ext uri="{FF2B5EF4-FFF2-40B4-BE49-F238E27FC236}">
                <a16:creationId xmlns:a16="http://schemas.microsoft.com/office/drawing/2014/main" id="{ABC0FC5D-E2AC-4582-A928-F3D67D8841DA}"/>
              </a:ext>
            </a:extLst>
          </p:cNvPr>
          <p:cNvSpPr txBox="1"/>
          <p:nvPr/>
        </p:nvSpPr>
        <p:spPr>
          <a:xfrm>
            <a:off x="3855341" y="2521544"/>
            <a:ext cx="277770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0.82</a:t>
            </a:r>
          </a:p>
        </p:txBody>
      </p:sp>
      <p:sp>
        <p:nvSpPr>
          <p:cNvPr id="212" name="Content Placeholder 3">
            <a:extLst>
              <a:ext uri="{FF2B5EF4-FFF2-40B4-BE49-F238E27FC236}">
                <a16:creationId xmlns:a16="http://schemas.microsoft.com/office/drawing/2014/main" id="{42CA80ED-3D13-4719-9492-F44AB1292BBD}"/>
              </a:ext>
            </a:extLst>
          </p:cNvPr>
          <p:cNvSpPr txBox="1"/>
          <p:nvPr/>
        </p:nvSpPr>
        <p:spPr>
          <a:xfrm>
            <a:off x="3811909" y="1439313"/>
            <a:ext cx="209991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1</a:t>
            </a:r>
          </a:p>
        </p:txBody>
      </p:sp>
      <p:sp>
        <p:nvSpPr>
          <p:cNvPr id="213" name="Content Placeholder 3">
            <a:extLst>
              <a:ext uri="{FF2B5EF4-FFF2-40B4-BE49-F238E27FC236}">
                <a16:creationId xmlns:a16="http://schemas.microsoft.com/office/drawing/2014/main" id="{F84B75C1-CC68-4985-A8F1-A1F958503579}"/>
              </a:ext>
            </a:extLst>
          </p:cNvPr>
          <p:cNvSpPr txBox="1"/>
          <p:nvPr/>
        </p:nvSpPr>
        <p:spPr>
          <a:xfrm>
            <a:off x="2739603" y="5110277"/>
            <a:ext cx="277770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0.82</a:t>
            </a:r>
          </a:p>
        </p:txBody>
      </p:sp>
      <p:sp>
        <p:nvSpPr>
          <p:cNvPr id="214" name="Content Placeholder 3">
            <a:extLst>
              <a:ext uri="{FF2B5EF4-FFF2-40B4-BE49-F238E27FC236}">
                <a16:creationId xmlns:a16="http://schemas.microsoft.com/office/drawing/2014/main" id="{946F3820-7B71-4606-ADC3-55FE8C73062B}"/>
              </a:ext>
            </a:extLst>
          </p:cNvPr>
          <p:cNvSpPr txBox="1"/>
          <p:nvPr/>
        </p:nvSpPr>
        <p:spPr>
          <a:xfrm>
            <a:off x="4329897" y="455474"/>
            <a:ext cx="209991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1</a:t>
            </a:r>
          </a:p>
        </p:txBody>
      </p:sp>
      <p:sp>
        <p:nvSpPr>
          <p:cNvPr id="215" name="Content Placeholder 3">
            <a:extLst>
              <a:ext uri="{FF2B5EF4-FFF2-40B4-BE49-F238E27FC236}">
                <a16:creationId xmlns:a16="http://schemas.microsoft.com/office/drawing/2014/main" id="{A1D84CA6-FEAD-49FD-A816-AFFF1803F15D}"/>
              </a:ext>
            </a:extLst>
          </p:cNvPr>
          <p:cNvSpPr txBox="1"/>
          <p:nvPr/>
        </p:nvSpPr>
        <p:spPr>
          <a:xfrm>
            <a:off x="4446779" y="3013462"/>
            <a:ext cx="277770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0.98</a:t>
            </a:r>
          </a:p>
        </p:txBody>
      </p:sp>
      <p:sp>
        <p:nvSpPr>
          <p:cNvPr id="216" name="Content Placeholder 3">
            <a:extLst>
              <a:ext uri="{FF2B5EF4-FFF2-40B4-BE49-F238E27FC236}">
                <a16:creationId xmlns:a16="http://schemas.microsoft.com/office/drawing/2014/main" id="{AD5530C8-4146-4679-B5F9-6716FBD56997}"/>
              </a:ext>
            </a:extLst>
          </p:cNvPr>
          <p:cNvSpPr txBox="1"/>
          <p:nvPr/>
        </p:nvSpPr>
        <p:spPr>
          <a:xfrm>
            <a:off x="4704822" y="3210229"/>
            <a:ext cx="209991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1</a:t>
            </a:r>
          </a:p>
        </p:txBody>
      </p:sp>
      <p:sp>
        <p:nvSpPr>
          <p:cNvPr id="217" name="Content Placeholder 3">
            <a:extLst>
              <a:ext uri="{FF2B5EF4-FFF2-40B4-BE49-F238E27FC236}">
                <a16:creationId xmlns:a16="http://schemas.microsoft.com/office/drawing/2014/main" id="{8190FD94-95F0-4101-90D1-E579EB4A6AA9}"/>
              </a:ext>
            </a:extLst>
          </p:cNvPr>
          <p:cNvSpPr txBox="1"/>
          <p:nvPr/>
        </p:nvSpPr>
        <p:spPr>
          <a:xfrm>
            <a:off x="2975952" y="3571996"/>
            <a:ext cx="277770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0.94</a:t>
            </a:r>
          </a:p>
        </p:txBody>
      </p:sp>
      <p:sp>
        <p:nvSpPr>
          <p:cNvPr id="218" name="Content Placeholder 3">
            <a:extLst>
              <a:ext uri="{FF2B5EF4-FFF2-40B4-BE49-F238E27FC236}">
                <a16:creationId xmlns:a16="http://schemas.microsoft.com/office/drawing/2014/main" id="{7F170BDB-5386-4932-8905-9B4BD7AAC6BF}"/>
              </a:ext>
            </a:extLst>
          </p:cNvPr>
          <p:cNvSpPr txBox="1"/>
          <p:nvPr/>
        </p:nvSpPr>
        <p:spPr>
          <a:xfrm>
            <a:off x="4905213" y="5915768"/>
            <a:ext cx="209991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1</a:t>
            </a:r>
          </a:p>
        </p:txBody>
      </p:sp>
      <p:sp>
        <p:nvSpPr>
          <p:cNvPr id="219" name="Content Placeholder 3">
            <a:extLst>
              <a:ext uri="{FF2B5EF4-FFF2-40B4-BE49-F238E27FC236}">
                <a16:creationId xmlns:a16="http://schemas.microsoft.com/office/drawing/2014/main" id="{2056355C-0022-451B-AF02-B1D2689058C0}"/>
              </a:ext>
            </a:extLst>
          </p:cNvPr>
          <p:cNvSpPr txBox="1"/>
          <p:nvPr/>
        </p:nvSpPr>
        <p:spPr>
          <a:xfrm>
            <a:off x="2867560" y="2761227"/>
            <a:ext cx="209991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1</a:t>
            </a:r>
          </a:p>
        </p:txBody>
      </p:sp>
      <p:sp>
        <p:nvSpPr>
          <p:cNvPr id="220" name="Content Placeholder 3">
            <a:extLst>
              <a:ext uri="{FF2B5EF4-FFF2-40B4-BE49-F238E27FC236}">
                <a16:creationId xmlns:a16="http://schemas.microsoft.com/office/drawing/2014/main" id="{96CAAD71-C182-477E-86C0-6412950171E7}"/>
              </a:ext>
            </a:extLst>
          </p:cNvPr>
          <p:cNvSpPr txBox="1"/>
          <p:nvPr/>
        </p:nvSpPr>
        <p:spPr>
          <a:xfrm>
            <a:off x="4020776" y="3736996"/>
            <a:ext cx="209991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1</a:t>
            </a:r>
          </a:p>
        </p:txBody>
      </p:sp>
      <p:sp>
        <p:nvSpPr>
          <p:cNvPr id="221" name="Content Placeholder 3">
            <a:extLst>
              <a:ext uri="{FF2B5EF4-FFF2-40B4-BE49-F238E27FC236}">
                <a16:creationId xmlns:a16="http://schemas.microsoft.com/office/drawing/2014/main" id="{0AA93A7C-80BA-4B10-8C52-D96CD15CEAD4}"/>
              </a:ext>
            </a:extLst>
          </p:cNvPr>
          <p:cNvSpPr txBox="1"/>
          <p:nvPr/>
        </p:nvSpPr>
        <p:spPr>
          <a:xfrm>
            <a:off x="3960669" y="1242546"/>
            <a:ext cx="209991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1</a:t>
            </a:r>
          </a:p>
        </p:txBody>
      </p:sp>
      <p:sp>
        <p:nvSpPr>
          <p:cNvPr id="222" name="Content Placeholder 3">
            <a:extLst>
              <a:ext uri="{FF2B5EF4-FFF2-40B4-BE49-F238E27FC236}">
                <a16:creationId xmlns:a16="http://schemas.microsoft.com/office/drawing/2014/main" id="{AFABA105-EA76-47AA-BA46-63802DC9C10D}"/>
              </a:ext>
            </a:extLst>
          </p:cNvPr>
          <p:cNvSpPr txBox="1"/>
          <p:nvPr/>
        </p:nvSpPr>
        <p:spPr>
          <a:xfrm>
            <a:off x="2955804" y="1950453"/>
            <a:ext cx="277770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0.99</a:t>
            </a:r>
          </a:p>
        </p:txBody>
      </p:sp>
      <p:sp>
        <p:nvSpPr>
          <p:cNvPr id="223" name="Content Placeholder 3">
            <a:extLst>
              <a:ext uri="{FF2B5EF4-FFF2-40B4-BE49-F238E27FC236}">
                <a16:creationId xmlns:a16="http://schemas.microsoft.com/office/drawing/2014/main" id="{64DBB913-BDFC-443A-9874-4CFB94A2EF42}"/>
              </a:ext>
            </a:extLst>
          </p:cNvPr>
          <p:cNvSpPr txBox="1"/>
          <p:nvPr/>
        </p:nvSpPr>
        <p:spPr>
          <a:xfrm>
            <a:off x="3536442" y="234110"/>
            <a:ext cx="209991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1</a:t>
            </a:r>
          </a:p>
        </p:txBody>
      </p:sp>
      <p:sp>
        <p:nvSpPr>
          <p:cNvPr id="224" name="Content Placeholder 3">
            <a:extLst>
              <a:ext uri="{FF2B5EF4-FFF2-40B4-BE49-F238E27FC236}">
                <a16:creationId xmlns:a16="http://schemas.microsoft.com/office/drawing/2014/main" id="{2177F0E9-5EB5-4CA1-9740-DB60099ABAE0}"/>
              </a:ext>
            </a:extLst>
          </p:cNvPr>
          <p:cNvSpPr txBox="1"/>
          <p:nvPr/>
        </p:nvSpPr>
        <p:spPr>
          <a:xfrm>
            <a:off x="4965861" y="3898919"/>
            <a:ext cx="277770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0.86</a:t>
            </a:r>
          </a:p>
        </p:txBody>
      </p:sp>
      <p:sp>
        <p:nvSpPr>
          <p:cNvPr id="225" name="Content Placeholder 3">
            <a:extLst>
              <a:ext uri="{FF2B5EF4-FFF2-40B4-BE49-F238E27FC236}">
                <a16:creationId xmlns:a16="http://schemas.microsoft.com/office/drawing/2014/main" id="{08D5C81C-616B-49C4-AEEA-6E1DA859A298}"/>
              </a:ext>
            </a:extLst>
          </p:cNvPr>
          <p:cNvSpPr txBox="1"/>
          <p:nvPr/>
        </p:nvSpPr>
        <p:spPr>
          <a:xfrm>
            <a:off x="3474090" y="5473068"/>
            <a:ext cx="209991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1</a:t>
            </a:r>
          </a:p>
        </p:txBody>
      </p:sp>
      <p:sp>
        <p:nvSpPr>
          <p:cNvPr id="226" name="Content Placeholder 3">
            <a:extLst>
              <a:ext uri="{FF2B5EF4-FFF2-40B4-BE49-F238E27FC236}">
                <a16:creationId xmlns:a16="http://schemas.microsoft.com/office/drawing/2014/main" id="{DC07497B-2D88-41A6-A08E-17A0C72AC827}"/>
              </a:ext>
            </a:extLst>
          </p:cNvPr>
          <p:cNvSpPr txBox="1"/>
          <p:nvPr/>
        </p:nvSpPr>
        <p:spPr>
          <a:xfrm>
            <a:off x="4211008" y="3919417"/>
            <a:ext cx="209991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1</a:t>
            </a:r>
          </a:p>
        </p:txBody>
      </p:sp>
      <p:sp>
        <p:nvSpPr>
          <p:cNvPr id="227" name="Content Placeholder 3">
            <a:extLst>
              <a:ext uri="{FF2B5EF4-FFF2-40B4-BE49-F238E27FC236}">
                <a16:creationId xmlns:a16="http://schemas.microsoft.com/office/drawing/2014/main" id="{589AEF15-6496-4560-A2AA-92513149E332}"/>
              </a:ext>
            </a:extLst>
          </p:cNvPr>
          <p:cNvSpPr txBox="1"/>
          <p:nvPr/>
        </p:nvSpPr>
        <p:spPr>
          <a:xfrm>
            <a:off x="4445939" y="1660678"/>
            <a:ext cx="209991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1</a:t>
            </a:r>
          </a:p>
        </p:txBody>
      </p:sp>
      <p:sp>
        <p:nvSpPr>
          <p:cNvPr id="228" name="Content Placeholder 3">
            <a:extLst>
              <a:ext uri="{FF2B5EF4-FFF2-40B4-BE49-F238E27FC236}">
                <a16:creationId xmlns:a16="http://schemas.microsoft.com/office/drawing/2014/main" id="{4A1AA3BA-A735-4C1B-B955-399B3BD76412}"/>
              </a:ext>
            </a:extLst>
          </p:cNvPr>
          <p:cNvSpPr txBox="1"/>
          <p:nvPr/>
        </p:nvSpPr>
        <p:spPr>
          <a:xfrm>
            <a:off x="4684850" y="6014203"/>
            <a:ext cx="209991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1</a:t>
            </a:r>
          </a:p>
        </p:txBody>
      </p:sp>
      <p:sp>
        <p:nvSpPr>
          <p:cNvPr id="229" name="Content Placeholder 3">
            <a:extLst>
              <a:ext uri="{FF2B5EF4-FFF2-40B4-BE49-F238E27FC236}">
                <a16:creationId xmlns:a16="http://schemas.microsoft.com/office/drawing/2014/main" id="{4F002783-D523-4FA4-BD35-2031E2A6C5C2}"/>
              </a:ext>
            </a:extLst>
          </p:cNvPr>
          <p:cNvSpPr txBox="1"/>
          <p:nvPr/>
        </p:nvSpPr>
        <p:spPr>
          <a:xfrm>
            <a:off x="4232173" y="1771360"/>
            <a:ext cx="209991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1</a:t>
            </a:r>
          </a:p>
        </p:txBody>
      </p:sp>
      <p:sp>
        <p:nvSpPr>
          <p:cNvPr id="230" name="Content Placeholder 3">
            <a:extLst>
              <a:ext uri="{FF2B5EF4-FFF2-40B4-BE49-F238E27FC236}">
                <a16:creationId xmlns:a16="http://schemas.microsoft.com/office/drawing/2014/main" id="{EC5A05CC-B391-456F-A174-33910CE455EA}"/>
              </a:ext>
            </a:extLst>
          </p:cNvPr>
          <p:cNvSpPr txBox="1"/>
          <p:nvPr/>
        </p:nvSpPr>
        <p:spPr>
          <a:xfrm>
            <a:off x="3927517" y="3074955"/>
            <a:ext cx="209991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1</a:t>
            </a:r>
          </a:p>
        </p:txBody>
      </p:sp>
      <p:sp>
        <p:nvSpPr>
          <p:cNvPr id="231" name="Content Placeholder 3">
            <a:extLst>
              <a:ext uri="{FF2B5EF4-FFF2-40B4-BE49-F238E27FC236}">
                <a16:creationId xmlns:a16="http://schemas.microsoft.com/office/drawing/2014/main" id="{60497EF5-155F-494D-BE3F-9E28D3E2CCAA}"/>
              </a:ext>
            </a:extLst>
          </p:cNvPr>
          <p:cNvSpPr txBox="1"/>
          <p:nvPr/>
        </p:nvSpPr>
        <p:spPr>
          <a:xfrm>
            <a:off x="2900925" y="4673695"/>
            <a:ext cx="209991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1</a:t>
            </a:r>
          </a:p>
        </p:txBody>
      </p:sp>
      <p:sp>
        <p:nvSpPr>
          <p:cNvPr id="232" name="Content Placeholder 3">
            <a:extLst>
              <a:ext uri="{FF2B5EF4-FFF2-40B4-BE49-F238E27FC236}">
                <a16:creationId xmlns:a16="http://schemas.microsoft.com/office/drawing/2014/main" id="{8120E79C-6D33-4CFA-A1C3-CB5EE51EB92D}"/>
              </a:ext>
            </a:extLst>
          </p:cNvPr>
          <p:cNvSpPr txBox="1"/>
          <p:nvPr/>
        </p:nvSpPr>
        <p:spPr>
          <a:xfrm>
            <a:off x="3164472" y="781372"/>
            <a:ext cx="209991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1</a:t>
            </a:r>
          </a:p>
        </p:txBody>
      </p:sp>
      <p:sp>
        <p:nvSpPr>
          <p:cNvPr id="233" name="Content Placeholder 3">
            <a:extLst>
              <a:ext uri="{FF2B5EF4-FFF2-40B4-BE49-F238E27FC236}">
                <a16:creationId xmlns:a16="http://schemas.microsoft.com/office/drawing/2014/main" id="{90975C92-195E-44F2-A543-B9B99D29424D}"/>
              </a:ext>
            </a:extLst>
          </p:cNvPr>
          <p:cNvSpPr txBox="1"/>
          <p:nvPr/>
        </p:nvSpPr>
        <p:spPr>
          <a:xfrm>
            <a:off x="4416333" y="3702152"/>
            <a:ext cx="209991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1</a:t>
            </a:r>
          </a:p>
        </p:txBody>
      </p:sp>
      <p:sp>
        <p:nvSpPr>
          <p:cNvPr id="234" name="Content Placeholder 3">
            <a:extLst>
              <a:ext uri="{FF2B5EF4-FFF2-40B4-BE49-F238E27FC236}">
                <a16:creationId xmlns:a16="http://schemas.microsoft.com/office/drawing/2014/main" id="{43E4D1C0-9419-4919-B52F-D2EA2F66CD75}"/>
              </a:ext>
            </a:extLst>
          </p:cNvPr>
          <p:cNvSpPr txBox="1"/>
          <p:nvPr/>
        </p:nvSpPr>
        <p:spPr>
          <a:xfrm>
            <a:off x="4591134" y="5669835"/>
            <a:ext cx="209991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1</a:t>
            </a:r>
          </a:p>
        </p:txBody>
      </p:sp>
      <p:sp>
        <p:nvSpPr>
          <p:cNvPr id="235" name="Content Placeholder 3">
            <a:extLst>
              <a:ext uri="{FF2B5EF4-FFF2-40B4-BE49-F238E27FC236}">
                <a16:creationId xmlns:a16="http://schemas.microsoft.com/office/drawing/2014/main" id="{F4A210B4-1248-444F-95CD-6051DD23280F}"/>
              </a:ext>
            </a:extLst>
          </p:cNvPr>
          <p:cNvSpPr txBox="1"/>
          <p:nvPr/>
        </p:nvSpPr>
        <p:spPr>
          <a:xfrm>
            <a:off x="1839247" y="5073347"/>
            <a:ext cx="209991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1</a:t>
            </a:r>
          </a:p>
        </p:txBody>
      </p:sp>
      <p:sp>
        <p:nvSpPr>
          <p:cNvPr id="236" name="Content Placeholder 3">
            <a:extLst>
              <a:ext uri="{FF2B5EF4-FFF2-40B4-BE49-F238E27FC236}">
                <a16:creationId xmlns:a16="http://schemas.microsoft.com/office/drawing/2014/main" id="{4F61B47A-14BE-4442-9642-6F142C4735A2}"/>
              </a:ext>
            </a:extLst>
          </p:cNvPr>
          <p:cNvSpPr txBox="1"/>
          <p:nvPr/>
        </p:nvSpPr>
        <p:spPr>
          <a:xfrm>
            <a:off x="3076400" y="4464629"/>
            <a:ext cx="277770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0.77</a:t>
            </a:r>
          </a:p>
        </p:txBody>
      </p:sp>
      <p:sp>
        <p:nvSpPr>
          <p:cNvPr id="237" name="Content Placeholder 3">
            <a:extLst>
              <a:ext uri="{FF2B5EF4-FFF2-40B4-BE49-F238E27FC236}">
                <a16:creationId xmlns:a16="http://schemas.microsoft.com/office/drawing/2014/main" id="{7A3663B6-FDDE-4C0D-B253-5247187E10F2}"/>
              </a:ext>
            </a:extLst>
          </p:cNvPr>
          <p:cNvSpPr txBox="1"/>
          <p:nvPr/>
        </p:nvSpPr>
        <p:spPr>
          <a:xfrm>
            <a:off x="3882819" y="160321"/>
            <a:ext cx="209991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1</a:t>
            </a:r>
          </a:p>
        </p:txBody>
      </p:sp>
      <p:sp>
        <p:nvSpPr>
          <p:cNvPr id="238" name="Content Placeholder 3">
            <a:extLst>
              <a:ext uri="{FF2B5EF4-FFF2-40B4-BE49-F238E27FC236}">
                <a16:creationId xmlns:a16="http://schemas.microsoft.com/office/drawing/2014/main" id="{C4611638-F134-401B-88EB-7B78472F723D}"/>
              </a:ext>
            </a:extLst>
          </p:cNvPr>
          <p:cNvSpPr txBox="1"/>
          <p:nvPr/>
        </p:nvSpPr>
        <p:spPr>
          <a:xfrm>
            <a:off x="3070264" y="1110343"/>
            <a:ext cx="209991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1</a:t>
            </a:r>
          </a:p>
        </p:txBody>
      </p:sp>
      <p:sp>
        <p:nvSpPr>
          <p:cNvPr id="239" name="Content Placeholder 3">
            <a:extLst>
              <a:ext uri="{FF2B5EF4-FFF2-40B4-BE49-F238E27FC236}">
                <a16:creationId xmlns:a16="http://schemas.microsoft.com/office/drawing/2014/main" id="{D7A789C1-18D6-45FA-8CE0-6447AF3B8EF1}"/>
              </a:ext>
            </a:extLst>
          </p:cNvPr>
          <p:cNvSpPr txBox="1"/>
          <p:nvPr/>
        </p:nvSpPr>
        <p:spPr>
          <a:xfrm>
            <a:off x="3945071" y="4882761"/>
            <a:ext cx="209991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1</a:t>
            </a:r>
          </a:p>
        </p:txBody>
      </p:sp>
      <p:sp>
        <p:nvSpPr>
          <p:cNvPr id="240" name="Content Placeholder 3">
            <a:extLst>
              <a:ext uri="{FF2B5EF4-FFF2-40B4-BE49-F238E27FC236}">
                <a16:creationId xmlns:a16="http://schemas.microsoft.com/office/drawing/2014/main" id="{65DC268B-00F7-4BF0-82F0-E75D56D61B38}"/>
              </a:ext>
            </a:extLst>
          </p:cNvPr>
          <p:cNvSpPr txBox="1"/>
          <p:nvPr/>
        </p:nvSpPr>
        <p:spPr>
          <a:xfrm>
            <a:off x="3822694" y="1968133"/>
            <a:ext cx="209991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1</a:t>
            </a:r>
          </a:p>
        </p:txBody>
      </p:sp>
      <p:sp>
        <p:nvSpPr>
          <p:cNvPr id="241" name="Content Placeholder 3">
            <a:extLst>
              <a:ext uri="{FF2B5EF4-FFF2-40B4-BE49-F238E27FC236}">
                <a16:creationId xmlns:a16="http://schemas.microsoft.com/office/drawing/2014/main" id="{417DA1ED-F0F7-4DBE-886C-BBA37A2FFED3}"/>
              </a:ext>
            </a:extLst>
          </p:cNvPr>
          <p:cNvSpPr txBox="1"/>
          <p:nvPr/>
        </p:nvSpPr>
        <p:spPr>
          <a:xfrm>
            <a:off x="3156817" y="5399281"/>
            <a:ext cx="277770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0.87</a:t>
            </a:r>
          </a:p>
        </p:txBody>
      </p:sp>
      <p:sp>
        <p:nvSpPr>
          <p:cNvPr id="242" name="Content Placeholder 3">
            <a:extLst>
              <a:ext uri="{FF2B5EF4-FFF2-40B4-BE49-F238E27FC236}">
                <a16:creationId xmlns:a16="http://schemas.microsoft.com/office/drawing/2014/main" id="{6A52522E-61CD-4FAA-B6ED-DD30C56ADA60}"/>
              </a:ext>
            </a:extLst>
          </p:cNvPr>
          <p:cNvSpPr txBox="1"/>
          <p:nvPr/>
        </p:nvSpPr>
        <p:spPr>
          <a:xfrm>
            <a:off x="3706829" y="1045779"/>
            <a:ext cx="209991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1</a:t>
            </a:r>
          </a:p>
        </p:txBody>
      </p:sp>
      <p:sp>
        <p:nvSpPr>
          <p:cNvPr id="243" name="Content Placeholder 3">
            <a:extLst>
              <a:ext uri="{FF2B5EF4-FFF2-40B4-BE49-F238E27FC236}">
                <a16:creationId xmlns:a16="http://schemas.microsoft.com/office/drawing/2014/main" id="{14A51EFE-F4B0-40FE-8210-B01C19D53806}"/>
              </a:ext>
            </a:extLst>
          </p:cNvPr>
          <p:cNvSpPr txBox="1"/>
          <p:nvPr/>
        </p:nvSpPr>
        <p:spPr>
          <a:xfrm>
            <a:off x="4131671" y="2054218"/>
            <a:ext cx="277770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0.94</a:t>
            </a:r>
          </a:p>
        </p:txBody>
      </p:sp>
      <p:sp>
        <p:nvSpPr>
          <p:cNvPr id="244" name="Content Placeholder 3">
            <a:extLst>
              <a:ext uri="{FF2B5EF4-FFF2-40B4-BE49-F238E27FC236}">
                <a16:creationId xmlns:a16="http://schemas.microsoft.com/office/drawing/2014/main" id="{B88C8378-8ACB-4AA0-A270-A262A895E3FB}"/>
              </a:ext>
            </a:extLst>
          </p:cNvPr>
          <p:cNvSpPr txBox="1"/>
          <p:nvPr/>
        </p:nvSpPr>
        <p:spPr>
          <a:xfrm>
            <a:off x="4388087" y="4136682"/>
            <a:ext cx="209991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1</a:t>
            </a:r>
          </a:p>
        </p:txBody>
      </p:sp>
      <p:sp>
        <p:nvSpPr>
          <p:cNvPr id="245" name="Content Placeholder 3">
            <a:extLst>
              <a:ext uri="{FF2B5EF4-FFF2-40B4-BE49-F238E27FC236}">
                <a16:creationId xmlns:a16="http://schemas.microsoft.com/office/drawing/2014/main" id="{F9077B08-2A85-4C87-A4B9-E74BA8E6EBA8}"/>
              </a:ext>
            </a:extLst>
          </p:cNvPr>
          <p:cNvSpPr txBox="1"/>
          <p:nvPr/>
        </p:nvSpPr>
        <p:spPr>
          <a:xfrm>
            <a:off x="3322663" y="2506169"/>
            <a:ext cx="277770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0.98</a:t>
            </a:r>
          </a:p>
        </p:txBody>
      </p:sp>
      <p:sp>
        <p:nvSpPr>
          <p:cNvPr id="246" name="Content Placeholder 3">
            <a:extLst>
              <a:ext uri="{FF2B5EF4-FFF2-40B4-BE49-F238E27FC236}">
                <a16:creationId xmlns:a16="http://schemas.microsoft.com/office/drawing/2014/main" id="{795C41C6-CDAE-4F8C-B756-D507156A9375}"/>
              </a:ext>
            </a:extLst>
          </p:cNvPr>
          <p:cNvSpPr txBox="1"/>
          <p:nvPr/>
        </p:nvSpPr>
        <p:spPr>
          <a:xfrm>
            <a:off x="3985793" y="849012"/>
            <a:ext cx="209991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1</a:t>
            </a:r>
          </a:p>
        </p:txBody>
      </p:sp>
      <p:sp>
        <p:nvSpPr>
          <p:cNvPr id="247" name="Content Placeholder 3">
            <a:extLst>
              <a:ext uri="{FF2B5EF4-FFF2-40B4-BE49-F238E27FC236}">
                <a16:creationId xmlns:a16="http://schemas.microsoft.com/office/drawing/2014/main" id="{B5087B81-F439-49BF-9E87-93AEE900C1DA}"/>
              </a:ext>
            </a:extLst>
          </p:cNvPr>
          <p:cNvSpPr txBox="1"/>
          <p:nvPr/>
        </p:nvSpPr>
        <p:spPr>
          <a:xfrm>
            <a:off x="3753931" y="4685994"/>
            <a:ext cx="209991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1</a:t>
            </a:r>
          </a:p>
        </p:txBody>
      </p:sp>
      <p:sp>
        <p:nvSpPr>
          <p:cNvPr id="248" name="Content Placeholder 3">
            <a:extLst>
              <a:ext uri="{FF2B5EF4-FFF2-40B4-BE49-F238E27FC236}">
                <a16:creationId xmlns:a16="http://schemas.microsoft.com/office/drawing/2014/main" id="{EC638F80-47C8-41E6-8268-D49F8740965D}"/>
              </a:ext>
            </a:extLst>
          </p:cNvPr>
          <p:cNvSpPr txBox="1"/>
          <p:nvPr/>
        </p:nvSpPr>
        <p:spPr>
          <a:xfrm>
            <a:off x="4836900" y="4030099"/>
            <a:ext cx="209991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1</a:t>
            </a:r>
          </a:p>
        </p:txBody>
      </p:sp>
      <p:sp>
        <p:nvSpPr>
          <p:cNvPr id="249" name="Content Placeholder 3">
            <a:extLst>
              <a:ext uri="{FF2B5EF4-FFF2-40B4-BE49-F238E27FC236}">
                <a16:creationId xmlns:a16="http://schemas.microsoft.com/office/drawing/2014/main" id="{F3D547B3-3D99-4B01-81A1-2060F1DBE0AC}"/>
              </a:ext>
            </a:extLst>
          </p:cNvPr>
          <p:cNvSpPr txBox="1"/>
          <p:nvPr/>
        </p:nvSpPr>
        <p:spPr>
          <a:xfrm>
            <a:off x="3845563" y="4489226"/>
            <a:ext cx="209991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1</a:t>
            </a:r>
          </a:p>
        </p:txBody>
      </p:sp>
      <p:sp>
        <p:nvSpPr>
          <p:cNvPr id="250" name="Content Placeholder 3">
            <a:extLst>
              <a:ext uri="{FF2B5EF4-FFF2-40B4-BE49-F238E27FC236}">
                <a16:creationId xmlns:a16="http://schemas.microsoft.com/office/drawing/2014/main" id="{45F2E765-75C7-4ADE-8090-CFECD9F39491}"/>
              </a:ext>
            </a:extLst>
          </p:cNvPr>
          <p:cNvSpPr txBox="1"/>
          <p:nvPr/>
        </p:nvSpPr>
        <p:spPr>
          <a:xfrm>
            <a:off x="3530545" y="603050"/>
            <a:ext cx="209991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1</a:t>
            </a:r>
          </a:p>
        </p:txBody>
      </p:sp>
      <p:sp>
        <p:nvSpPr>
          <p:cNvPr id="251" name="Content Placeholder 3">
            <a:extLst>
              <a:ext uri="{FF2B5EF4-FFF2-40B4-BE49-F238E27FC236}">
                <a16:creationId xmlns:a16="http://schemas.microsoft.com/office/drawing/2014/main" id="{9181F827-201D-4473-92CD-77297D179D83}"/>
              </a:ext>
            </a:extLst>
          </p:cNvPr>
          <p:cNvSpPr txBox="1"/>
          <p:nvPr/>
        </p:nvSpPr>
        <p:spPr>
          <a:xfrm>
            <a:off x="4741648" y="1734470"/>
            <a:ext cx="209991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1</a:t>
            </a:r>
          </a:p>
        </p:txBody>
      </p:sp>
      <p:sp>
        <p:nvSpPr>
          <p:cNvPr id="252" name="Content Placeholder 3">
            <a:extLst>
              <a:ext uri="{FF2B5EF4-FFF2-40B4-BE49-F238E27FC236}">
                <a16:creationId xmlns:a16="http://schemas.microsoft.com/office/drawing/2014/main" id="{F44D6112-547C-48B1-8370-CB58D85FAA1A}"/>
              </a:ext>
            </a:extLst>
          </p:cNvPr>
          <p:cNvSpPr txBox="1"/>
          <p:nvPr/>
        </p:nvSpPr>
        <p:spPr>
          <a:xfrm>
            <a:off x="3373023" y="4587610"/>
            <a:ext cx="209991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1</a:t>
            </a:r>
          </a:p>
        </p:txBody>
      </p:sp>
      <p:sp>
        <p:nvSpPr>
          <p:cNvPr id="253" name="Content Placeholder 3">
            <a:extLst>
              <a:ext uri="{FF2B5EF4-FFF2-40B4-BE49-F238E27FC236}">
                <a16:creationId xmlns:a16="http://schemas.microsoft.com/office/drawing/2014/main" id="{6A676483-A680-4F01-8016-59504829C4F4}"/>
              </a:ext>
            </a:extLst>
          </p:cNvPr>
          <p:cNvSpPr txBox="1"/>
          <p:nvPr/>
        </p:nvSpPr>
        <p:spPr>
          <a:xfrm>
            <a:off x="3422958" y="5177917"/>
            <a:ext cx="209991" cy="177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485" b="1" spc="0" baseline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1</a:t>
            </a:r>
          </a:p>
        </p:txBody>
      </p:sp>
      <p:sp>
        <p:nvSpPr>
          <p:cNvPr id="254" name="Content Placeholder 3">
            <a:extLst>
              <a:ext uri="{FF2B5EF4-FFF2-40B4-BE49-F238E27FC236}">
                <a16:creationId xmlns:a16="http://schemas.microsoft.com/office/drawing/2014/main" id="{3E7C9A1D-7C0A-4261-8612-E7275E2FB3C2}"/>
              </a:ext>
            </a:extLst>
          </p:cNvPr>
          <p:cNvSpPr txBox="1"/>
          <p:nvPr/>
        </p:nvSpPr>
        <p:spPr>
          <a:xfrm>
            <a:off x="5116465" y="3447566"/>
            <a:ext cx="1558440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dirty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s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weet potato </a:t>
            </a:r>
            <a:r>
              <a:rPr lang="en-US" sz="647" spc="0" baseline="0" dirty="0" err="1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pakakuy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virus NC 015655 1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255" name="Content Placeholder 3">
            <a:extLst>
              <a:ext uri="{FF2B5EF4-FFF2-40B4-BE49-F238E27FC236}">
                <a16:creationId xmlns:a16="http://schemas.microsoft.com/office/drawing/2014/main" id="{A3DB1033-02C1-4114-B993-1D9E0363791E}"/>
              </a:ext>
            </a:extLst>
          </p:cNvPr>
          <p:cNvSpPr txBox="1"/>
          <p:nvPr/>
        </p:nvSpPr>
        <p:spPr>
          <a:xfrm>
            <a:off x="4687290" y="3545950"/>
            <a:ext cx="1561646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dirty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c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acao red vein banding virus MH029281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256" name="Content Placeholder 3">
            <a:extLst>
              <a:ext uri="{FF2B5EF4-FFF2-40B4-BE49-F238E27FC236}">
                <a16:creationId xmlns:a16="http://schemas.microsoft.com/office/drawing/2014/main" id="{28D9829B-96D2-47C3-A285-D60663089CC4}"/>
              </a:ext>
            </a:extLst>
          </p:cNvPr>
          <p:cNvSpPr txBox="1"/>
          <p:nvPr/>
        </p:nvSpPr>
        <p:spPr>
          <a:xfrm>
            <a:off x="4821582" y="4726564"/>
            <a:ext cx="1378904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647" spc="0" baseline="0" dirty="0" err="1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Rubus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yellow net virus NC 026238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257" name="Content Placeholder 3">
            <a:extLst>
              <a:ext uri="{FF2B5EF4-FFF2-40B4-BE49-F238E27FC236}">
                <a16:creationId xmlns:a16="http://schemas.microsoft.com/office/drawing/2014/main" id="{62842767-930D-4666-B457-711FF0152CAF}"/>
              </a:ext>
            </a:extLst>
          </p:cNvPr>
          <p:cNvSpPr txBox="1"/>
          <p:nvPr/>
        </p:nvSpPr>
        <p:spPr>
          <a:xfrm>
            <a:off x="4945301" y="6005579"/>
            <a:ext cx="1596912" cy="1919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sz="647" dirty="0" err="1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b</a:t>
            </a:r>
            <a:r>
              <a:rPr lang="en-US" sz="647" spc="0" baseline="0" dirty="0" err="1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rinjal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err="1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badnavirus</a:t>
            </a:r>
            <a:r>
              <a:rPr lang="en-US" sz="647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A 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</a:t>
            </a:r>
            <a:r>
              <a:rPr lang="en-US" sz="647" spc="0" baseline="0" dirty="0" err="1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Melongena</a:t>
            </a:r>
            <a:r>
              <a:rPr lang="en-US" sz="647" spc="0" baseline="0" dirty="0" smtClean="0">
                <a:solidFill>
                  <a:srgbClr val="000000"/>
                </a:solidFill>
                <a:latin typeface="Times New Roman"/>
                <a:cs typeface="Times New Roman"/>
                <a:sym typeface="Times New Roman"/>
                <a:rtl val="0"/>
              </a:rPr>
              <a:t> VR 1</a:t>
            </a:r>
            <a:endParaRPr lang="en-US" sz="647" spc="0" baseline="0" dirty="0">
              <a:solidFill>
                <a:srgbClr val="000000"/>
              </a:solidFill>
              <a:latin typeface="Times New Roman"/>
              <a:cs typeface="Times New Roman"/>
              <a:sym typeface="Times New Roman"/>
              <a:rtl val="0"/>
            </a:endParaRPr>
          </a:p>
        </p:txBody>
      </p:sp>
      <p:sp>
        <p:nvSpPr>
          <p:cNvPr id="258" name="ZoneTexte 257"/>
          <p:cNvSpPr txBox="1"/>
          <p:nvPr/>
        </p:nvSpPr>
        <p:spPr>
          <a:xfrm>
            <a:off x="0" y="6534010"/>
            <a:ext cx="233429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 err="1" smtClean="0">
                <a:cs typeface="Times New Roman" panose="02020603050405020304" pitchFamily="18" charset="0"/>
              </a:rPr>
              <a:t>Serfraz</a:t>
            </a:r>
            <a:r>
              <a:rPr lang="fr-FR" sz="1100" dirty="0" smtClean="0">
                <a:cs typeface="Times New Roman" panose="02020603050405020304" pitchFamily="18" charset="0"/>
              </a:rPr>
              <a:t> </a:t>
            </a:r>
            <a:r>
              <a:rPr lang="fr-FR" sz="1100" i="1" dirty="0" smtClean="0">
                <a:cs typeface="Times New Roman" panose="02020603050405020304" pitchFamily="18" charset="0"/>
              </a:rPr>
              <a:t>et al</a:t>
            </a:r>
            <a:r>
              <a:rPr lang="fr-FR" sz="1100" dirty="0" smtClean="0">
                <a:cs typeface="Times New Roman" panose="02020603050405020304" pitchFamily="18" charset="0"/>
              </a:rPr>
              <a:t>., </a:t>
            </a:r>
            <a:r>
              <a:rPr lang="fr-FR" sz="1100" dirty="0" err="1" smtClean="0">
                <a:cs typeface="Times New Roman" panose="02020603050405020304" pitchFamily="18" charset="0"/>
              </a:rPr>
              <a:t>Supplementary</a:t>
            </a:r>
            <a:r>
              <a:rPr lang="fr-FR" sz="1100" dirty="0" smtClean="0">
                <a:cs typeface="Times New Roman" panose="02020603050405020304" pitchFamily="18" charset="0"/>
              </a:rPr>
              <a:t> </a:t>
            </a:r>
            <a:r>
              <a:rPr lang="fr-FR" sz="1100" smtClean="0">
                <a:cs typeface="Times New Roman" panose="02020603050405020304" pitchFamily="18" charset="0"/>
              </a:rPr>
              <a:t>Figure </a:t>
            </a:r>
            <a:r>
              <a:rPr lang="fr-FR" sz="1100" smtClean="0">
                <a:cs typeface="Times New Roman" panose="02020603050405020304" pitchFamily="18" charset="0"/>
              </a:rPr>
              <a:t>2</a:t>
            </a:r>
            <a:endParaRPr lang="fr-FR" sz="1100" dirty="0"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200287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32</TotalTime>
  <Words>454</Words>
  <Application>Microsoft Office PowerPoint</Application>
  <PresentationFormat>Grand écran</PresentationFormat>
  <Paragraphs>12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Agency FB</vt:lpstr>
      <vt:lpstr>Arial</vt:lpstr>
      <vt:lpstr>Calibri</vt:lpstr>
      <vt:lpstr>Calibri Light</vt:lpstr>
      <vt:lpstr>Times New Roman</vt:lpstr>
      <vt:lpstr>Office Them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ad Serfraz</dc:creator>
  <cp:lastModifiedBy> Pierre-Yves Teycheney</cp:lastModifiedBy>
  <cp:revision>7</cp:revision>
  <dcterms:created xsi:type="dcterms:W3CDTF">2021-03-20T02:19:02Z</dcterms:created>
  <dcterms:modified xsi:type="dcterms:W3CDTF">2021-06-11T22:38:49Z</dcterms:modified>
</cp:coreProperties>
</file>